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2"/>
  </p:notesMasterIdLst>
  <p:sldIdLst>
    <p:sldId id="256" r:id="rId2"/>
    <p:sldId id="257" r:id="rId3"/>
    <p:sldId id="277" r:id="rId4"/>
    <p:sldId id="278" r:id="rId5"/>
    <p:sldId id="279" r:id="rId6"/>
    <p:sldId id="280" r:id="rId7"/>
    <p:sldId id="281" r:id="rId8"/>
    <p:sldId id="282" r:id="rId9"/>
    <p:sldId id="283" r:id="rId10"/>
    <p:sldId id="284" r:id="rId11"/>
    <p:sldId id="285" r:id="rId12"/>
    <p:sldId id="286" r:id="rId13"/>
    <p:sldId id="259" r:id="rId14"/>
    <p:sldId id="260" r:id="rId15"/>
    <p:sldId id="261" r:id="rId16"/>
    <p:sldId id="262" r:id="rId17"/>
    <p:sldId id="263" r:id="rId18"/>
    <p:sldId id="264" r:id="rId19"/>
    <p:sldId id="265" r:id="rId20"/>
    <p:sldId id="266" r:id="rId21"/>
    <p:sldId id="267" r:id="rId22"/>
    <p:sldId id="268" r:id="rId23"/>
    <p:sldId id="269" r:id="rId24"/>
    <p:sldId id="270" r:id="rId25"/>
    <p:sldId id="271" r:id="rId26"/>
    <p:sldId id="272" r:id="rId27"/>
    <p:sldId id="273" r:id="rId28"/>
    <p:sldId id="274" r:id="rId29"/>
    <p:sldId id="275" r:id="rId30"/>
    <p:sldId id="276" r:id="rId31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1254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52B2C9-8185-4E40-A3E4-C03A1308E75C}" type="datetimeFigureOut">
              <a:rPr lang="en-GB" smtClean="0"/>
              <a:t>14/08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042C19-8F11-4DA7-9C44-E6058E70BA7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00816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5CD297-B2A8-418A-8C12-E20CF7932874}" type="slidenum">
              <a:rPr lang="en-GB" smtClean="0">
                <a:solidFill>
                  <a:prstClr val="black"/>
                </a:solidFill>
              </a:rPr>
              <a:pPr/>
              <a:t>3</a:t>
            </a:fld>
            <a:endParaRPr lang="en-GB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035928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5CD297-B2A8-418A-8C12-E20CF7932874}" type="slidenum">
              <a:rPr lang="en-GB" smtClean="0">
                <a:solidFill>
                  <a:prstClr val="black"/>
                </a:solidFill>
              </a:rPr>
              <a:pPr/>
              <a:t>12</a:t>
            </a:fld>
            <a:endParaRPr lang="en-GB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84997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7F09341-2CFE-4CBA-B1EE-FE4D547F4373}" type="slidenum">
              <a:rPr lang="en-GB" smtClean="0">
                <a:solidFill>
                  <a:prstClr val="black"/>
                </a:solidFill>
              </a:rPr>
              <a:pPr/>
              <a:t>21</a:t>
            </a:fld>
            <a:endParaRPr lang="en-GB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8188590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6BF8660-EF26-4FD7-87B8-A98D3BEF2F02}" type="slidenum">
              <a:rPr lang="en-GB" smtClean="0">
                <a:solidFill>
                  <a:prstClr val="black"/>
                </a:solidFill>
              </a:rPr>
              <a:pPr/>
              <a:t>23</a:t>
            </a:fld>
            <a:endParaRPr lang="en-GB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9122894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4B9F3B7-7121-4669-A1F9-35DE2367C855}" type="slidenum">
              <a:rPr lang="en-GB" smtClean="0">
                <a:solidFill>
                  <a:prstClr val="black"/>
                </a:solidFill>
              </a:rPr>
              <a:pPr/>
              <a:t>27</a:t>
            </a:fld>
            <a:endParaRPr lang="en-GB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384655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4-8-201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4-8-201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4-8-201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4-8-201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4-8-201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4-8-2013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4-8-2013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4-8-2013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4-8-2013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4-8-2013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636C07-7E76-46D3-B86B-6AF7C60E533E}" type="datetimeFigureOut">
              <a:rPr lang="nl-NL" smtClean="0"/>
              <a:t>14-8-2013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636C07-7E76-46D3-B86B-6AF7C60E533E}" type="datetimeFigureOut">
              <a:rPr lang="nl-NL" smtClean="0"/>
              <a:t>14-8-201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096D49-DAE3-40DE-93E0-41688E0A5016}" type="slidenum">
              <a:rPr lang="nl-NL" smtClean="0"/>
              <a:t>‹#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1.png"/><Relationship Id="rId4" Type="http://schemas.openxmlformats.org/officeDocument/2006/relationships/image" Target="../media/image22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emf"/><Relationship Id="rId5" Type="http://schemas.openxmlformats.org/officeDocument/2006/relationships/image" Target="../media/image22.emf"/><Relationship Id="rId4" Type="http://schemas.openxmlformats.org/officeDocument/2006/relationships/image" Target="../media/image34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emf"/><Relationship Id="rId7" Type="http://schemas.openxmlformats.org/officeDocument/2006/relationships/image" Target="../media/image3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emf"/><Relationship Id="rId5" Type="http://schemas.openxmlformats.org/officeDocument/2006/relationships/image" Target="../media/image37.emf"/><Relationship Id="rId4" Type="http://schemas.openxmlformats.org/officeDocument/2006/relationships/image" Target="../media/image34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3.png"/><Relationship Id="rId4" Type="http://schemas.openxmlformats.org/officeDocument/2006/relationships/image" Target="../media/image42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7.png"/><Relationship Id="rId4" Type="http://schemas.openxmlformats.org/officeDocument/2006/relationships/image" Target="../media/image46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1.png"/><Relationship Id="rId4" Type="http://schemas.openxmlformats.org/officeDocument/2006/relationships/image" Target="../media/image50.png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emf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4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emf"/><Relationship Id="rId5" Type="http://schemas.openxmlformats.org/officeDocument/2006/relationships/image" Target="../media/image14.emf"/><Relationship Id="rId4" Type="http://schemas.openxmlformats.org/officeDocument/2006/relationships/image" Target="../media/image8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png"/><Relationship Id="rId4" Type="http://schemas.openxmlformats.org/officeDocument/2006/relationships/image" Target="../media/image14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emf"/><Relationship Id="rId4" Type="http://schemas.openxmlformats.org/officeDocument/2006/relationships/image" Target="../media/image14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5" Type="http://schemas.openxmlformats.org/officeDocument/2006/relationships/image" Target="../media/image24.emf"/><Relationship Id="rId4" Type="http://schemas.openxmlformats.org/officeDocument/2006/relationships/image" Target="../media/image23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emf"/><Relationship Id="rId4" Type="http://schemas.openxmlformats.org/officeDocument/2006/relationships/image" Target="../media/image2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/>
          <a:stretch/>
        </p:blipFill>
        <p:spPr bwMode="auto">
          <a:xfrm>
            <a:off x="5654991" y="365795"/>
            <a:ext cx="3237489" cy="69108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392"/>
          <a:stretch/>
        </p:blipFill>
        <p:spPr bwMode="auto">
          <a:xfrm>
            <a:off x="323528" y="365795"/>
            <a:ext cx="5206497" cy="66708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0" y="13990"/>
            <a:ext cx="8997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itle: The </a:t>
            </a:r>
            <a:r>
              <a:rPr lang="en-GB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rassica rapa FLC</a:t>
            </a:r>
            <a:r>
              <a:rPr lang="en-GB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homolog </a:t>
            </a:r>
            <a:r>
              <a:rPr lang="en-GB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rFLC2</a:t>
            </a:r>
            <a:r>
              <a:rPr lang="en-GB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is a key regulator of flowering time, identified through transcriptional co-expression </a:t>
            </a:r>
            <a:r>
              <a:rPr lang="en-GB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networks</a:t>
            </a:r>
            <a:endParaRPr lang="en-GB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344991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oup 35"/>
          <p:cNvGrpSpPr/>
          <p:nvPr/>
        </p:nvGrpSpPr>
        <p:grpSpPr>
          <a:xfrm>
            <a:off x="899592" y="256508"/>
            <a:ext cx="7856015" cy="6338383"/>
            <a:chOff x="899592" y="256508"/>
            <a:chExt cx="7856015" cy="6338383"/>
          </a:xfrm>
        </p:grpSpPr>
        <p:grpSp>
          <p:nvGrpSpPr>
            <p:cNvPr id="13" name="Group 12"/>
            <p:cNvGrpSpPr/>
            <p:nvPr/>
          </p:nvGrpSpPr>
          <p:grpSpPr>
            <a:xfrm>
              <a:off x="899592" y="256508"/>
              <a:ext cx="6934352" cy="5764780"/>
              <a:chOff x="899592" y="256508"/>
              <a:chExt cx="6934352" cy="5764780"/>
            </a:xfrm>
          </p:grpSpPr>
          <p:grpSp>
            <p:nvGrpSpPr>
              <p:cNvPr id="11" name="Group 10"/>
              <p:cNvGrpSpPr/>
              <p:nvPr/>
            </p:nvGrpSpPr>
            <p:grpSpPr>
              <a:xfrm>
                <a:off x="899592" y="256508"/>
                <a:ext cx="6934352" cy="5764780"/>
                <a:chOff x="1303686" y="256508"/>
                <a:chExt cx="6934352" cy="5764780"/>
              </a:xfrm>
            </p:grpSpPr>
            <p:sp>
              <p:nvSpPr>
                <p:cNvPr id="28" name="Rectangle 27"/>
                <p:cNvSpPr/>
                <p:nvPr/>
              </p:nvSpPr>
              <p:spPr>
                <a:xfrm>
                  <a:off x="4794345" y="847353"/>
                  <a:ext cx="44307" cy="406054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solidFill>
                      <a:prstClr val="white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42" name="Group 41"/>
                <p:cNvGrpSpPr/>
                <p:nvPr/>
              </p:nvGrpSpPr>
              <p:grpSpPr>
                <a:xfrm>
                  <a:off x="4915162" y="256508"/>
                  <a:ext cx="3322876" cy="5764780"/>
                  <a:chOff x="1764641" y="286517"/>
                  <a:chExt cx="3596559" cy="5764780"/>
                </a:xfrm>
              </p:grpSpPr>
              <p:sp>
                <p:nvSpPr>
                  <p:cNvPr id="7" name="TextBox 6"/>
                  <p:cNvSpPr txBox="1"/>
                  <p:nvPr/>
                </p:nvSpPr>
                <p:spPr>
                  <a:xfrm>
                    <a:off x="4777882" y="286517"/>
                    <a:ext cx="58331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A08-P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10" name="Group 9"/>
                  <p:cNvGrpSpPr/>
                  <p:nvPr/>
                </p:nvGrpSpPr>
                <p:grpSpPr>
                  <a:xfrm>
                    <a:off x="1764641" y="520214"/>
                    <a:ext cx="1458658" cy="4245580"/>
                    <a:chOff x="3276809" y="335548"/>
                    <a:chExt cx="1458658" cy="4245580"/>
                  </a:xfrm>
                </p:grpSpPr>
                <p:pic>
                  <p:nvPicPr>
                    <p:cNvPr id="8" name="Picture 4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23765" r="64068" b="29795"/>
                    <a:stretch/>
                  </p:blipFill>
                  <p:spPr bwMode="auto">
                    <a:xfrm>
                      <a:off x="3276809" y="692696"/>
                      <a:ext cx="1458658" cy="388843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6" name="Rectangle 5"/>
                    <p:cNvSpPr/>
                    <p:nvPr/>
                  </p:nvSpPr>
                  <p:spPr>
                    <a:xfrm>
                      <a:off x="3462062" y="335548"/>
                      <a:ext cx="444516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GB" sz="1000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A08</a:t>
                      </a:r>
                    </a:p>
                  </p:txBody>
                </p:sp>
              </p:grpSp>
              <p:cxnSp>
                <p:nvCxnSpPr>
                  <p:cNvPr id="12" name="Straight Arrow Connector 11"/>
                  <p:cNvCxnSpPr/>
                  <p:nvPr/>
                </p:nvCxnSpPr>
                <p:spPr>
                  <a:xfrm>
                    <a:off x="3223299" y="1241052"/>
                    <a:ext cx="1339464" cy="2164858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" name="Straight Arrow Connector 14"/>
                  <p:cNvCxnSpPr/>
                  <p:nvPr/>
                </p:nvCxnSpPr>
                <p:spPr>
                  <a:xfrm>
                    <a:off x="3223299" y="1628800"/>
                    <a:ext cx="1350242" cy="792088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" name="Straight Arrow Connector 18"/>
                  <p:cNvCxnSpPr/>
                  <p:nvPr/>
                </p:nvCxnSpPr>
                <p:spPr>
                  <a:xfrm>
                    <a:off x="3223299" y="2546432"/>
                    <a:ext cx="1339464" cy="121075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" name="Straight Arrow Connector 20"/>
                  <p:cNvCxnSpPr/>
                  <p:nvPr/>
                </p:nvCxnSpPr>
                <p:spPr>
                  <a:xfrm>
                    <a:off x="3223299" y="2629977"/>
                    <a:ext cx="1350240" cy="1860671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" name="Straight Arrow Connector 24"/>
                  <p:cNvCxnSpPr/>
                  <p:nvPr/>
                </p:nvCxnSpPr>
                <p:spPr>
                  <a:xfrm>
                    <a:off x="3223299" y="2830814"/>
                    <a:ext cx="1350240" cy="2071975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" name="Straight Arrow Connector 28"/>
                  <p:cNvCxnSpPr/>
                  <p:nvPr/>
                </p:nvCxnSpPr>
                <p:spPr>
                  <a:xfrm>
                    <a:off x="3223299" y="2907453"/>
                    <a:ext cx="1350240" cy="2140585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" name="Straight Arrow Connector 31"/>
                  <p:cNvCxnSpPr/>
                  <p:nvPr/>
                </p:nvCxnSpPr>
                <p:spPr>
                  <a:xfrm>
                    <a:off x="3223299" y="3023720"/>
                    <a:ext cx="1339464" cy="1879069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4" name="Straight Arrow Connector 33"/>
                  <p:cNvCxnSpPr/>
                  <p:nvPr/>
                </p:nvCxnSpPr>
                <p:spPr>
                  <a:xfrm>
                    <a:off x="3223299" y="3537952"/>
                    <a:ext cx="1350242" cy="1937281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" name="Straight Arrow Connector 37"/>
                  <p:cNvCxnSpPr/>
                  <p:nvPr/>
                </p:nvCxnSpPr>
                <p:spPr>
                  <a:xfrm>
                    <a:off x="3223299" y="4330346"/>
                    <a:ext cx="1339464" cy="1144887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Straight Arrow Connector 39"/>
                  <p:cNvCxnSpPr/>
                  <p:nvPr/>
                </p:nvCxnSpPr>
                <p:spPr>
                  <a:xfrm>
                    <a:off x="3223299" y="4708728"/>
                    <a:ext cx="1339464" cy="1342569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9" name="Group 38"/>
                <p:cNvGrpSpPr/>
                <p:nvPr/>
              </p:nvGrpSpPr>
              <p:grpSpPr>
                <a:xfrm>
                  <a:off x="2760329" y="589522"/>
                  <a:ext cx="2114880" cy="305986"/>
                  <a:chOff x="2855579" y="94222"/>
                  <a:chExt cx="2114880" cy="305986"/>
                </a:xfrm>
              </p:grpSpPr>
              <p:sp>
                <p:nvSpPr>
                  <p:cNvPr id="41" name="TextBox 40"/>
                  <p:cNvSpPr txBox="1"/>
                  <p:nvPr/>
                </p:nvSpPr>
                <p:spPr>
                  <a:xfrm>
                    <a:off x="4715261" y="103238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0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43" name="Straight Connector 42"/>
                  <p:cNvCxnSpPr/>
                  <p:nvPr/>
                </p:nvCxnSpPr>
                <p:spPr>
                  <a:xfrm>
                    <a:off x="2855579" y="323596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Straight Connector 43"/>
                  <p:cNvCxnSpPr/>
                  <p:nvPr/>
                </p:nvCxnSpPr>
                <p:spPr>
                  <a:xfrm>
                    <a:off x="3188954" y="326934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Straight Connector 44"/>
                  <p:cNvCxnSpPr/>
                  <p:nvPr/>
                </p:nvCxnSpPr>
                <p:spPr>
                  <a:xfrm>
                    <a:off x="3522329" y="319726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" name="Straight Connector 45"/>
                  <p:cNvCxnSpPr/>
                  <p:nvPr/>
                </p:nvCxnSpPr>
                <p:spPr>
                  <a:xfrm>
                    <a:off x="4198604" y="325637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7" name="Straight Connector 46"/>
                  <p:cNvCxnSpPr/>
                  <p:nvPr/>
                </p:nvCxnSpPr>
                <p:spPr>
                  <a:xfrm>
                    <a:off x="4531979" y="332246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8" name="Straight Connector 47"/>
                  <p:cNvCxnSpPr/>
                  <p:nvPr/>
                </p:nvCxnSpPr>
                <p:spPr>
                  <a:xfrm>
                    <a:off x="4852753" y="329074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9" name="TextBox 48"/>
                  <p:cNvSpPr txBox="1"/>
                  <p:nvPr/>
                </p:nvSpPr>
                <p:spPr>
                  <a:xfrm>
                    <a:off x="4387641" y="96079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1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0" name="TextBox 49"/>
                  <p:cNvSpPr txBox="1"/>
                  <p:nvPr/>
                </p:nvSpPr>
                <p:spPr>
                  <a:xfrm>
                    <a:off x="4065254" y="94222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2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1" name="TextBox 50"/>
                  <p:cNvSpPr txBox="1"/>
                  <p:nvPr/>
                </p:nvSpPr>
                <p:spPr>
                  <a:xfrm>
                    <a:off x="3720891" y="98932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3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2" name="TextBox 51"/>
                  <p:cNvSpPr txBox="1"/>
                  <p:nvPr/>
                </p:nvSpPr>
                <p:spPr>
                  <a:xfrm>
                    <a:off x="3373612" y="98527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4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3" name="TextBox 52"/>
                  <p:cNvSpPr txBox="1"/>
                  <p:nvPr/>
                </p:nvSpPr>
                <p:spPr>
                  <a:xfrm>
                    <a:off x="3054141" y="94222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pic>
              <p:nvPicPr>
                <p:cNvPr id="8195" name="Picture 3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303686" y="892336"/>
                  <a:ext cx="1304925" cy="384344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54" name="TextBox 53"/>
                <p:cNvSpPr txBox="1"/>
                <p:nvPr/>
              </p:nvSpPr>
              <p:spPr>
                <a:xfrm>
                  <a:off x="1671454" y="4759603"/>
                  <a:ext cx="5036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e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>
                  <a:off x="3394670" y="4741030"/>
                  <a:ext cx="4683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f</a:t>
                  </a:r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6" name="TextBox 55"/>
                <p:cNvSpPr txBox="1"/>
                <p:nvPr/>
              </p:nvSpPr>
              <p:spPr>
                <a:xfrm>
                  <a:off x="3374296" y="300533"/>
                  <a:ext cx="44755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LOD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57" name="TextBox 56"/>
              <p:cNvSpPr txBox="1"/>
              <p:nvPr/>
            </p:nvSpPr>
            <p:spPr>
              <a:xfrm>
                <a:off x="2223567" y="59555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6</a:t>
                </a:r>
                <a:endParaRPr lang="en-GB" sz="10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58" name="Straight Connector 57"/>
              <p:cNvCxnSpPr/>
              <p:nvPr/>
            </p:nvCxnSpPr>
            <p:spPr>
              <a:xfrm>
                <a:off x="3356360" y="820937"/>
                <a:ext cx="0" cy="6796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9" name="Group 58"/>
            <p:cNvGrpSpPr/>
            <p:nvPr/>
          </p:nvGrpSpPr>
          <p:grpSpPr>
            <a:xfrm>
              <a:off x="7060029" y="657317"/>
              <a:ext cx="1695578" cy="5937574"/>
              <a:chOff x="833793" y="188640"/>
              <a:chExt cx="1695578" cy="5937574"/>
            </a:xfrm>
          </p:grpSpPr>
          <p:cxnSp>
            <p:nvCxnSpPr>
              <p:cNvPr id="60" name="Straight Connector 59"/>
              <p:cNvCxnSpPr/>
              <p:nvPr/>
            </p:nvCxnSpPr>
            <p:spPr>
              <a:xfrm>
                <a:off x="1263817" y="4437112"/>
                <a:ext cx="0" cy="939361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61" name="Picture 12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686" t="21798" r="36673" b="18016"/>
              <a:stretch/>
            </p:blipFill>
            <p:spPr bwMode="auto">
              <a:xfrm>
                <a:off x="918343" y="188640"/>
                <a:ext cx="1390747" cy="44629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2" name="Picture 12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3535" t="21798" r="16892" b="60192"/>
              <a:stretch/>
            </p:blipFill>
            <p:spPr bwMode="auto">
              <a:xfrm>
                <a:off x="833793" y="4790798"/>
                <a:ext cx="1695578" cy="133541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63" name="Straight Connector 62"/>
              <p:cNvCxnSpPr/>
              <p:nvPr/>
            </p:nvCxnSpPr>
            <p:spPr>
              <a:xfrm>
                <a:off x="1370037" y="4330904"/>
                <a:ext cx="0" cy="939361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5" name="Picture 3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54" r="6343" b="1742"/>
          <a:stretch/>
        </p:blipFill>
        <p:spPr bwMode="auto">
          <a:xfrm>
            <a:off x="2270383" y="890196"/>
            <a:ext cx="2129104" cy="38885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3251015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/>
          <p:cNvGrpSpPr/>
          <p:nvPr/>
        </p:nvGrpSpPr>
        <p:grpSpPr>
          <a:xfrm>
            <a:off x="323528" y="-57150"/>
            <a:ext cx="8663333" cy="7005521"/>
            <a:chOff x="323528" y="-95250"/>
            <a:chExt cx="8663333" cy="7005521"/>
          </a:xfrm>
        </p:grpSpPr>
        <p:grpSp>
          <p:nvGrpSpPr>
            <p:cNvPr id="14" name="Group 13"/>
            <p:cNvGrpSpPr/>
            <p:nvPr/>
          </p:nvGrpSpPr>
          <p:grpSpPr>
            <a:xfrm>
              <a:off x="323528" y="-95250"/>
              <a:ext cx="7895998" cy="6945292"/>
              <a:chOff x="323528" y="-95250"/>
              <a:chExt cx="7895998" cy="6945292"/>
            </a:xfrm>
          </p:grpSpPr>
          <p:grpSp>
            <p:nvGrpSpPr>
              <p:cNvPr id="12" name="Group 11"/>
              <p:cNvGrpSpPr/>
              <p:nvPr/>
            </p:nvGrpSpPr>
            <p:grpSpPr>
              <a:xfrm>
                <a:off x="323528" y="-95250"/>
                <a:ext cx="7895998" cy="6945292"/>
                <a:chOff x="631801" y="-95250"/>
                <a:chExt cx="7895998" cy="6945292"/>
              </a:xfrm>
            </p:grpSpPr>
            <p:grpSp>
              <p:nvGrpSpPr>
                <p:cNvPr id="66" name="Group 65"/>
                <p:cNvGrpSpPr/>
                <p:nvPr/>
              </p:nvGrpSpPr>
              <p:grpSpPr>
                <a:xfrm>
                  <a:off x="4639836" y="-95250"/>
                  <a:ext cx="3887963" cy="6709049"/>
                  <a:chOff x="1409750" y="-137252"/>
                  <a:chExt cx="3887963" cy="6709049"/>
                </a:xfrm>
              </p:grpSpPr>
              <p:sp>
                <p:nvSpPr>
                  <p:cNvPr id="8" name="TextBox 7"/>
                  <p:cNvSpPr txBox="1"/>
                  <p:nvPr/>
                </p:nvSpPr>
                <p:spPr>
                  <a:xfrm>
                    <a:off x="4758783" y="-137252"/>
                    <a:ext cx="5389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A09-P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11" name="Group 10"/>
                  <p:cNvGrpSpPr/>
                  <p:nvPr/>
                </p:nvGrpSpPr>
                <p:grpSpPr>
                  <a:xfrm>
                    <a:off x="1409750" y="23063"/>
                    <a:ext cx="2138999" cy="6548734"/>
                    <a:chOff x="4293194" y="91"/>
                    <a:chExt cx="2138999" cy="6548734"/>
                  </a:xfrm>
                </p:grpSpPr>
                <p:pic>
                  <p:nvPicPr>
                    <p:cNvPr id="9" name="Picture 3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4997" r="47299" b="8509"/>
                    <a:stretch/>
                  </p:blipFill>
                  <p:spPr bwMode="auto">
                    <a:xfrm>
                      <a:off x="4293194" y="332656"/>
                      <a:ext cx="2138999" cy="621616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10" name="TextBox 9"/>
                    <p:cNvSpPr txBox="1"/>
                    <p:nvPr/>
                  </p:nvSpPr>
                  <p:spPr>
                    <a:xfrm>
                      <a:off x="4488262" y="91"/>
                      <a:ext cx="4106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A09</a:t>
                      </a:r>
                      <a:endParaRPr lang="en-GB" sz="10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cxnSp>
                <p:nvCxnSpPr>
                  <p:cNvPr id="13" name="Straight Arrow Connector 12"/>
                  <p:cNvCxnSpPr/>
                  <p:nvPr/>
                </p:nvCxnSpPr>
                <p:spPr>
                  <a:xfrm>
                    <a:off x="2782074" y="411122"/>
                    <a:ext cx="1882562" cy="71362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" name="Straight Arrow Connector 15"/>
                  <p:cNvCxnSpPr/>
                  <p:nvPr/>
                </p:nvCxnSpPr>
                <p:spPr>
                  <a:xfrm flipV="1">
                    <a:off x="2854082" y="411122"/>
                    <a:ext cx="1810554" cy="929646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" name="Straight Arrow Connector 18"/>
                  <p:cNvCxnSpPr/>
                  <p:nvPr/>
                </p:nvCxnSpPr>
                <p:spPr>
                  <a:xfrm flipV="1">
                    <a:off x="2854082" y="1196752"/>
                    <a:ext cx="1802929" cy="24185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" name="Straight Arrow Connector 21"/>
                  <p:cNvCxnSpPr/>
                  <p:nvPr/>
                </p:nvCxnSpPr>
                <p:spPr>
                  <a:xfrm flipV="1">
                    <a:off x="2854082" y="1124744"/>
                    <a:ext cx="1802929" cy="384488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" name="Straight Arrow Connector 23"/>
                  <p:cNvCxnSpPr/>
                  <p:nvPr/>
                </p:nvCxnSpPr>
                <p:spPr>
                  <a:xfrm flipV="1">
                    <a:off x="2854082" y="1340768"/>
                    <a:ext cx="1810554" cy="44864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" name="Straight Arrow Connector 29"/>
                  <p:cNvCxnSpPr/>
                  <p:nvPr/>
                </p:nvCxnSpPr>
                <p:spPr>
                  <a:xfrm flipV="1">
                    <a:off x="2854082" y="1063692"/>
                    <a:ext cx="1801318" cy="112212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" name="Straight Arrow Connector 32"/>
                  <p:cNvCxnSpPr/>
                  <p:nvPr/>
                </p:nvCxnSpPr>
                <p:spPr>
                  <a:xfrm>
                    <a:off x="2835032" y="2808426"/>
                    <a:ext cx="1789926" cy="6775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" name="Straight Arrow Connector 35"/>
                  <p:cNvCxnSpPr/>
                  <p:nvPr/>
                </p:nvCxnSpPr>
                <p:spPr>
                  <a:xfrm flipV="1">
                    <a:off x="2854082" y="2378886"/>
                    <a:ext cx="1789926" cy="842474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" name="Straight Arrow Connector 37"/>
                  <p:cNvCxnSpPr/>
                  <p:nvPr/>
                </p:nvCxnSpPr>
                <p:spPr>
                  <a:xfrm>
                    <a:off x="3667512" y="3721020"/>
                    <a:ext cx="957446" cy="67409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Straight Arrow Connector 39"/>
                  <p:cNvCxnSpPr/>
                  <p:nvPr/>
                </p:nvCxnSpPr>
                <p:spPr>
                  <a:xfrm>
                    <a:off x="2710066" y="4105084"/>
                    <a:ext cx="1914892" cy="58288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" name="Straight Arrow Connector 42"/>
                  <p:cNvCxnSpPr/>
                  <p:nvPr/>
                </p:nvCxnSpPr>
                <p:spPr>
                  <a:xfrm flipV="1">
                    <a:off x="2782074" y="2378886"/>
                    <a:ext cx="1861934" cy="194325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Straight Arrow Connector 44"/>
                  <p:cNvCxnSpPr/>
                  <p:nvPr/>
                </p:nvCxnSpPr>
                <p:spPr>
                  <a:xfrm>
                    <a:off x="2782074" y="4748692"/>
                    <a:ext cx="1861934" cy="11743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7" name="Straight Arrow Connector 46"/>
                  <p:cNvCxnSpPr/>
                  <p:nvPr/>
                </p:nvCxnSpPr>
                <p:spPr>
                  <a:xfrm>
                    <a:off x="2782074" y="5100332"/>
                    <a:ext cx="1842884" cy="17181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8" name="Straight Arrow Connector 47"/>
                  <p:cNvCxnSpPr/>
                  <p:nvPr/>
                </p:nvCxnSpPr>
                <p:spPr>
                  <a:xfrm>
                    <a:off x="2782074" y="5341661"/>
                    <a:ext cx="1842884" cy="11743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0" name="Straight Arrow Connector 49"/>
                  <p:cNvCxnSpPr/>
                  <p:nvPr/>
                </p:nvCxnSpPr>
                <p:spPr>
                  <a:xfrm>
                    <a:off x="2782074" y="5411466"/>
                    <a:ext cx="1842884" cy="170853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4" name="Straight Arrow Connector 53"/>
                  <p:cNvCxnSpPr/>
                  <p:nvPr/>
                </p:nvCxnSpPr>
                <p:spPr>
                  <a:xfrm flipV="1">
                    <a:off x="2782074" y="1531863"/>
                    <a:ext cx="1882562" cy="399082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6" name="Straight Arrow Connector 55"/>
                  <p:cNvCxnSpPr/>
                  <p:nvPr/>
                </p:nvCxnSpPr>
                <p:spPr>
                  <a:xfrm>
                    <a:off x="2782074" y="5770200"/>
                    <a:ext cx="1873326" cy="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" name="Straight Arrow Connector 60"/>
                  <p:cNvCxnSpPr/>
                  <p:nvPr/>
                </p:nvCxnSpPr>
                <p:spPr>
                  <a:xfrm>
                    <a:off x="2854082" y="6093296"/>
                    <a:ext cx="1770876" cy="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" name="Straight Arrow Connector 62"/>
                  <p:cNvCxnSpPr/>
                  <p:nvPr/>
                </p:nvCxnSpPr>
                <p:spPr>
                  <a:xfrm>
                    <a:off x="2854082" y="6174958"/>
                    <a:ext cx="1801318" cy="133541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5" name="Straight Arrow Connector 64"/>
                  <p:cNvCxnSpPr/>
                  <p:nvPr/>
                </p:nvCxnSpPr>
                <p:spPr>
                  <a:xfrm flipV="1">
                    <a:off x="2854082" y="5459091"/>
                    <a:ext cx="1789926" cy="81905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4" name="Group 63"/>
                <p:cNvGrpSpPr/>
                <p:nvPr/>
              </p:nvGrpSpPr>
              <p:grpSpPr>
                <a:xfrm>
                  <a:off x="2588879" y="148024"/>
                  <a:ext cx="2114880" cy="306162"/>
                  <a:chOff x="2855579" y="90874"/>
                  <a:chExt cx="2114880" cy="306162"/>
                </a:xfrm>
              </p:grpSpPr>
              <p:sp>
                <p:nvSpPr>
                  <p:cNvPr id="67" name="TextBox 66"/>
                  <p:cNvSpPr txBox="1"/>
                  <p:nvPr/>
                </p:nvSpPr>
                <p:spPr>
                  <a:xfrm>
                    <a:off x="4715261" y="103238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0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68" name="Straight Connector 67"/>
                  <p:cNvCxnSpPr/>
                  <p:nvPr/>
                </p:nvCxnSpPr>
                <p:spPr>
                  <a:xfrm>
                    <a:off x="2855579" y="323596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" name="Straight Connector 68"/>
                  <p:cNvCxnSpPr/>
                  <p:nvPr/>
                </p:nvCxnSpPr>
                <p:spPr>
                  <a:xfrm>
                    <a:off x="3188954" y="326934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" name="Straight Connector 69"/>
                  <p:cNvCxnSpPr/>
                  <p:nvPr/>
                </p:nvCxnSpPr>
                <p:spPr>
                  <a:xfrm>
                    <a:off x="3522329" y="319726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" name="Straight Connector 70"/>
                  <p:cNvCxnSpPr/>
                  <p:nvPr/>
                </p:nvCxnSpPr>
                <p:spPr>
                  <a:xfrm>
                    <a:off x="4150979" y="325637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2" name="Straight Connector 71"/>
                  <p:cNvCxnSpPr/>
                  <p:nvPr/>
                </p:nvCxnSpPr>
                <p:spPr>
                  <a:xfrm>
                    <a:off x="4503404" y="322721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" name="Straight Connector 72"/>
                  <p:cNvCxnSpPr/>
                  <p:nvPr/>
                </p:nvCxnSpPr>
                <p:spPr>
                  <a:xfrm>
                    <a:off x="4852753" y="329074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4" name="TextBox 73"/>
                  <p:cNvSpPr txBox="1"/>
                  <p:nvPr/>
                </p:nvSpPr>
                <p:spPr>
                  <a:xfrm>
                    <a:off x="4359066" y="90874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1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5" name="TextBox 74"/>
                  <p:cNvSpPr txBox="1"/>
                  <p:nvPr/>
                </p:nvSpPr>
                <p:spPr>
                  <a:xfrm>
                    <a:off x="4016166" y="100212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2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6" name="TextBox 75"/>
                  <p:cNvSpPr txBox="1"/>
                  <p:nvPr/>
                </p:nvSpPr>
                <p:spPr>
                  <a:xfrm>
                    <a:off x="3701841" y="94672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3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7" name="TextBox 76"/>
                  <p:cNvSpPr txBox="1"/>
                  <p:nvPr/>
                </p:nvSpPr>
                <p:spPr>
                  <a:xfrm>
                    <a:off x="3373612" y="94267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4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8" name="TextBox 77"/>
                  <p:cNvSpPr txBox="1"/>
                  <p:nvPr/>
                </p:nvSpPr>
                <p:spPr>
                  <a:xfrm>
                    <a:off x="3055292" y="99608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cxnSp>
              <p:nvCxnSpPr>
                <p:cNvPr id="55" name="Straight Connector 54"/>
                <p:cNvCxnSpPr/>
                <p:nvPr/>
              </p:nvCxnSpPr>
              <p:spPr>
                <a:xfrm>
                  <a:off x="631801" y="6604273"/>
                  <a:ext cx="176212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59" name="Group 58"/>
                <p:cNvGrpSpPr/>
                <p:nvPr/>
              </p:nvGrpSpPr>
              <p:grpSpPr>
                <a:xfrm>
                  <a:off x="650851" y="450099"/>
                  <a:ext cx="1827411" cy="6229141"/>
                  <a:chOff x="631801" y="450099"/>
                  <a:chExt cx="1827411" cy="6229141"/>
                </a:xfrm>
              </p:grpSpPr>
              <p:pic>
                <p:nvPicPr>
                  <p:cNvPr id="9219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631801" y="450099"/>
                    <a:ext cx="1762125" cy="6163699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58" name="Rectangle 57"/>
                  <p:cNvSpPr/>
                  <p:nvPr/>
                </p:nvSpPr>
                <p:spPr>
                  <a:xfrm>
                    <a:off x="2393926" y="6547123"/>
                    <a:ext cx="65286" cy="132117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sz="1000">
                      <a:solidFill>
                        <a:prstClr val="white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82" name="TextBox 81"/>
                <p:cNvSpPr txBox="1"/>
                <p:nvPr/>
              </p:nvSpPr>
              <p:spPr>
                <a:xfrm>
                  <a:off x="1102067" y="6578840"/>
                  <a:ext cx="5036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e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3300239" y="6603821"/>
                  <a:ext cx="4683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f</a:t>
                  </a:r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3266270" y="-88359"/>
                  <a:ext cx="44755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LOD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57" name="Straight Connector 56"/>
              <p:cNvCxnSpPr/>
              <p:nvPr/>
            </p:nvCxnSpPr>
            <p:spPr>
              <a:xfrm>
                <a:off x="3261681" y="376876"/>
                <a:ext cx="0" cy="6796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TextBox 59"/>
              <p:cNvSpPr txBox="1"/>
              <p:nvPr/>
            </p:nvSpPr>
            <p:spPr>
              <a:xfrm>
                <a:off x="2137346" y="150789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6</a:t>
                </a:r>
                <a:endParaRPr lang="en-GB" sz="10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62" name="Group 61"/>
            <p:cNvGrpSpPr/>
            <p:nvPr/>
          </p:nvGrpSpPr>
          <p:grpSpPr>
            <a:xfrm>
              <a:off x="7598134" y="136806"/>
              <a:ext cx="1388727" cy="6773465"/>
              <a:chOff x="735227" y="1196752"/>
              <a:chExt cx="1695392" cy="8385478"/>
            </a:xfrm>
          </p:grpSpPr>
          <p:pic>
            <p:nvPicPr>
              <p:cNvPr id="79" name="Picture 14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57" t="23051" r="68471" b="71324"/>
              <a:stretch/>
            </p:blipFill>
            <p:spPr bwMode="auto">
              <a:xfrm>
                <a:off x="735227" y="9165086"/>
                <a:ext cx="1173303" cy="41714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80" name="Group 79"/>
              <p:cNvGrpSpPr/>
              <p:nvPr/>
            </p:nvGrpSpPr>
            <p:grpSpPr>
              <a:xfrm>
                <a:off x="755576" y="1196752"/>
                <a:ext cx="1675043" cy="8098166"/>
                <a:chOff x="755576" y="259876"/>
                <a:chExt cx="1675043" cy="9035042"/>
              </a:xfrm>
            </p:grpSpPr>
            <p:pic>
              <p:nvPicPr>
                <p:cNvPr id="81" name="Picture 13"/>
                <p:cNvPicPr>
                  <a:picLocks noChangeAspect="1" noChangeArrowheads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4068" t="19651" b="16104"/>
                <a:stretch/>
              </p:blipFill>
              <p:spPr bwMode="auto">
                <a:xfrm>
                  <a:off x="755576" y="259876"/>
                  <a:ext cx="1512168" cy="476393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85" name="Picture 14"/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3051" r="81908" b="16709"/>
                <a:stretch/>
              </p:blipFill>
              <p:spPr bwMode="auto">
                <a:xfrm>
                  <a:off x="821981" y="4720952"/>
                  <a:ext cx="1608638" cy="4466973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cxnSp>
              <p:nvCxnSpPr>
                <p:cNvPr id="86" name="Straight Connector 85"/>
                <p:cNvCxnSpPr/>
                <p:nvPr/>
              </p:nvCxnSpPr>
              <p:spPr>
                <a:xfrm>
                  <a:off x="1142498" y="8498647"/>
                  <a:ext cx="0" cy="796271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7" name="Straight Connector 86"/>
                <p:cNvCxnSpPr/>
                <p:nvPr/>
              </p:nvCxnSpPr>
              <p:spPr>
                <a:xfrm>
                  <a:off x="1252958" y="8444169"/>
                  <a:ext cx="0" cy="796271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pic>
        <p:nvPicPr>
          <p:cNvPr id="9218" name="Picture 2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09" t="30762" r="81608" b="34241"/>
          <a:stretch/>
        </p:blipFill>
        <p:spPr bwMode="auto">
          <a:xfrm flipH="1">
            <a:off x="2234581" y="458714"/>
            <a:ext cx="2087743" cy="61836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3307683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08304" y="5517232"/>
            <a:ext cx="1467043" cy="10081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37" name="Group 36"/>
          <p:cNvGrpSpPr/>
          <p:nvPr/>
        </p:nvGrpSpPr>
        <p:grpSpPr>
          <a:xfrm>
            <a:off x="1115616" y="401430"/>
            <a:ext cx="7578740" cy="4960456"/>
            <a:chOff x="1115616" y="401430"/>
            <a:chExt cx="7578740" cy="4960456"/>
          </a:xfrm>
        </p:grpSpPr>
        <p:pic>
          <p:nvPicPr>
            <p:cNvPr id="43" name="Picture 15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88" t="22479" r="51229" b="14287"/>
            <a:stretch/>
          </p:blipFill>
          <p:spPr bwMode="auto">
            <a:xfrm>
              <a:off x="7246581" y="672957"/>
              <a:ext cx="1447775" cy="46889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1" name="Group 10"/>
            <p:cNvGrpSpPr/>
            <p:nvPr/>
          </p:nvGrpSpPr>
          <p:grpSpPr>
            <a:xfrm>
              <a:off x="1115616" y="401430"/>
              <a:ext cx="6849393" cy="4323714"/>
              <a:chOff x="1115616" y="401430"/>
              <a:chExt cx="6849393" cy="4323714"/>
            </a:xfrm>
          </p:grpSpPr>
          <p:grpSp>
            <p:nvGrpSpPr>
              <p:cNvPr id="10" name="Group 9"/>
              <p:cNvGrpSpPr/>
              <p:nvPr/>
            </p:nvGrpSpPr>
            <p:grpSpPr>
              <a:xfrm>
                <a:off x="1115616" y="401430"/>
                <a:ext cx="6849393" cy="4323714"/>
                <a:chOff x="1303797" y="900393"/>
                <a:chExt cx="6849393" cy="4323714"/>
              </a:xfrm>
            </p:grpSpPr>
            <p:grpSp>
              <p:nvGrpSpPr>
                <p:cNvPr id="19" name="Group 18"/>
                <p:cNvGrpSpPr/>
                <p:nvPr/>
              </p:nvGrpSpPr>
              <p:grpSpPr>
                <a:xfrm>
                  <a:off x="4731316" y="900393"/>
                  <a:ext cx="3421874" cy="4323714"/>
                  <a:chOff x="1356792" y="785032"/>
                  <a:chExt cx="3421874" cy="4323714"/>
                </a:xfrm>
              </p:grpSpPr>
              <p:sp>
                <p:nvSpPr>
                  <p:cNvPr id="4" name="TextBox 3"/>
                  <p:cNvSpPr txBox="1"/>
                  <p:nvPr/>
                </p:nvSpPr>
                <p:spPr>
                  <a:xfrm>
                    <a:off x="4239736" y="785032"/>
                    <a:ext cx="5389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A10-P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2" name="Group 1"/>
                  <p:cNvGrpSpPr/>
                  <p:nvPr/>
                </p:nvGrpSpPr>
                <p:grpSpPr>
                  <a:xfrm>
                    <a:off x="1356792" y="1187729"/>
                    <a:ext cx="1965065" cy="3318360"/>
                    <a:chOff x="4021088" y="1230964"/>
                    <a:chExt cx="1965065" cy="3318360"/>
                  </a:xfrm>
                </p:grpSpPr>
                <p:pic>
                  <p:nvPicPr>
                    <p:cNvPr id="5" name="Picture 6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26218" r="51512" b="36891"/>
                    <a:stretch/>
                  </p:blipFill>
                  <p:spPr bwMode="auto">
                    <a:xfrm>
                      <a:off x="4021088" y="1556792"/>
                      <a:ext cx="1965065" cy="299253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6" name="TextBox 5"/>
                    <p:cNvSpPr txBox="1"/>
                    <p:nvPr/>
                  </p:nvSpPr>
                  <p:spPr>
                    <a:xfrm>
                      <a:off x="4196684" y="1230964"/>
                      <a:ext cx="4106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A10</a:t>
                      </a:r>
                      <a:endParaRPr lang="en-GB" sz="10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cxnSp>
                <p:nvCxnSpPr>
                  <p:cNvPr id="9" name="Straight Arrow Connector 8"/>
                  <p:cNvCxnSpPr/>
                  <p:nvPr/>
                </p:nvCxnSpPr>
                <p:spPr>
                  <a:xfrm flipV="1">
                    <a:off x="2781652" y="1555243"/>
                    <a:ext cx="1233965" cy="15479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" name="Straight Arrow Connector 11"/>
                  <p:cNvCxnSpPr/>
                  <p:nvPr/>
                </p:nvCxnSpPr>
                <p:spPr>
                  <a:xfrm>
                    <a:off x="2781652" y="3974744"/>
                    <a:ext cx="1233965" cy="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" name="Straight Arrow Connector 13"/>
                  <p:cNvCxnSpPr/>
                  <p:nvPr/>
                </p:nvCxnSpPr>
                <p:spPr>
                  <a:xfrm>
                    <a:off x="2781652" y="4065597"/>
                    <a:ext cx="1233965" cy="59768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" name="Straight Arrow Connector 15"/>
                  <p:cNvCxnSpPr/>
                  <p:nvPr/>
                </p:nvCxnSpPr>
                <p:spPr>
                  <a:xfrm>
                    <a:off x="2781652" y="4450314"/>
                    <a:ext cx="1233965" cy="65843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" name="Straight Arrow Connector 17"/>
                  <p:cNvCxnSpPr/>
                  <p:nvPr/>
                </p:nvCxnSpPr>
                <p:spPr>
                  <a:xfrm>
                    <a:off x="2781652" y="4348359"/>
                    <a:ext cx="1233965" cy="431171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0" name="Group 19"/>
                <p:cNvGrpSpPr/>
                <p:nvPr/>
              </p:nvGrpSpPr>
              <p:grpSpPr>
                <a:xfrm>
                  <a:off x="2662619" y="1367145"/>
                  <a:ext cx="2105644" cy="315766"/>
                  <a:chOff x="2864815" y="81270"/>
                  <a:chExt cx="2105644" cy="315766"/>
                </a:xfrm>
              </p:grpSpPr>
              <p:sp>
                <p:nvSpPr>
                  <p:cNvPr id="21" name="TextBox 20"/>
                  <p:cNvSpPr txBox="1"/>
                  <p:nvPr/>
                </p:nvSpPr>
                <p:spPr>
                  <a:xfrm>
                    <a:off x="4715261" y="103238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0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22" name="Straight Connector 21"/>
                  <p:cNvCxnSpPr/>
                  <p:nvPr/>
                </p:nvCxnSpPr>
                <p:spPr>
                  <a:xfrm>
                    <a:off x="2864815" y="323307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" name="Straight Connector 22"/>
                  <p:cNvCxnSpPr/>
                  <p:nvPr/>
                </p:nvCxnSpPr>
                <p:spPr>
                  <a:xfrm>
                    <a:off x="3190752" y="317409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" name="Straight Connector 23"/>
                  <p:cNvCxnSpPr/>
                  <p:nvPr/>
                </p:nvCxnSpPr>
                <p:spPr>
                  <a:xfrm>
                    <a:off x="3522329" y="319726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" name="Straight Connector 24"/>
                  <p:cNvCxnSpPr/>
                  <p:nvPr/>
                </p:nvCxnSpPr>
                <p:spPr>
                  <a:xfrm>
                    <a:off x="4189079" y="316112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" name="Straight Connector 25"/>
                  <p:cNvCxnSpPr/>
                  <p:nvPr/>
                </p:nvCxnSpPr>
                <p:spPr>
                  <a:xfrm>
                    <a:off x="4522454" y="322721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" name="Straight Connector 26"/>
                  <p:cNvCxnSpPr/>
                  <p:nvPr/>
                </p:nvCxnSpPr>
                <p:spPr>
                  <a:xfrm>
                    <a:off x="4852753" y="329074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8" name="TextBox 27"/>
                  <p:cNvSpPr txBox="1"/>
                  <p:nvPr/>
                </p:nvSpPr>
                <p:spPr>
                  <a:xfrm>
                    <a:off x="4378405" y="92505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1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9" name="TextBox 28"/>
                  <p:cNvSpPr txBox="1"/>
                  <p:nvPr/>
                </p:nvSpPr>
                <p:spPr>
                  <a:xfrm>
                    <a:off x="4060266" y="92505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2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0" name="TextBox 29"/>
                  <p:cNvSpPr txBox="1"/>
                  <p:nvPr/>
                </p:nvSpPr>
                <p:spPr>
                  <a:xfrm>
                    <a:off x="3720602" y="95398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3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1" name="TextBox 30"/>
                  <p:cNvSpPr txBox="1"/>
                  <p:nvPr/>
                </p:nvSpPr>
                <p:spPr>
                  <a:xfrm>
                    <a:off x="3387227" y="82633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4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2" name="TextBox 31"/>
                  <p:cNvSpPr txBox="1"/>
                  <p:nvPr/>
                </p:nvSpPr>
                <p:spPr>
                  <a:xfrm>
                    <a:off x="3063834" y="81270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cxnSp>
              <p:nvCxnSpPr>
                <p:cNvPr id="13" name="Straight Connector 12"/>
                <p:cNvCxnSpPr/>
                <p:nvPr/>
              </p:nvCxnSpPr>
              <p:spPr>
                <a:xfrm>
                  <a:off x="1305968" y="4597890"/>
                  <a:ext cx="1209675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9216" name="Group 9215"/>
                <p:cNvGrpSpPr/>
                <p:nvPr/>
              </p:nvGrpSpPr>
              <p:grpSpPr>
                <a:xfrm>
                  <a:off x="1303797" y="1673562"/>
                  <a:ext cx="1257575" cy="3143012"/>
                  <a:chOff x="848768" y="1673562"/>
                  <a:chExt cx="1257575" cy="3143012"/>
                </a:xfrm>
              </p:grpSpPr>
              <p:pic>
                <p:nvPicPr>
                  <p:cNvPr id="10243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848768" y="1673562"/>
                    <a:ext cx="1209675" cy="2933853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17" name="Rectangle 16"/>
                  <p:cNvSpPr/>
                  <p:nvPr/>
                </p:nvSpPr>
                <p:spPr>
                  <a:xfrm>
                    <a:off x="2060624" y="4549502"/>
                    <a:ext cx="45719" cy="267072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sz="1000">
                      <a:solidFill>
                        <a:prstClr val="white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38" name="TextBox 37"/>
                <p:cNvSpPr txBox="1"/>
                <p:nvPr/>
              </p:nvSpPr>
              <p:spPr>
                <a:xfrm>
                  <a:off x="1657018" y="4640140"/>
                  <a:ext cx="5036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e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3422537" y="4640141"/>
                  <a:ext cx="4683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f</a:t>
                  </a:r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3246430" y="1079324"/>
                  <a:ext cx="44755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LOD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41" name="Straight Connector 40"/>
              <p:cNvCxnSpPr/>
              <p:nvPr/>
            </p:nvCxnSpPr>
            <p:spPr>
              <a:xfrm>
                <a:off x="3455802" y="1106638"/>
                <a:ext cx="0" cy="6796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TextBox 41"/>
              <p:cNvSpPr txBox="1"/>
              <p:nvPr/>
            </p:nvSpPr>
            <p:spPr>
              <a:xfrm>
                <a:off x="2352255" y="86818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6</a:t>
                </a:r>
                <a:endParaRPr lang="en-GB" sz="10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3" name="TextBox 2"/>
          <p:cNvSpPr txBox="1"/>
          <p:nvPr/>
        </p:nvSpPr>
        <p:spPr>
          <a:xfrm>
            <a:off x="153023" y="4941168"/>
            <a:ext cx="7048937" cy="17211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Times New Roman"/>
                <a:ea typeface="PMingLiU"/>
                <a:cs typeface="Times New Roman"/>
              </a:rPr>
              <a:t>Supplementary Fig. S2. 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Ft genes as anchors between genetic map (YS-143×PC-175) (</a:t>
            </a:r>
            <a:r>
              <a:rPr lang="en-GB" sz="1200" dirty="0" err="1">
                <a:latin typeface="Times New Roman"/>
                <a:ea typeface="PMingLiU"/>
                <a:cs typeface="Times New Roman"/>
              </a:rPr>
              <a:t>cM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) and physical map (Mb). A total of 730 Ft candidate genes were included in the physical map. The same Ft candidate genes are connected with solid lines between genetic and physical maps. P behind linkage group assignment indicates the physical map.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 </a:t>
            </a:r>
            <a:r>
              <a:rPr lang="en-US" sz="1200" dirty="0" err="1">
                <a:latin typeface="Times New Roman"/>
                <a:ea typeface="PMingLiU"/>
                <a:cs typeface="Times New Roman"/>
              </a:rPr>
              <a:t>eQTL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 represented by expression block are shown on the left of the linkage groups, close to their corresponding genetic markers. Physical maps ends represent Chiffue-401 genome end markers. The displayed physical and genetic location of all Ft genes with </a:t>
            </a:r>
            <a:r>
              <a:rPr lang="en-US" sz="1200" dirty="0" err="1">
                <a:latin typeface="Times New Roman"/>
                <a:ea typeface="PMingLiU"/>
                <a:cs typeface="Times New Roman"/>
              </a:rPr>
              <a:t>eQTL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 </a:t>
            </a:r>
            <a:r>
              <a:rPr lang="en-US" sz="1200" dirty="0">
                <a:latin typeface="Times New Roman"/>
                <a:ea typeface="SimSun"/>
                <a:cs typeface="Times New Roman"/>
              </a:rPr>
              <a:t>is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 included as </a:t>
            </a:r>
            <a:r>
              <a:rPr lang="en-US" sz="1200" dirty="0">
                <a:solidFill>
                  <a:srgbClr val="0000FF"/>
                </a:solidFill>
                <a:latin typeface="Times New Roman"/>
                <a:ea typeface="PMingLiU"/>
                <a:cs typeface="Times New Roman"/>
              </a:rPr>
              <a:t>Supplementary Table S10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.</a:t>
            </a:r>
            <a:r>
              <a:rPr lang="en-US" sz="1200" dirty="0">
                <a:latin typeface="Times New Roman"/>
                <a:ea typeface="SimSun"/>
                <a:cs typeface="Times New Roman"/>
              </a:rPr>
              <a:t> </a:t>
            </a:r>
            <a:endParaRPr lang="en-GB" sz="850" dirty="0">
              <a:effectLst/>
              <a:latin typeface="Verdana"/>
              <a:ea typeface="PMingLiU"/>
              <a:cs typeface="Times New Roman"/>
            </a:endParaRPr>
          </a:p>
        </p:txBody>
      </p:sp>
      <p:pic>
        <p:nvPicPr>
          <p:cNvPr id="34" name="Picture 3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9" t="4835" r="8700" b="4698"/>
          <a:stretch/>
        </p:blipFill>
        <p:spPr bwMode="auto">
          <a:xfrm>
            <a:off x="2454541" y="1145408"/>
            <a:ext cx="2107066" cy="2955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78154190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475656" y="5744289"/>
            <a:ext cx="1104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hromosome</a:t>
            </a:r>
            <a:endParaRPr lang="en-GB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4520185" y="648739"/>
            <a:ext cx="4084263" cy="2588174"/>
            <a:chOff x="4206246" y="205658"/>
            <a:chExt cx="4084263" cy="2588174"/>
          </a:xfrm>
        </p:grpSpPr>
        <p:pic>
          <p:nvPicPr>
            <p:cNvPr id="3079" name="Picture 7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06246" y="205658"/>
              <a:ext cx="4084263" cy="23111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>
              <a:off x="5868144" y="2516833"/>
              <a:ext cx="1104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hromosome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-51957" y="631723"/>
            <a:ext cx="4258203" cy="2588152"/>
            <a:chOff x="-51957" y="188642"/>
            <a:chExt cx="4258203" cy="2588152"/>
          </a:xfrm>
        </p:grpSpPr>
        <p:pic>
          <p:nvPicPr>
            <p:cNvPr id="3081" name="Picture 9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6942" y="188642"/>
              <a:ext cx="4039304" cy="23042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TextBox 8"/>
            <p:cNvSpPr txBox="1"/>
            <p:nvPr/>
          </p:nvSpPr>
          <p:spPr>
            <a:xfrm>
              <a:off x="1634199" y="2499795"/>
              <a:ext cx="1104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hromosome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 rot="10800000">
              <a:off x="-51957" y="980954"/>
              <a:ext cx="369332" cy="40812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LOD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3" name="TextBox 12"/>
          <p:cNvSpPr txBox="1"/>
          <p:nvPr/>
        </p:nvSpPr>
        <p:spPr>
          <a:xfrm rot="10800000">
            <a:off x="4289740" y="1405619"/>
            <a:ext cx="369332" cy="40812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GB" sz="12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LOD</a:t>
            </a:r>
            <a:endParaRPr lang="en-GB" sz="12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" name="Group 9"/>
          <p:cNvGrpSpPr/>
          <p:nvPr/>
        </p:nvGrpSpPr>
        <p:grpSpPr>
          <a:xfrm>
            <a:off x="4339980" y="3404662"/>
            <a:ext cx="4232608" cy="2590334"/>
            <a:chOff x="4339980" y="2961581"/>
            <a:chExt cx="4232608" cy="2590334"/>
          </a:xfrm>
        </p:grpSpPr>
        <p:grpSp>
          <p:nvGrpSpPr>
            <p:cNvPr id="6" name="Group 5"/>
            <p:cNvGrpSpPr/>
            <p:nvPr/>
          </p:nvGrpSpPr>
          <p:grpSpPr>
            <a:xfrm>
              <a:off x="4610242" y="2961581"/>
              <a:ext cx="3962346" cy="2590334"/>
              <a:chOff x="4288706" y="2961581"/>
              <a:chExt cx="3962346" cy="2590334"/>
            </a:xfrm>
          </p:grpSpPr>
          <p:pic>
            <p:nvPicPr>
              <p:cNvPr id="3083" name="Picture 11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88706" y="2961581"/>
                <a:ext cx="3962346" cy="233962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5948588" y="5274916"/>
                <a:ext cx="110479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Chromosome</a:t>
                </a:r>
                <a:endParaRPr lang="en-GB" sz="12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5" name="TextBox 14"/>
            <p:cNvSpPr txBox="1"/>
            <p:nvPr/>
          </p:nvSpPr>
          <p:spPr>
            <a:xfrm rot="10800000">
              <a:off x="4339980" y="3923747"/>
              <a:ext cx="369332" cy="40812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LOD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-51957" y="3397494"/>
            <a:ext cx="4258203" cy="2346795"/>
            <a:chOff x="-51957" y="2954413"/>
            <a:chExt cx="4258203" cy="2346795"/>
          </a:xfrm>
        </p:grpSpPr>
        <p:pic>
          <p:nvPicPr>
            <p:cNvPr id="3082" name="Picture 10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7903" y="2954413"/>
              <a:ext cx="3978343" cy="23467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6" name="TextBox 15"/>
            <p:cNvSpPr txBox="1"/>
            <p:nvPr/>
          </p:nvSpPr>
          <p:spPr>
            <a:xfrm rot="10800000">
              <a:off x="-51957" y="3956979"/>
              <a:ext cx="369332" cy="40812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LOD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0" y="13990"/>
            <a:ext cx="8997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itle: The </a:t>
            </a:r>
            <a:r>
              <a:rPr lang="en-GB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rassica rapa FLC</a:t>
            </a:r>
            <a:r>
              <a:rPr lang="en-GB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homolog </a:t>
            </a:r>
            <a:r>
              <a:rPr lang="en-GB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rFLC2</a:t>
            </a:r>
            <a:r>
              <a:rPr lang="en-GB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is a key regulator of flowering time, identified through transcriptional co-expression </a:t>
            </a:r>
            <a:r>
              <a:rPr lang="en-GB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networks</a:t>
            </a:r>
            <a:endParaRPr lang="en-GB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68194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8379" y="95110"/>
            <a:ext cx="4431703" cy="2520916"/>
            <a:chOff x="18379" y="95110"/>
            <a:chExt cx="4431703" cy="2520916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5850" y="95110"/>
              <a:ext cx="4154232" cy="235823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 rot="10800000">
              <a:off x="18379" y="980954"/>
              <a:ext cx="369332" cy="40812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LOD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825111" y="2339027"/>
              <a:ext cx="1104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hromosome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4510369" y="2664158"/>
            <a:ext cx="4485930" cy="2505665"/>
            <a:chOff x="4510369" y="2664158"/>
            <a:chExt cx="4485930" cy="2505665"/>
          </a:xfrm>
        </p:grpSpPr>
        <p:pic>
          <p:nvPicPr>
            <p:cNvPr id="8200" name="Picture 8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73256" y="2664158"/>
              <a:ext cx="4223043" cy="23398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 rot="10800000">
              <a:off x="4510369" y="3627899"/>
              <a:ext cx="369332" cy="40812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LOD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342430" y="4892824"/>
              <a:ext cx="1104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hromosome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85772" y="2664158"/>
            <a:ext cx="4364309" cy="2498424"/>
            <a:chOff x="85772" y="2664158"/>
            <a:chExt cx="4364309" cy="2498424"/>
          </a:xfrm>
        </p:grpSpPr>
        <p:pic>
          <p:nvPicPr>
            <p:cNvPr id="8201" name="Picture 9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9309" y="2664158"/>
              <a:ext cx="4140772" cy="23398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 rot="10800000">
              <a:off x="85772" y="3630009"/>
              <a:ext cx="369332" cy="40812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LOD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786599" y="4885583"/>
              <a:ext cx="1104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hromosome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4500321" y="85874"/>
            <a:ext cx="4377430" cy="2475821"/>
            <a:chOff x="4500321" y="85874"/>
            <a:chExt cx="4377430" cy="2475821"/>
          </a:xfrm>
        </p:grpSpPr>
        <p:pic>
          <p:nvPicPr>
            <p:cNvPr id="8196" name="Picture 4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41474" y="85874"/>
              <a:ext cx="4136277" cy="23212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TextBox 8"/>
            <p:cNvSpPr txBox="1"/>
            <p:nvPr/>
          </p:nvSpPr>
          <p:spPr>
            <a:xfrm rot="10800000">
              <a:off x="4500321" y="999885"/>
              <a:ext cx="369332" cy="40812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LOD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332382" y="2284696"/>
              <a:ext cx="1104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hromosome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471381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-51957" y="116632"/>
            <a:ext cx="4380120" cy="2499394"/>
            <a:chOff x="-51957" y="116632"/>
            <a:chExt cx="4380120" cy="2499394"/>
          </a:xfrm>
        </p:grpSpPr>
        <p:pic>
          <p:nvPicPr>
            <p:cNvPr id="13315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2941" y="116632"/>
              <a:ext cx="4145222" cy="23136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>
              <a:off x="1654295" y="2339027"/>
              <a:ext cx="1104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hromosome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0800000">
              <a:off x="-51957" y="980954"/>
              <a:ext cx="369332" cy="40812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LOD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4490700" y="74117"/>
            <a:ext cx="4436221" cy="2494696"/>
            <a:chOff x="4490700" y="74117"/>
            <a:chExt cx="4436221" cy="2494696"/>
          </a:xfrm>
        </p:grpSpPr>
        <p:pic>
          <p:nvPicPr>
            <p:cNvPr id="13316" name="Picture 4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20739" y="74117"/>
              <a:ext cx="4206182" cy="23136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" name="TextBox 8"/>
            <p:cNvSpPr txBox="1"/>
            <p:nvPr/>
          </p:nvSpPr>
          <p:spPr>
            <a:xfrm>
              <a:off x="6444208" y="2291814"/>
              <a:ext cx="1104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hromosome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0800000">
              <a:off x="4490700" y="980954"/>
              <a:ext cx="369332" cy="40812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LOD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-45805" y="2713952"/>
            <a:ext cx="4434928" cy="2442755"/>
            <a:chOff x="-45805" y="2713952"/>
            <a:chExt cx="4434928" cy="2442755"/>
          </a:xfrm>
        </p:grpSpPr>
        <p:pic>
          <p:nvPicPr>
            <p:cNvPr id="13317" name="Picture 5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2941" y="2713952"/>
              <a:ext cx="4206182" cy="230425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>
              <a:off x="1670180" y="4879708"/>
              <a:ext cx="1104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hromosome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0800000">
              <a:off x="-45805" y="3670635"/>
              <a:ext cx="369332" cy="40812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LOD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4490700" y="2758764"/>
            <a:ext cx="4406076" cy="2399054"/>
            <a:chOff x="4490700" y="2758764"/>
            <a:chExt cx="4406076" cy="2399054"/>
          </a:xfrm>
        </p:grpSpPr>
        <p:pic>
          <p:nvPicPr>
            <p:cNvPr id="13318" name="Picture 6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86915" y="2758764"/>
              <a:ext cx="4109861" cy="221925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>
              <a:off x="6444208" y="4880819"/>
              <a:ext cx="1104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hromosome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0800000">
              <a:off x="4490700" y="3656802"/>
              <a:ext cx="369332" cy="40812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LOD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744604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8523" y="188640"/>
            <a:ext cx="4428459" cy="2610166"/>
            <a:chOff x="48523" y="188640"/>
            <a:chExt cx="4428459" cy="2610166"/>
          </a:xfrm>
        </p:grpSpPr>
        <p:pic>
          <p:nvPicPr>
            <p:cNvPr id="18435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4860" y="188640"/>
              <a:ext cx="4172122" cy="239724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 rot="10800000">
              <a:off x="48523" y="1131674"/>
              <a:ext cx="369332" cy="408125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LOD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979712" y="2521807"/>
              <a:ext cx="1104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Chromosome</a:t>
              </a:r>
              <a:endParaRPr lang="en-GB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" name="Rectangle 5"/>
          <p:cNvSpPr/>
          <p:nvPr/>
        </p:nvSpPr>
        <p:spPr>
          <a:xfrm>
            <a:off x="304860" y="5071895"/>
            <a:ext cx="8443604" cy="889346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nl-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Times New Roman"/>
                <a:ea typeface="PMingLiU"/>
                <a:cs typeface="Times New Roman"/>
              </a:rPr>
              <a:t>Supplementary Fig. S3. 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The relative abundance of 13 Ft candidate gene transcripts using RT-</a:t>
            </a:r>
            <a:r>
              <a:rPr lang="en-US" sz="1200" dirty="0" err="1">
                <a:latin typeface="Times New Roman"/>
                <a:ea typeface="PMingLiU"/>
                <a:cs typeface="Times New Roman"/>
              </a:rPr>
              <a:t>qPCR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, plotted at 1cM distances along all linkage groups. X-axis shows the chromosome numbers, A01-A10. Y-axis shows the LOD scores from restricted MQM Mapping in </a:t>
            </a:r>
            <a:r>
              <a:rPr lang="en-US" sz="1200" dirty="0" err="1">
                <a:latin typeface="Times New Roman"/>
                <a:ea typeface="PMingLiU"/>
                <a:cs typeface="Times New Roman"/>
              </a:rPr>
              <a:t>MapQTL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. </a:t>
            </a:r>
            <a:endParaRPr lang="en-GB" sz="850" dirty="0">
              <a:effectLst/>
              <a:latin typeface="Verdana"/>
              <a:ea typeface="PMingLiU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40690647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xiao005\Desktop\6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21" t="1766" r="3353"/>
          <a:stretch/>
        </p:blipFill>
        <p:spPr bwMode="auto">
          <a:xfrm>
            <a:off x="611560" y="323509"/>
            <a:ext cx="8183419" cy="60653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486704" y="323509"/>
            <a:ext cx="22850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  <a:p>
            <a:r>
              <a:rPr lang="en-GB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GB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0" y="13990"/>
            <a:ext cx="8997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itle: The </a:t>
            </a:r>
            <a:r>
              <a:rPr lang="en-GB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rassica rapa FLC</a:t>
            </a:r>
            <a:r>
              <a:rPr lang="en-GB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homolog </a:t>
            </a:r>
            <a:r>
              <a:rPr lang="en-GB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rFLC2</a:t>
            </a:r>
            <a:r>
              <a:rPr lang="en-GB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is a key regulator of flowering time, identified through transcriptional co-expression </a:t>
            </a:r>
            <a:r>
              <a:rPr lang="en-GB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networks</a:t>
            </a:r>
            <a:endParaRPr lang="en-GB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3102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4" name="Picture 6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0" t="3162" r="6415" b="8468"/>
          <a:stretch/>
        </p:blipFill>
        <p:spPr bwMode="auto">
          <a:xfrm>
            <a:off x="230244" y="0"/>
            <a:ext cx="8237595" cy="685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23528" y="289958"/>
            <a:ext cx="24383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6173037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39552" y="332656"/>
            <a:ext cx="21945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</a:t>
            </a:r>
            <a:endParaRPr lang="en-GB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2" t="1802" r="14763" b="34006"/>
          <a:stretch/>
        </p:blipFill>
        <p:spPr bwMode="auto">
          <a:xfrm>
            <a:off x="5283" y="764704"/>
            <a:ext cx="9103221" cy="52972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377552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179512" y="260648"/>
            <a:ext cx="8735888" cy="6597352"/>
            <a:chOff x="-2467694" y="-2001316"/>
            <a:chExt cx="14093155" cy="10765978"/>
          </a:xfrm>
        </p:grpSpPr>
        <p:pic>
          <p:nvPicPr>
            <p:cNvPr id="10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00"/>
            <a:stretch/>
          </p:blipFill>
          <p:spPr bwMode="auto">
            <a:xfrm>
              <a:off x="-2467694" y="-1890638"/>
              <a:ext cx="5273675" cy="106553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9784"/>
            <a:stretch/>
          </p:blipFill>
          <p:spPr bwMode="auto">
            <a:xfrm>
              <a:off x="254744" y="-1910085"/>
              <a:ext cx="8460631" cy="106553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" name="Picture 4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4825"/>
            <a:stretch/>
          </p:blipFill>
          <p:spPr bwMode="auto">
            <a:xfrm>
              <a:off x="8970193" y="-2001316"/>
              <a:ext cx="2655268" cy="106553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6" name="TextBox 5"/>
          <p:cNvSpPr txBox="1"/>
          <p:nvPr/>
        </p:nvSpPr>
        <p:spPr>
          <a:xfrm>
            <a:off x="0" y="5746030"/>
            <a:ext cx="55081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Bef>
                <a:spcPts val="1400"/>
              </a:spcBef>
              <a:spcAft>
                <a:spcPts val="0"/>
              </a:spcAft>
            </a:pPr>
            <a:r>
              <a:rPr lang="en-US" sz="1200" b="1" dirty="0">
                <a:latin typeface="Times New Roman"/>
                <a:ea typeface="SimSun"/>
              </a:rPr>
              <a:t>Supplementary Fig. S1. </a:t>
            </a:r>
            <a:r>
              <a:rPr lang="en-US" sz="1200" dirty="0">
                <a:solidFill>
                  <a:srgbClr val="000000"/>
                </a:solidFill>
                <a:latin typeface="Times New Roman"/>
              </a:rPr>
              <a:t>An updated genetic linkage map constructed with 125 Ft candidate gene target markers (GT) based on DH68 population (YS-143×PC-175). The </a:t>
            </a:r>
            <a:r>
              <a:rPr lang="en-GB" sz="1200" dirty="0">
                <a:solidFill>
                  <a:srgbClr val="000000"/>
                </a:solidFill>
                <a:latin typeface="Times New Roman"/>
              </a:rPr>
              <a:t>flowering time candidate gene markers were marked by red colour.</a:t>
            </a:r>
            <a:endParaRPr lang="en-GB" sz="1200" dirty="0">
              <a:effectLst/>
              <a:latin typeface="Times New Roman"/>
              <a:ea typeface="SimSun"/>
            </a:endParaRPr>
          </a:p>
        </p:txBody>
      </p:sp>
    </p:spTree>
    <p:extLst>
      <p:ext uri="{BB962C8B-B14F-4D97-AF65-F5344CB8AC3E}">
        <p14:creationId xmlns:p14="http://schemas.microsoft.com/office/powerpoint/2010/main" val="34799947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11560" y="454578"/>
            <a:ext cx="22935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D</a:t>
            </a:r>
          </a:p>
        </p:txBody>
      </p:sp>
      <p:pic>
        <p:nvPicPr>
          <p:cNvPr id="4" name="Picture 2" descr="C:\Users\xiao005\Desktop\4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16" t="13063" r="28561" b="16779"/>
          <a:stretch/>
        </p:blipFill>
        <p:spPr bwMode="auto">
          <a:xfrm>
            <a:off x="1476375" y="304800"/>
            <a:ext cx="6648450" cy="59340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665306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xiao005\Desktop\9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458014"/>
            <a:ext cx="7975898" cy="60535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95536" y="319515"/>
            <a:ext cx="2304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E</a:t>
            </a:r>
            <a:endParaRPr lang="en-GB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65635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38612" y="116632"/>
            <a:ext cx="23762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</a:t>
            </a:r>
          </a:p>
        </p:txBody>
      </p:sp>
      <p:pic>
        <p:nvPicPr>
          <p:cNvPr id="5123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43" t="1743" r="7282" b="1789"/>
          <a:stretch/>
        </p:blipFill>
        <p:spPr bwMode="auto">
          <a:xfrm>
            <a:off x="971600" y="188640"/>
            <a:ext cx="6943725" cy="64556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480686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67544" y="404664"/>
            <a:ext cx="2605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G</a:t>
            </a:r>
          </a:p>
        </p:txBody>
      </p:sp>
      <p:pic>
        <p:nvPicPr>
          <p:cNvPr id="6146" name="Picture 2" descr="C:\Users\xiao005\Desktop\3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08" t="20383" r="27736" b="9459"/>
          <a:stretch/>
        </p:blipFill>
        <p:spPr bwMode="auto">
          <a:xfrm>
            <a:off x="2771800" y="1268760"/>
            <a:ext cx="2828926" cy="33569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797202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11560" y="384316"/>
            <a:ext cx="2160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H</a:t>
            </a:r>
            <a:endParaRPr lang="en-GB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170" name="Picture 2" descr="C:\Users\xiao005\Desktop\5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13" t="3891" r="28830" b="9092"/>
          <a:stretch/>
        </p:blipFill>
        <p:spPr bwMode="auto">
          <a:xfrm>
            <a:off x="1259632" y="384316"/>
            <a:ext cx="6482133" cy="57450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043279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323528" y="262678"/>
            <a:ext cx="21335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I</a:t>
            </a:r>
            <a:endParaRPr lang="en-GB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8194" name="Picture 2" descr="C:\Users\xiao005\Desktop\8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39" t="2157" r="5085" b="6241"/>
          <a:stretch/>
        </p:blipFill>
        <p:spPr bwMode="auto">
          <a:xfrm>
            <a:off x="1181099" y="539676"/>
            <a:ext cx="6438901" cy="49752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703574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539552" y="369533"/>
            <a:ext cx="2713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J</a:t>
            </a:r>
            <a:endParaRPr lang="en-GB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218" name="Picture 2" descr="C:\Users\xiao005\Desktop\7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600" y="403044"/>
            <a:ext cx="7366230" cy="55907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7654914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95536" y="231033"/>
            <a:ext cx="2713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K</a:t>
            </a:r>
            <a:endParaRPr lang="en-GB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6" name="Picture 8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7" t="4173" r="23743" b="3154"/>
          <a:stretch/>
        </p:blipFill>
        <p:spPr bwMode="auto">
          <a:xfrm>
            <a:off x="1187624" y="508032"/>
            <a:ext cx="7848872" cy="63499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5724128" y="6586511"/>
            <a:ext cx="1143262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ircadian clock</a:t>
            </a:r>
            <a:endParaRPr lang="en-GB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556368" y="4738970"/>
            <a:ext cx="1949573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100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hotoperiod/circadian clock</a:t>
            </a:r>
            <a:endParaRPr lang="en-GB" sz="11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7893234" y="3284984"/>
            <a:ext cx="946093" cy="2616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1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hotoperiod</a:t>
            </a:r>
          </a:p>
        </p:txBody>
      </p:sp>
    </p:spTree>
    <p:extLst>
      <p:ext uri="{BB962C8B-B14F-4D97-AF65-F5344CB8AC3E}">
        <p14:creationId xmlns:p14="http://schemas.microsoft.com/office/powerpoint/2010/main" val="6333766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95536" y="260648"/>
            <a:ext cx="8424936" cy="5598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Times New Roman"/>
                <a:ea typeface="PMingLiU"/>
                <a:cs typeface="Times New Roman"/>
              </a:rPr>
              <a:t>Supplementary Fig. S4. </a:t>
            </a:r>
            <a:r>
              <a:rPr lang="en-US" sz="1200" dirty="0">
                <a:latin typeface="Times New Roman"/>
                <a:ea typeface="SimSun"/>
                <a:cs typeface="Times New Roman"/>
              </a:rPr>
              <a:t>Extraction of functional clusters from the general gene network. Figures present the genes involved in specific functional pathways with their correlations to genes from other pathways, resulting in a multitude of interactions. 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Genes from different pathways are indicated with different </a:t>
            </a:r>
            <a:r>
              <a:rPr lang="en-US" sz="1200" dirty="0" err="1">
                <a:latin typeface="Times New Roman"/>
                <a:ea typeface="PMingLiU"/>
                <a:cs typeface="Times New Roman"/>
              </a:rPr>
              <a:t>coloured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 dots: </a:t>
            </a:r>
            <a:r>
              <a:rPr lang="en-US" sz="1200" dirty="0">
                <a:latin typeface="Times New Roman"/>
                <a:ea typeface="SimSun"/>
                <a:cs typeface="Times New Roman"/>
              </a:rPr>
              <a:t>gibberellin light blue; floral meristems dark blue; </a:t>
            </a:r>
            <a:r>
              <a:rPr lang="en-US" sz="1200" dirty="0" err="1">
                <a:latin typeface="Times New Roman"/>
                <a:ea typeface="SimSun"/>
                <a:cs typeface="Times New Roman"/>
              </a:rPr>
              <a:t>vernalization</a:t>
            </a:r>
            <a:r>
              <a:rPr lang="en-US" sz="1200" dirty="0">
                <a:latin typeface="Times New Roman"/>
                <a:ea typeface="SimSun"/>
                <a:cs typeface="Times New Roman"/>
              </a:rPr>
              <a:t> magenta; autonomous light pink; red/far red light signaling orange; photoperiod/circadian clock red; regulation of transcription black; light signaling purple; floral integrators green; development yellow and unknown functional pathways grey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. </a:t>
            </a:r>
            <a:endParaRPr lang="en-GB" sz="850" dirty="0">
              <a:latin typeface="Verdana"/>
              <a:ea typeface="PMingLiU"/>
              <a:cs typeface="Times New Roman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Times New Roman"/>
                <a:ea typeface="PMingLiU"/>
                <a:cs typeface="Times New Roman"/>
              </a:rPr>
              <a:t>A,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 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The gibberellin functional pathway. </a:t>
            </a:r>
            <a:r>
              <a:rPr lang="en-US" sz="1200" dirty="0">
                <a:latin typeface="Times New Roman"/>
                <a:ea typeface="SimSun"/>
                <a:cs typeface="Times New Roman"/>
              </a:rPr>
              <a:t>Gibberellin genes integrate a diverse set of functional pathway genes. For example, </a:t>
            </a:r>
            <a:r>
              <a:rPr lang="en-US" sz="1200" i="1" dirty="0">
                <a:latin typeface="Times New Roman"/>
                <a:ea typeface="SimSun"/>
                <a:cs typeface="Times New Roman"/>
              </a:rPr>
              <a:t>GASA4</a:t>
            </a:r>
            <a:r>
              <a:rPr lang="en-US" sz="1200" dirty="0">
                <a:latin typeface="Times New Roman"/>
                <a:ea typeface="SimSun"/>
                <a:cs typeface="Times New Roman"/>
              </a:rPr>
              <a:t>_A02 and </a:t>
            </a:r>
            <a:r>
              <a:rPr lang="en-US" sz="1200" i="1" dirty="0">
                <a:latin typeface="Times New Roman"/>
                <a:ea typeface="SimSun"/>
                <a:cs typeface="Times New Roman"/>
              </a:rPr>
              <a:t>T22J18.140</a:t>
            </a:r>
            <a:r>
              <a:rPr lang="en-US" sz="1200" dirty="0">
                <a:latin typeface="Times New Roman"/>
                <a:ea typeface="SimSun"/>
                <a:cs typeface="Times New Roman"/>
              </a:rPr>
              <a:t>_A09 connects with each other and many genes belonging to other functional pathways; </a:t>
            </a:r>
            <a:r>
              <a:rPr lang="en-US" sz="1200" i="1" dirty="0">
                <a:latin typeface="Times New Roman"/>
                <a:ea typeface="SimSun"/>
                <a:cs typeface="Times New Roman"/>
              </a:rPr>
              <a:t>GA20OX3</a:t>
            </a:r>
            <a:r>
              <a:rPr lang="en-US" sz="1200" dirty="0">
                <a:latin typeface="Times New Roman"/>
                <a:ea typeface="SimSun"/>
                <a:cs typeface="Times New Roman"/>
              </a:rPr>
              <a:t>_A10, </a:t>
            </a:r>
            <a:r>
              <a:rPr lang="en-US" sz="1200" i="1" dirty="0">
                <a:latin typeface="Times New Roman"/>
                <a:ea typeface="SimSun"/>
                <a:cs typeface="Times New Roman"/>
              </a:rPr>
              <a:t>RGA</a:t>
            </a:r>
            <a:r>
              <a:rPr lang="en-US" sz="1200" dirty="0">
                <a:latin typeface="Times New Roman"/>
                <a:ea typeface="SimSun"/>
                <a:cs typeface="Times New Roman"/>
              </a:rPr>
              <a:t>_A06</a:t>
            </a:r>
            <a:r>
              <a:rPr lang="en-US" sz="1200" i="1" dirty="0">
                <a:latin typeface="Times New Roman"/>
                <a:ea typeface="PMingLiU"/>
                <a:cs typeface="Times New Roman"/>
              </a:rPr>
              <a:t> 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and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SEC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1 also show connection with genes from other functional pathways. </a:t>
            </a:r>
            <a:endParaRPr lang="en-GB" sz="850" dirty="0">
              <a:latin typeface="Verdana"/>
              <a:ea typeface="PMingLiU"/>
              <a:cs typeface="Times New Roman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Times New Roman"/>
                <a:ea typeface="PMingLiU"/>
                <a:cs typeface="Times New Roman"/>
              </a:rPr>
              <a:t>B,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 The floral meristem functional pathway. The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COP3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1,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T1N6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2_A10,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FRL2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9,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ULP1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6,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CRP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9,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CRP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3 and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UPF2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2 genes were connected as core genes with genes from other functional pathways. Especially,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PI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2 was connected with several important flowering time genes (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BrSOC1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, </a:t>
            </a:r>
            <a:r>
              <a:rPr lang="en-GB" sz="1200" i="1" dirty="0" err="1">
                <a:latin typeface="Times New Roman"/>
                <a:ea typeface="PMingLiU"/>
                <a:cs typeface="Times New Roman"/>
              </a:rPr>
              <a:t>BrFT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,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BrSRR1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,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BrFLC2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, </a:t>
            </a:r>
            <a:r>
              <a:rPr lang="en-GB" sz="1200" i="1" dirty="0" err="1">
                <a:latin typeface="Times New Roman"/>
                <a:ea typeface="PMingLiU"/>
                <a:cs typeface="Times New Roman"/>
              </a:rPr>
              <a:t>BrPHYA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,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BrVEL1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 and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BrGASA4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) and flowering time phenotype. </a:t>
            </a:r>
            <a:endParaRPr lang="en-GB" sz="850" dirty="0">
              <a:latin typeface="Verdana"/>
              <a:ea typeface="PMingLiU"/>
              <a:cs typeface="Times New Roman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Times New Roman"/>
                <a:ea typeface="PMingLiU"/>
                <a:cs typeface="Times New Roman"/>
              </a:rPr>
              <a:t>C,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 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The </a:t>
            </a:r>
            <a:r>
              <a:rPr lang="en-GB" sz="1200" dirty="0" err="1">
                <a:latin typeface="Times New Roman"/>
                <a:ea typeface="PMingLiU"/>
                <a:cs typeface="Times New Roman"/>
              </a:rPr>
              <a:t>vernalization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 functional pathway. The Figure shows that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SUF4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9,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COR15B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3.1,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COR15B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3.2,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VIP2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3,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FRI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4,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VIP4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2.1,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FIE1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5 and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FAF4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2 are correlated with genes from other functional pathways. </a:t>
            </a:r>
            <a:r>
              <a:rPr lang="en-GB" sz="1200" i="1" dirty="0" err="1">
                <a:latin typeface="Times New Roman"/>
                <a:ea typeface="PMingLiU"/>
                <a:cs typeface="Times New Roman"/>
              </a:rPr>
              <a:t>BrFLC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 </a:t>
            </a:r>
            <a:r>
              <a:rPr lang="en-GB" sz="1200" dirty="0" err="1">
                <a:latin typeface="Times New Roman"/>
                <a:ea typeface="PMingLiU"/>
                <a:cs typeface="Times New Roman"/>
              </a:rPr>
              <a:t>paralogues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 are connected with different sets of genes.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BrFLC2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 is notably interacting with some floral integrator genes and</a:t>
            </a:r>
            <a:r>
              <a:rPr lang="en-GB" sz="1200" dirty="0">
                <a:latin typeface="Times New Roman"/>
                <a:ea typeface="SimSun"/>
                <a:cs typeface="Times New Roman"/>
              </a:rPr>
              <a:t> 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flowering time phenotype. </a:t>
            </a:r>
            <a:endParaRPr lang="en-GB" sz="850" dirty="0">
              <a:latin typeface="Verdana"/>
              <a:ea typeface="PMingLiU"/>
              <a:cs typeface="Times New Roman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Times New Roman"/>
                <a:ea typeface="PMingLiU"/>
                <a:cs typeface="Times New Roman"/>
              </a:rPr>
              <a:t>D,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 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The autonomous functional pathway. The Figure shows that five autonomous functional pathway genes each are core connected with different sets of genes from other functional pathways. Only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GA20OX3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10 (</a:t>
            </a:r>
            <a:r>
              <a:rPr lang="en-US" sz="1200" dirty="0">
                <a:latin typeface="Times New Roman"/>
                <a:ea typeface="SimSun"/>
                <a:cs typeface="Times New Roman"/>
              </a:rPr>
              <a:t>gibberellin pathway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) is connected to the genes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FLK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3 and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FCA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1</a:t>
            </a:r>
            <a:r>
              <a:rPr lang="en-US" sz="1200" dirty="0">
                <a:latin typeface="Times New Roman"/>
                <a:ea typeface="SimSun"/>
                <a:cs typeface="Times New Roman"/>
              </a:rPr>
              <a:t>. </a:t>
            </a:r>
            <a:endParaRPr lang="en-GB" sz="850" dirty="0">
              <a:latin typeface="Verdana"/>
              <a:ea typeface="PMingLiU"/>
              <a:cs typeface="Times New Roman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Times New Roman"/>
                <a:ea typeface="PMingLiU"/>
                <a:cs typeface="Times New Roman"/>
              </a:rPr>
              <a:t>E,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 The red or far red light response signalling functional pathway. Expression of nine out of 16 genes is highly correlated. The genes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COL3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4 and </a:t>
            </a:r>
            <a:r>
              <a:rPr lang="en-GB" sz="1200" i="1" dirty="0">
                <a:latin typeface="Times New Roman"/>
                <a:ea typeface="PMingLiU"/>
                <a:cs typeface="Times New Roman"/>
              </a:rPr>
              <a:t>PAT1</a:t>
            </a:r>
            <a:r>
              <a:rPr lang="en-GB" sz="1200" dirty="0">
                <a:latin typeface="Times New Roman"/>
                <a:ea typeface="PMingLiU"/>
                <a:cs typeface="Times New Roman"/>
              </a:rPr>
              <a:t>_A02 are connected to genes from other functional pathways. </a:t>
            </a:r>
            <a:endParaRPr lang="en-GB" sz="850" dirty="0">
              <a:latin typeface="Verdana"/>
              <a:ea typeface="PMingLiU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0121164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95536" y="260648"/>
            <a:ext cx="8424936" cy="48013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GB" sz="1200" b="1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F,</a:t>
            </a:r>
            <a:r>
              <a:rPr lang="en-GB" sz="1200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 The photoperiod/circadian clock functional pathway. Genes are highly inter-connected. Some genes are depicted outside the circle to better visualize their connections with genes from other functional pathways. </a:t>
            </a:r>
            <a:endParaRPr lang="en-GB" sz="850" dirty="0">
              <a:solidFill>
                <a:prstClr val="black"/>
              </a:solidFill>
              <a:latin typeface="Verdana"/>
              <a:ea typeface="PMingLiU"/>
              <a:cs typeface="Times New Roman"/>
            </a:endParaRPr>
          </a:p>
          <a:p>
            <a:pPr lvl="0" algn="just">
              <a:lnSpc>
                <a:spcPct val="150000"/>
              </a:lnSpc>
            </a:pPr>
            <a:r>
              <a:rPr lang="en-GB" sz="1200" b="1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G,</a:t>
            </a:r>
            <a:r>
              <a:rPr lang="en-GB" sz="1200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 The regulation of transcription functional pathway. The Figure shows only four genes from different pathways connected with </a:t>
            </a:r>
            <a:r>
              <a:rPr lang="en-GB" sz="1200" i="1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TFIIIA</a:t>
            </a:r>
            <a:r>
              <a:rPr lang="en-GB" sz="1200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_A02 and a single gene connected with </a:t>
            </a:r>
            <a:r>
              <a:rPr lang="en-GB" sz="1200" i="1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SPL15</a:t>
            </a:r>
            <a:r>
              <a:rPr lang="en-GB" sz="1200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_A07. </a:t>
            </a:r>
            <a:endParaRPr lang="en-GB" sz="850" dirty="0">
              <a:solidFill>
                <a:prstClr val="black"/>
              </a:solidFill>
              <a:latin typeface="Verdana"/>
              <a:ea typeface="PMingLiU"/>
              <a:cs typeface="Times New Roman"/>
            </a:endParaRPr>
          </a:p>
          <a:p>
            <a:pPr lvl="0" algn="just">
              <a:lnSpc>
                <a:spcPct val="150000"/>
              </a:lnSpc>
            </a:pPr>
            <a:r>
              <a:rPr lang="en-GB" sz="1200" b="1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H,</a:t>
            </a:r>
            <a:r>
              <a:rPr lang="en-GB" sz="1200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 The light signalling functional pathway. The Figure clearly demonstrates that the </a:t>
            </a:r>
            <a:r>
              <a:rPr lang="en-GB" sz="1200" i="1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CML24</a:t>
            </a:r>
            <a:r>
              <a:rPr lang="en-GB" sz="1200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_A07 gene is connected with 16 genes, many from the red/far red signalling pathway; and four from these 16 genes were also connected with the light signalling pathway gene </a:t>
            </a:r>
            <a:r>
              <a:rPr lang="en-GB" sz="1200" i="1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CIB1</a:t>
            </a:r>
            <a:r>
              <a:rPr lang="en-GB" sz="1200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_A01. </a:t>
            </a:r>
            <a:endParaRPr lang="en-GB" sz="850" dirty="0">
              <a:solidFill>
                <a:prstClr val="black"/>
              </a:solidFill>
              <a:latin typeface="Verdana"/>
              <a:ea typeface="PMingLiU"/>
              <a:cs typeface="Times New Roman"/>
            </a:endParaRPr>
          </a:p>
          <a:p>
            <a:pPr lvl="0" algn="just">
              <a:lnSpc>
                <a:spcPct val="150000"/>
              </a:lnSpc>
            </a:pPr>
            <a:r>
              <a:rPr lang="en-GB" sz="1200" b="1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I,</a:t>
            </a:r>
            <a:r>
              <a:rPr lang="en-GB" sz="1200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 The development functional pathway. A large network connects 27 transcripts</a:t>
            </a:r>
            <a:r>
              <a:rPr lang="en-GB" sz="850" dirty="0">
                <a:solidFill>
                  <a:prstClr val="black"/>
                </a:solidFill>
                <a:latin typeface="Verdana"/>
                <a:ea typeface="PMingLiU"/>
                <a:cs typeface="Times New Roman"/>
              </a:rPr>
              <a:t> </a:t>
            </a:r>
            <a:r>
              <a:rPr lang="en-GB" sz="1200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from several functional pathways to the central genes </a:t>
            </a:r>
            <a:r>
              <a:rPr lang="en-GB" sz="1200" i="1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PCFS4</a:t>
            </a:r>
            <a:r>
              <a:rPr lang="en-GB" sz="1200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_A09 and </a:t>
            </a:r>
            <a:r>
              <a:rPr lang="en-GB" sz="1200" i="1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SDG25</a:t>
            </a:r>
            <a:r>
              <a:rPr lang="en-GB" sz="1200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_A09. </a:t>
            </a:r>
            <a:endParaRPr lang="en-GB" sz="850" dirty="0">
              <a:solidFill>
                <a:prstClr val="black"/>
              </a:solidFill>
              <a:latin typeface="Verdana"/>
              <a:ea typeface="PMingLiU"/>
              <a:cs typeface="Times New Roman"/>
            </a:endParaRPr>
          </a:p>
          <a:p>
            <a:pPr lvl="0" algn="just">
              <a:lnSpc>
                <a:spcPct val="150000"/>
              </a:lnSpc>
            </a:pPr>
            <a:r>
              <a:rPr lang="en-GB" sz="1200" b="1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J,</a:t>
            </a:r>
            <a:r>
              <a:rPr lang="en-GB" sz="1200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 The unknown functional pathway. The Figure shows that </a:t>
            </a:r>
            <a:r>
              <a:rPr lang="en-GB" sz="1200" i="1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CAM1</a:t>
            </a:r>
            <a:r>
              <a:rPr lang="en-GB" sz="1200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_A07 is clearly correlated to many genes from seven functional pathways. </a:t>
            </a:r>
            <a:endParaRPr lang="en-GB" sz="850" dirty="0">
              <a:solidFill>
                <a:prstClr val="black"/>
              </a:solidFill>
              <a:latin typeface="Verdana"/>
              <a:ea typeface="PMingLiU"/>
              <a:cs typeface="Times New Roman"/>
            </a:endParaRPr>
          </a:p>
          <a:p>
            <a:pPr lvl="0" algn="just">
              <a:lnSpc>
                <a:spcPct val="150000"/>
              </a:lnSpc>
            </a:pPr>
            <a:r>
              <a:rPr lang="en-GB" sz="1200" b="1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K,</a:t>
            </a:r>
            <a:r>
              <a:rPr lang="en-GB" sz="1200" dirty="0">
                <a:solidFill>
                  <a:prstClr val="black"/>
                </a:solidFill>
                <a:latin typeface="Times New Roman"/>
                <a:ea typeface="PMingLiU"/>
                <a:cs typeface="Times New Roman"/>
              </a:rPr>
              <a:t> Visualization of correlation between photoperiod genes, circadian clock genes, and genes assigned to both photoperiod and circadian clock pathways. Clearly genes from these three sub-clusters are highly connected both within (blue lines) and between (yellow, red and pink lines) sub-clusters. Seven photoperiod genes (31.8%) are connected with five circadian clock genes through 24 interactions (yellow lines), and 15 photoperiod genes (68.2%) with fifteen genes assigned to both photoperiod and circadian clock pathways through 45 interactions (red lines). Eight circadian clock genes (88.9%) are connected with 12 photoperiod/circadian clock genes through 35 interactions (pink lines).</a:t>
            </a:r>
            <a:endParaRPr lang="en-GB" sz="850" dirty="0">
              <a:solidFill>
                <a:prstClr val="black"/>
              </a:solidFill>
              <a:latin typeface="Verdana"/>
              <a:ea typeface="PMingLiU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822268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04677" y="231519"/>
            <a:ext cx="8841055" cy="6690309"/>
            <a:chOff x="204677" y="25285"/>
            <a:chExt cx="8931159" cy="6813419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86" t="30229" r="81732" b="40092"/>
            <a:stretch/>
          </p:blipFill>
          <p:spPr bwMode="auto">
            <a:xfrm flipH="1">
              <a:off x="2520706" y="534710"/>
              <a:ext cx="2171789" cy="559732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2" name="Group 51"/>
            <p:cNvGrpSpPr/>
            <p:nvPr/>
          </p:nvGrpSpPr>
          <p:grpSpPr>
            <a:xfrm>
              <a:off x="204677" y="25285"/>
              <a:ext cx="8931159" cy="6813419"/>
              <a:chOff x="204677" y="16049"/>
              <a:chExt cx="8931159" cy="6813419"/>
            </a:xfrm>
          </p:grpSpPr>
          <p:grpSp>
            <p:nvGrpSpPr>
              <p:cNvPr id="8" name="Group 7"/>
              <p:cNvGrpSpPr/>
              <p:nvPr/>
            </p:nvGrpSpPr>
            <p:grpSpPr>
              <a:xfrm>
                <a:off x="204677" y="16049"/>
                <a:ext cx="8053321" cy="6334501"/>
                <a:chOff x="204677" y="-127967"/>
                <a:chExt cx="8053321" cy="6334501"/>
              </a:xfrm>
            </p:grpSpPr>
            <p:cxnSp>
              <p:nvCxnSpPr>
                <p:cNvPr id="45" name="Straight Connector 44"/>
                <p:cNvCxnSpPr/>
                <p:nvPr/>
              </p:nvCxnSpPr>
              <p:spPr>
                <a:xfrm>
                  <a:off x="3244081" y="450759"/>
                  <a:ext cx="0" cy="67962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" name="TextBox 45"/>
                <p:cNvSpPr txBox="1"/>
                <p:nvPr/>
              </p:nvSpPr>
              <p:spPr>
                <a:xfrm>
                  <a:off x="2757999" y="231164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5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7" name="Group 6"/>
                <p:cNvGrpSpPr/>
                <p:nvPr/>
              </p:nvGrpSpPr>
              <p:grpSpPr>
                <a:xfrm>
                  <a:off x="204677" y="-127967"/>
                  <a:ext cx="8053321" cy="6334501"/>
                  <a:chOff x="204677" y="-127967"/>
                  <a:chExt cx="8053321" cy="6334501"/>
                </a:xfrm>
              </p:grpSpPr>
              <p:grpSp>
                <p:nvGrpSpPr>
                  <p:cNvPr id="6" name="Group 5"/>
                  <p:cNvGrpSpPr/>
                  <p:nvPr/>
                </p:nvGrpSpPr>
                <p:grpSpPr>
                  <a:xfrm>
                    <a:off x="204677" y="-127967"/>
                    <a:ext cx="8053321" cy="6334501"/>
                    <a:chOff x="204677" y="-142907"/>
                    <a:chExt cx="8053321" cy="6334501"/>
                  </a:xfrm>
                </p:grpSpPr>
                <p:grpSp>
                  <p:nvGrpSpPr>
                    <p:cNvPr id="25" name="Group 24"/>
                    <p:cNvGrpSpPr/>
                    <p:nvPr/>
                  </p:nvGrpSpPr>
                  <p:grpSpPr>
                    <a:xfrm>
                      <a:off x="2402062" y="210957"/>
                      <a:ext cx="2336618" cy="309913"/>
                      <a:chOff x="976424" y="161631"/>
                      <a:chExt cx="2336618" cy="315785"/>
                    </a:xfrm>
                  </p:grpSpPr>
                  <p:sp>
                    <p:nvSpPr>
                      <p:cNvPr id="15" name="TextBox 14"/>
                      <p:cNvSpPr txBox="1"/>
                      <p:nvPr/>
                    </p:nvSpPr>
                    <p:spPr>
                      <a:xfrm>
                        <a:off x="3057844" y="175875"/>
                        <a:ext cx="255198" cy="25088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GB" sz="1000" dirty="0" smtClean="0">
                            <a:solidFill>
                              <a:prstClr val="black"/>
                            </a:solidFill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lang="en-GB" sz="1000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cxnSp>
                    <p:nvCxnSpPr>
                      <p:cNvPr id="17" name="Straight Connector 16"/>
                      <p:cNvCxnSpPr/>
                      <p:nvPr/>
                    </p:nvCxnSpPr>
                    <p:spPr>
                      <a:xfrm>
                        <a:off x="1115616" y="402584"/>
                        <a:ext cx="0" cy="6925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4" name="Straight Connector 33"/>
                      <p:cNvCxnSpPr/>
                      <p:nvPr/>
                    </p:nvCxnSpPr>
                    <p:spPr>
                      <a:xfrm>
                        <a:off x="1457649" y="396280"/>
                        <a:ext cx="0" cy="6925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5" name="Straight Connector 34"/>
                      <p:cNvCxnSpPr/>
                      <p:nvPr/>
                    </p:nvCxnSpPr>
                    <p:spPr>
                      <a:xfrm>
                        <a:off x="2169712" y="398641"/>
                        <a:ext cx="0" cy="6925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6" name="Straight Connector 35"/>
                      <p:cNvCxnSpPr/>
                      <p:nvPr/>
                    </p:nvCxnSpPr>
                    <p:spPr>
                      <a:xfrm>
                        <a:off x="2503376" y="404664"/>
                        <a:ext cx="0" cy="6925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8" name="Straight Connector 37"/>
                      <p:cNvCxnSpPr/>
                      <p:nvPr/>
                    </p:nvCxnSpPr>
                    <p:spPr>
                      <a:xfrm>
                        <a:off x="2846276" y="401692"/>
                        <a:ext cx="0" cy="6925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9" name="Straight Connector 38"/>
                      <p:cNvCxnSpPr/>
                      <p:nvPr/>
                    </p:nvCxnSpPr>
                    <p:spPr>
                      <a:xfrm>
                        <a:off x="3186100" y="408166"/>
                        <a:ext cx="0" cy="6925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0" name="TextBox 39"/>
                      <p:cNvSpPr txBox="1"/>
                      <p:nvPr/>
                    </p:nvSpPr>
                    <p:spPr>
                      <a:xfrm>
                        <a:off x="2711463" y="167450"/>
                        <a:ext cx="255198" cy="25088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GB" sz="1000" dirty="0" smtClean="0">
                            <a:solidFill>
                              <a:prstClr val="black"/>
                            </a:solidFill>
                            <a:latin typeface="Arial" pitchFamily="34" charset="0"/>
                            <a:cs typeface="Arial" pitchFamily="34" charset="0"/>
                          </a:rPr>
                          <a:t>1</a:t>
                        </a:r>
                        <a:endParaRPr lang="en-GB" sz="1000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41" name="TextBox 40"/>
                      <p:cNvSpPr txBox="1"/>
                      <p:nvPr/>
                    </p:nvSpPr>
                    <p:spPr>
                      <a:xfrm>
                        <a:off x="2371048" y="172265"/>
                        <a:ext cx="255198" cy="25088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GB" sz="1000" dirty="0" smtClean="0">
                            <a:solidFill>
                              <a:prstClr val="black"/>
                            </a:solidFill>
                            <a:latin typeface="Arial" pitchFamily="34" charset="0"/>
                            <a:cs typeface="Arial" pitchFamily="34" charset="0"/>
                          </a:rPr>
                          <a:t>2</a:t>
                        </a:r>
                        <a:endParaRPr lang="en-GB" sz="1000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42" name="TextBox 41"/>
                      <p:cNvSpPr txBox="1"/>
                      <p:nvPr/>
                    </p:nvSpPr>
                    <p:spPr>
                      <a:xfrm>
                        <a:off x="2034899" y="161631"/>
                        <a:ext cx="255198" cy="25088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GB" sz="1000" dirty="0" smtClean="0">
                            <a:solidFill>
                              <a:prstClr val="black"/>
                            </a:solidFill>
                            <a:latin typeface="Arial" pitchFamily="34" charset="0"/>
                            <a:cs typeface="Arial" pitchFamily="34" charset="0"/>
                          </a:rPr>
                          <a:t>3</a:t>
                        </a:r>
                        <a:endParaRPr lang="en-GB" sz="1000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43" name="TextBox 42"/>
                      <p:cNvSpPr txBox="1"/>
                      <p:nvPr/>
                    </p:nvSpPr>
                    <p:spPr>
                      <a:xfrm>
                        <a:off x="1685392" y="167276"/>
                        <a:ext cx="255198" cy="25088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GB" sz="1000" dirty="0" smtClean="0">
                            <a:solidFill>
                              <a:prstClr val="black"/>
                            </a:solidFill>
                            <a:latin typeface="Arial" pitchFamily="34" charset="0"/>
                            <a:cs typeface="Arial" pitchFamily="34" charset="0"/>
                          </a:rPr>
                          <a:t>4</a:t>
                        </a:r>
                        <a:endParaRPr lang="en-GB" sz="1000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44" name="TextBox 43"/>
                      <p:cNvSpPr txBox="1"/>
                      <p:nvPr/>
                    </p:nvSpPr>
                    <p:spPr>
                      <a:xfrm>
                        <a:off x="976424" y="166853"/>
                        <a:ext cx="255198" cy="25088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GB" sz="1000" dirty="0" smtClean="0">
                            <a:solidFill>
                              <a:prstClr val="black"/>
                            </a:solidFill>
                            <a:latin typeface="Arial" pitchFamily="34" charset="0"/>
                            <a:cs typeface="Arial" pitchFamily="34" charset="0"/>
                          </a:rPr>
                          <a:t>6</a:t>
                        </a:r>
                        <a:endParaRPr lang="en-GB" sz="1000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  <p:grpSp>
                  <p:nvGrpSpPr>
                    <p:cNvPr id="37" name="Group 36"/>
                    <p:cNvGrpSpPr/>
                    <p:nvPr/>
                  </p:nvGrpSpPr>
                  <p:grpSpPr>
                    <a:xfrm>
                      <a:off x="4593745" y="-142907"/>
                      <a:ext cx="3664253" cy="6058774"/>
                      <a:chOff x="1227306" y="-194965"/>
                      <a:chExt cx="3664253" cy="6058774"/>
                    </a:xfrm>
                  </p:grpSpPr>
                  <p:sp>
                    <p:nvSpPr>
                      <p:cNvPr id="4" name="TextBox 3"/>
                      <p:cNvSpPr txBox="1"/>
                      <p:nvPr/>
                    </p:nvSpPr>
                    <p:spPr>
                      <a:xfrm>
                        <a:off x="4352629" y="-194965"/>
                        <a:ext cx="538930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GB" sz="1000" dirty="0" smtClean="0">
                            <a:solidFill>
                              <a:prstClr val="black"/>
                            </a:solidFill>
                            <a:latin typeface="Arial" pitchFamily="34" charset="0"/>
                            <a:cs typeface="Arial" pitchFamily="34" charset="0"/>
                          </a:rPr>
                          <a:t>A01-P</a:t>
                        </a:r>
                        <a:endParaRPr lang="en-GB" sz="1000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grpSp>
                    <p:nvGrpSpPr>
                      <p:cNvPr id="11" name="Group 10"/>
                      <p:cNvGrpSpPr/>
                      <p:nvPr/>
                    </p:nvGrpSpPr>
                    <p:grpSpPr>
                      <a:xfrm>
                        <a:off x="1227306" y="114202"/>
                        <a:ext cx="1872208" cy="5749607"/>
                        <a:chOff x="3459554" y="114202"/>
                        <a:chExt cx="1872208" cy="5749607"/>
                      </a:xfrm>
                    </p:grpSpPr>
                    <p:pic>
                      <p:nvPicPr>
                        <p:cNvPr id="5" name="Picture 2"/>
                        <p:cNvPicPr>
                          <a:picLocks noChangeAspect="1" noChangeArrowheads="1"/>
                        </p:cNvPicPr>
                        <p:nvPr/>
                      </p:nvPicPr>
                      <p:blipFill rotWithShape="1">
                        <a:blip r:embed="rId4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t="21811" r="63486" b="30402"/>
                        <a:stretch/>
                      </p:blipFill>
                      <p:spPr bwMode="auto">
                        <a:xfrm>
                          <a:off x="3459554" y="391201"/>
                          <a:ext cx="1872208" cy="547260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  <p:sp>
                      <p:nvSpPr>
                        <p:cNvPr id="10" name="TextBox 9"/>
                        <p:cNvSpPr txBox="1"/>
                        <p:nvPr/>
                      </p:nvSpPr>
                      <p:spPr>
                        <a:xfrm>
                          <a:off x="3747586" y="114202"/>
                          <a:ext cx="410690" cy="24622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GB" sz="1000" dirty="0" smtClean="0">
                              <a:solidFill>
                                <a:prstClr val="black"/>
                              </a:solidFill>
                              <a:latin typeface="Arial" pitchFamily="34" charset="0"/>
                              <a:cs typeface="Arial" pitchFamily="34" charset="0"/>
                            </a:rPr>
                            <a:t>A01</a:t>
                          </a:r>
                          <a:endParaRPr lang="en-GB" sz="1000" dirty="0">
                            <a:solidFill>
                              <a:prstClr val="black"/>
                            </a:solidFill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</p:grpSp>
                  <p:cxnSp>
                    <p:nvCxnSpPr>
                      <p:cNvPr id="13" name="Straight Arrow Connector 12"/>
                      <p:cNvCxnSpPr/>
                      <p:nvPr/>
                    </p:nvCxnSpPr>
                    <p:spPr>
                      <a:xfrm flipH="1" flipV="1">
                        <a:off x="2883492" y="487047"/>
                        <a:ext cx="1267922" cy="576064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8" name="Straight Arrow Connector 17"/>
                      <p:cNvCxnSpPr/>
                      <p:nvPr/>
                    </p:nvCxnSpPr>
                    <p:spPr>
                      <a:xfrm flipH="1" flipV="1">
                        <a:off x="2883491" y="640588"/>
                        <a:ext cx="1267922" cy="326100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" name="Straight Arrow Connector 19"/>
                      <p:cNvCxnSpPr/>
                      <p:nvPr/>
                    </p:nvCxnSpPr>
                    <p:spPr>
                      <a:xfrm flipH="1" flipV="1">
                        <a:off x="2955500" y="1192558"/>
                        <a:ext cx="1195913" cy="441252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2" name="Straight Arrow Connector 21"/>
                      <p:cNvCxnSpPr/>
                      <p:nvPr/>
                    </p:nvCxnSpPr>
                    <p:spPr>
                      <a:xfrm flipH="1" flipV="1">
                        <a:off x="2955501" y="1716245"/>
                        <a:ext cx="1195912" cy="220537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4" name="Straight Arrow Connector 23"/>
                      <p:cNvCxnSpPr/>
                      <p:nvPr/>
                    </p:nvCxnSpPr>
                    <p:spPr>
                      <a:xfrm flipH="1" flipV="1">
                        <a:off x="2955501" y="4404054"/>
                        <a:ext cx="1195912" cy="542124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6" name="Straight Arrow Connector 25"/>
                      <p:cNvCxnSpPr/>
                      <p:nvPr/>
                    </p:nvCxnSpPr>
                    <p:spPr>
                      <a:xfrm>
                        <a:off x="2955498" y="5115499"/>
                        <a:ext cx="1195915" cy="541264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8" name="Straight Arrow Connector 27"/>
                      <p:cNvCxnSpPr/>
                      <p:nvPr/>
                    </p:nvCxnSpPr>
                    <p:spPr>
                      <a:xfrm flipH="1" flipV="1">
                        <a:off x="2955499" y="5628188"/>
                        <a:ext cx="1195914" cy="28575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3" name="Straight Arrow Connector 32"/>
                      <p:cNvCxnSpPr/>
                      <p:nvPr/>
                    </p:nvCxnSpPr>
                    <p:spPr>
                      <a:xfrm flipH="1">
                        <a:off x="3128536" y="5470774"/>
                        <a:ext cx="1022877" cy="285129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pic>
                  <p:nvPicPr>
                    <p:cNvPr id="1030" name="Picture 6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204677" y="520862"/>
                      <a:ext cx="2295525" cy="538548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29" name="TextBox 28"/>
                    <p:cNvSpPr txBox="1"/>
                    <p:nvPr/>
                  </p:nvSpPr>
                  <p:spPr>
                    <a:xfrm>
                      <a:off x="1022316" y="5945373"/>
                      <a:ext cx="503664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1000" dirty="0" err="1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eQTL</a:t>
                      </a:r>
                      <a:endParaRPr lang="en-GB" sz="10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47" name="TextBox 46"/>
                    <p:cNvSpPr txBox="1"/>
                    <p:nvPr/>
                  </p:nvSpPr>
                  <p:spPr>
                    <a:xfrm>
                      <a:off x="3157567" y="5916798"/>
                      <a:ext cx="468398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1000" dirty="0" err="1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r>
                        <a:rPr lang="en-GB" sz="1000" dirty="0" err="1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QTL</a:t>
                      </a:r>
                      <a:endParaRPr lang="en-GB" sz="10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sp>
                <p:nvSpPr>
                  <p:cNvPr id="48" name="TextBox 47"/>
                  <p:cNvSpPr txBox="1"/>
                  <p:nvPr/>
                </p:nvSpPr>
                <p:spPr>
                  <a:xfrm>
                    <a:off x="3197016" y="-25558"/>
                    <a:ext cx="44755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LOD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grpSp>
            <p:nvGrpSpPr>
              <p:cNvPr id="49" name="Group 48"/>
              <p:cNvGrpSpPr/>
              <p:nvPr/>
            </p:nvGrpSpPr>
            <p:grpSpPr>
              <a:xfrm>
                <a:off x="7563997" y="260648"/>
                <a:ext cx="1571839" cy="6568820"/>
                <a:chOff x="649222" y="44624"/>
                <a:chExt cx="1571839" cy="6919314"/>
              </a:xfrm>
            </p:grpSpPr>
            <p:pic>
              <p:nvPicPr>
                <p:cNvPr id="50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20757" r="82708" b="19472"/>
                <a:stretch/>
              </p:blipFill>
              <p:spPr bwMode="auto">
                <a:xfrm>
                  <a:off x="683568" y="44624"/>
                  <a:ext cx="1537493" cy="443212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51" name="Picture 50"/>
                <p:cNvPicPr>
                  <a:picLocks noChangeAspect="1" noChangeArrowheads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7230" t="20757" r="65417" b="42722"/>
                <a:stretch/>
              </p:blipFill>
              <p:spPr bwMode="auto">
                <a:xfrm>
                  <a:off x="649222" y="4255837"/>
                  <a:ext cx="1481735" cy="270810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</p:grpSp>
      </p:grpSp>
      <p:sp>
        <p:nvSpPr>
          <p:cNvPr id="54" name="TextBox 53"/>
          <p:cNvSpPr txBox="1"/>
          <p:nvPr/>
        </p:nvSpPr>
        <p:spPr>
          <a:xfrm>
            <a:off x="0" y="13990"/>
            <a:ext cx="8997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itle: The </a:t>
            </a:r>
            <a:r>
              <a:rPr lang="en-GB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rassica rapa FLC</a:t>
            </a:r>
            <a:r>
              <a:rPr lang="en-GB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homolog </a:t>
            </a:r>
            <a:r>
              <a:rPr lang="en-GB" sz="12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BrFLC2</a:t>
            </a:r>
            <a:r>
              <a:rPr lang="en-GB" sz="12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is a key regulator of flowering time, identified through transcriptional co-expression </a:t>
            </a:r>
            <a:r>
              <a:rPr lang="en-GB" sz="12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networks</a:t>
            </a:r>
            <a:endParaRPr lang="en-GB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78225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-5899" y="179404"/>
            <a:ext cx="9091305" cy="4805569"/>
            <a:chOff x="-42843" y="179404"/>
            <a:chExt cx="9091305" cy="4805569"/>
          </a:xfrm>
        </p:grpSpPr>
        <p:grpSp>
          <p:nvGrpSpPr>
            <p:cNvPr id="3" name="Group 2"/>
            <p:cNvGrpSpPr/>
            <p:nvPr/>
          </p:nvGrpSpPr>
          <p:grpSpPr>
            <a:xfrm>
              <a:off x="-42843" y="179404"/>
              <a:ext cx="9091305" cy="4805569"/>
              <a:chOff x="-42843" y="179404"/>
              <a:chExt cx="9091305" cy="4805569"/>
            </a:xfrm>
          </p:grpSpPr>
          <p:grpSp>
            <p:nvGrpSpPr>
              <p:cNvPr id="20" name="Group 19"/>
              <p:cNvGrpSpPr/>
              <p:nvPr/>
            </p:nvGrpSpPr>
            <p:grpSpPr>
              <a:xfrm>
                <a:off x="-42843" y="179404"/>
                <a:ext cx="9091305" cy="4805569"/>
                <a:chOff x="-42843" y="179404"/>
                <a:chExt cx="9091305" cy="4805569"/>
              </a:xfrm>
            </p:grpSpPr>
            <p:grpSp>
              <p:nvGrpSpPr>
                <p:cNvPr id="1024" name="Group 1023"/>
                <p:cNvGrpSpPr/>
                <p:nvPr/>
              </p:nvGrpSpPr>
              <p:grpSpPr>
                <a:xfrm>
                  <a:off x="-32224" y="179404"/>
                  <a:ext cx="9080684" cy="1386377"/>
                  <a:chOff x="72551" y="179404"/>
                  <a:chExt cx="9080684" cy="1386377"/>
                </a:xfrm>
              </p:grpSpPr>
              <p:pic>
                <p:nvPicPr>
                  <p:cNvPr id="76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1881" b="62743"/>
                  <a:stretch/>
                </p:blipFill>
                <p:spPr bwMode="auto">
                  <a:xfrm>
                    <a:off x="1648690" y="179404"/>
                    <a:ext cx="7504545" cy="128564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4" name="TextBox 3"/>
                  <p:cNvSpPr txBox="1"/>
                  <p:nvPr/>
                </p:nvSpPr>
                <p:spPr>
                  <a:xfrm>
                    <a:off x="72551" y="475451"/>
                    <a:ext cx="1645002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i="1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Arabidopsis </a:t>
                    </a:r>
                    <a:r>
                      <a:rPr lang="en-US" sz="1000" i="1" dirty="0" err="1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thaliana_FLC</a:t>
                    </a:r>
                    <a:endParaRPr lang="en-GB" sz="1000" i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" name="TextBox 4"/>
                  <p:cNvSpPr txBox="1"/>
                  <p:nvPr/>
                </p:nvSpPr>
                <p:spPr>
                  <a:xfrm>
                    <a:off x="696868" y="651498"/>
                    <a:ext cx="1023037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Chiifu_</a:t>
                    </a:r>
                    <a:r>
                      <a:rPr lang="en-US" sz="1000" i="1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BrFLC2</a:t>
                    </a:r>
                    <a:endParaRPr lang="en-GB" sz="1000" i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6" name="TextBox 5"/>
                  <p:cNvSpPr txBox="1"/>
                  <p:nvPr/>
                </p:nvSpPr>
                <p:spPr>
                  <a:xfrm>
                    <a:off x="582197" y="977853"/>
                    <a:ext cx="112082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YS-143_</a:t>
                    </a:r>
                    <a:r>
                      <a:rPr lang="en-US" sz="1000" i="1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BrFLC2</a:t>
                    </a:r>
                    <a:endParaRPr lang="en-GB" sz="1000" i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" name="TextBox 6"/>
                  <p:cNvSpPr txBox="1"/>
                  <p:nvPr/>
                </p:nvSpPr>
                <p:spPr>
                  <a:xfrm>
                    <a:off x="594834" y="799416"/>
                    <a:ext cx="1128835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PC-175_</a:t>
                    </a:r>
                    <a:r>
                      <a:rPr lang="en-US" sz="1000" i="1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BrFLC2</a:t>
                    </a:r>
                    <a:endParaRPr lang="en-GB" sz="1000" i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47" name="Straight Arrow Connector 46"/>
                  <p:cNvCxnSpPr/>
                  <p:nvPr/>
                </p:nvCxnSpPr>
                <p:spPr>
                  <a:xfrm flipH="1">
                    <a:off x="1811313" y="1565781"/>
                    <a:ext cx="3190828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46" name="Straight Connector 45"/>
                <p:cNvCxnSpPr/>
                <p:nvPr/>
              </p:nvCxnSpPr>
              <p:spPr>
                <a:xfrm>
                  <a:off x="1706538" y="1148726"/>
                  <a:ext cx="0" cy="624347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8" name="TextBox 47"/>
                <p:cNvSpPr txBox="1"/>
                <p:nvPr/>
              </p:nvSpPr>
              <p:spPr>
                <a:xfrm>
                  <a:off x="5113091" y="1435263"/>
                  <a:ext cx="623889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1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Exon 4</a:t>
                  </a:r>
                  <a:endParaRPr lang="en-GB" sz="11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94" name="Group 93"/>
                <p:cNvGrpSpPr/>
                <p:nvPr/>
              </p:nvGrpSpPr>
              <p:grpSpPr>
                <a:xfrm>
                  <a:off x="-41651" y="1821378"/>
                  <a:ext cx="9090113" cy="1548537"/>
                  <a:chOff x="63124" y="1935678"/>
                  <a:chExt cx="9090113" cy="1548537"/>
                </a:xfrm>
              </p:grpSpPr>
              <p:pic>
                <p:nvPicPr>
                  <p:cNvPr id="77" name="Picture 2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1881" t="34317" b="32842"/>
                  <a:stretch/>
                </p:blipFill>
                <p:spPr bwMode="auto">
                  <a:xfrm>
                    <a:off x="1648691" y="1935678"/>
                    <a:ext cx="7504546" cy="1133282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grpSp>
                <p:nvGrpSpPr>
                  <p:cNvPr id="80" name="Group 79"/>
                  <p:cNvGrpSpPr/>
                  <p:nvPr/>
                </p:nvGrpSpPr>
                <p:grpSpPr>
                  <a:xfrm>
                    <a:off x="63124" y="2189262"/>
                    <a:ext cx="1656879" cy="744407"/>
                    <a:chOff x="-127376" y="3116033"/>
                    <a:chExt cx="1656879" cy="744407"/>
                  </a:xfrm>
                </p:grpSpPr>
                <p:sp>
                  <p:nvSpPr>
                    <p:cNvPr id="8" name="TextBox 7"/>
                    <p:cNvSpPr txBox="1"/>
                    <p:nvPr/>
                  </p:nvSpPr>
                  <p:spPr>
                    <a:xfrm>
                      <a:off x="-127376" y="3116033"/>
                      <a:ext cx="164500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i="1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Arabidopsis </a:t>
                      </a:r>
                      <a:r>
                        <a:rPr lang="en-US" sz="1000" i="1" dirty="0" err="1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thaliana_FLC</a:t>
                      </a:r>
                      <a:endParaRPr lang="en-GB" sz="1000" i="1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9" name="TextBox 8"/>
                    <p:cNvSpPr txBox="1"/>
                    <p:nvPr/>
                  </p:nvSpPr>
                  <p:spPr>
                    <a:xfrm>
                      <a:off x="506466" y="3292080"/>
                      <a:ext cx="102303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Chiifu_</a:t>
                      </a:r>
                      <a:r>
                        <a:rPr lang="en-US" sz="1000" i="1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BrFLC2</a:t>
                      </a:r>
                      <a:endParaRPr lang="en-GB" sz="1000" i="1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0" name="TextBox 9"/>
                    <p:cNvSpPr txBox="1"/>
                    <p:nvPr/>
                  </p:nvSpPr>
                  <p:spPr>
                    <a:xfrm>
                      <a:off x="391426" y="3614219"/>
                      <a:ext cx="112082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YS-143_</a:t>
                      </a:r>
                      <a:r>
                        <a:rPr lang="en-US" sz="1000" i="1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BrFLC2</a:t>
                      </a:r>
                      <a:endParaRPr lang="en-GB" sz="1000" i="1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1" name="TextBox 10"/>
                    <p:cNvSpPr txBox="1"/>
                    <p:nvPr/>
                  </p:nvSpPr>
                  <p:spPr>
                    <a:xfrm>
                      <a:off x="392293" y="3454021"/>
                      <a:ext cx="112883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PC-175_</a:t>
                      </a:r>
                      <a:r>
                        <a:rPr lang="en-US" sz="1000" i="1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BrFLC2</a:t>
                      </a:r>
                      <a:endParaRPr lang="en-GB" sz="1000" i="1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cxnSp>
                <p:nvCxnSpPr>
                  <p:cNvPr id="49" name="Straight Connector 48"/>
                  <p:cNvCxnSpPr/>
                  <p:nvPr/>
                </p:nvCxnSpPr>
                <p:spPr>
                  <a:xfrm>
                    <a:off x="3524647" y="2631310"/>
                    <a:ext cx="0" cy="846673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7" name="Straight Arrow Connector 56"/>
                  <p:cNvCxnSpPr/>
                  <p:nvPr/>
                </p:nvCxnSpPr>
                <p:spPr>
                  <a:xfrm flipH="1">
                    <a:off x="7495174" y="3284984"/>
                    <a:ext cx="1061649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" name="Straight Connector 58"/>
                  <p:cNvCxnSpPr/>
                  <p:nvPr/>
                </p:nvCxnSpPr>
                <p:spPr>
                  <a:xfrm>
                    <a:off x="7505278" y="2859868"/>
                    <a:ext cx="0" cy="624347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2" name="TextBox 81"/>
                  <p:cNvSpPr txBox="1"/>
                  <p:nvPr/>
                </p:nvSpPr>
                <p:spPr>
                  <a:xfrm>
                    <a:off x="4992241" y="3032459"/>
                    <a:ext cx="1106393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1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Intron 4 (44bp)</a:t>
                    </a:r>
                    <a:endParaRPr lang="en-GB" sz="11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grpSp>
              <p:nvGrpSpPr>
                <p:cNvPr id="95" name="Group 94"/>
                <p:cNvGrpSpPr/>
                <p:nvPr/>
              </p:nvGrpSpPr>
              <p:grpSpPr>
                <a:xfrm>
                  <a:off x="-42843" y="3513526"/>
                  <a:ext cx="4940209" cy="1471447"/>
                  <a:chOff x="61932" y="3608776"/>
                  <a:chExt cx="4940209" cy="1471447"/>
                </a:xfrm>
              </p:grpSpPr>
              <p:grpSp>
                <p:nvGrpSpPr>
                  <p:cNvPr id="12" name="Group 11"/>
                  <p:cNvGrpSpPr/>
                  <p:nvPr/>
                </p:nvGrpSpPr>
                <p:grpSpPr>
                  <a:xfrm>
                    <a:off x="61932" y="3782598"/>
                    <a:ext cx="1647354" cy="758148"/>
                    <a:chOff x="303569" y="2197797"/>
                    <a:chExt cx="1647354" cy="758148"/>
                  </a:xfrm>
                </p:grpSpPr>
                <p:sp>
                  <p:nvSpPr>
                    <p:cNvPr id="13" name="TextBox 12"/>
                    <p:cNvSpPr txBox="1"/>
                    <p:nvPr/>
                  </p:nvSpPr>
                  <p:spPr>
                    <a:xfrm>
                      <a:off x="303569" y="2197797"/>
                      <a:ext cx="164500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i="1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Arabidopsis </a:t>
                      </a:r>
                      <a:r>
                        <a:rPr lang="en-US" sz="1000" i="1" dirty="0" err="1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thaliana_FLC</a:t>
                      </a:r>
                      <a:endParaRPr lang="en-GB" sz="1000" i="1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4" name="TextBox 13"/>
                    <p:cNvSpPr txBox="1"/>
                    <p:nvPr/>
                  </p:nvSpPr>
                  <p:spPr>
                    <a:xfrm>
                      <a:off x="927886" y="2364319"/>
                      <a:ext cx="102303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Chiifu_</a:t>
                      </a:r>
                      <a:r>
                        <a:rPr lang="en-US" sz="1000" i="1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BrFLC2</a:t>
                      </a:r>
                      <a:endParaRPr lang="en-GB" sz="1000" i="1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5" name="TextBox 14"/>
                    <p:cNvSpPr txBox="1"/>
                    <p:nvPr/>
                  </p:nvSpPr>
                  <p:spPr>
                    <a:xfrm>
                      <a:off x="822740" y="2709724"/>
                      <a:ext cx="112082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YS-143_</a:t>
                      </a:r>
                      <a:r>
                        <a:rPr lang="en-US" sz="1000" i="1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BrFLC2</a:t>
                      </a:r>
                      <a:endParaRPr lang="en-GB" sz="1000" i="1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6" name="TextBox 15"/>
                    <p:cNvSpPr txBox="1"/>
                    <p:nvPr/>
                  </p:nvSpPr>
                  <p:spPr>
                    <a:xfrm>
                      <a:off x="816327" y="2531287"/>
                      <a:ext cx="112883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PC-175_</a:t>
                      </a:r>
                      <a:r>
                        <a:rPr lang="en-US" sz="1000" i="1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BrFLC2</a:t>
                      </a:r>
                      <a:endParaRPr lang="en-GB" sz="1000" i="1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grpSp>
                <p:nvGrpSpPr>
                  <p:cNvPr id="93" name="Group 92"/>
                  <p:cNvGrpSpPr/>
                  <p:nvPr/>
                </p:nvGrpSpPr>
                <p:grpSpPr>
                  <a:xfrm>
                    <a:off x="1637618" y="3608776"/>
                    <a:ext cx="3364523" cy="1471447"/>
                    <a:chOff x="1570943" y="3964040"/>
                    <a:chExt cx="3364523" cy="1471447"/>
                  </a:xfrm>
                </p:grpSpPr>
                <p:pic>
                  <p:nvPicPr>
                    <p:cNvPr id="78" name="Picture 2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1881" t="69649" r="49176"/>
                    <a:stretch/>
                  </p:blipFill>
                  <p:spPr bwMode="auto">
                    <a:xfrm>
                      <a:off x="1570943" y="3964040"/>
                      <a:ext cx="3364523" cy="104731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cxnSp>
                  <p:nvCxnSpPr>
                    <p:cNvPr id="60" name="Straight Arrow Connector 59"/>
                    <p:cNvCxnSpPr/>
                    <p:nvPr/>
                  </p:nvCxnSpPr>
                  <p:spPr>
                    <a:xfrm>
                      <a:off x="3126507" y="5229200"/>
                      <a:ext cx="18002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arrow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64" name="TextBox 63"/>
                    <p:cNvSpPr txBox="1"/>
                    <p:nvPr/>
                  </p:nvSpPr>
                  <p:spPr>
                    <a:xfrm>
                      <a:off x="2423546" y="5098395"/>
                      <a:ext cx="623889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11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Exon 5</a:t>
                      </a:r>
                      <a:endParaRPr lang="en-GB" sz="11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cxnSp>
                  <p:nvCxnSpPr>
                    <p:cNvPr id="91" name="Straight Connector 90"/>
                    <p:cNvCxnSpPr/>
                    <p:nvPr/>
                  </p:nvCxnSpPr>
                  <p:spPr>
                    <a:xfrm>
                      <a:off x="4932019" y="4811140"/>
                      <a:ext cx="0" cy="624347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cxnSp>
              <p:nvCxnSpPr>
                <p:cNvPr id="1027" name="Straight Connector 1026"/>
                <p:cNvCxnSpPr/>
                <p:nvPr/>
              </p:nvCxnSpPr>
              <p:spPr>
                <a:xfrm>
                  <a:off x="2320702" y="2421760"/>
                  <a:ext cx="0" cy="940012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2" name="Straight Arrow Connector 111"/>
                <p:cNvCxnSpPr/>
                <p:nvPr/>
              </p:nvCxnSpPr>
              <p:spPr>
                <a:xfrm flipH="1">
                  <a:off x="3417018" y="3058489"/>
                  <a:ext cx="1480348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prstDash val="sysDash"/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8" name="Straight Arrow Connector 117"/>
                <p:cNvCxnSpPr/>
                <p:nvPr/>
              </p:nvCxnSpPr>
              <p:spPr>
                <a:xfrm>
                  <a:off x="5942233" y="3058489"/>
                  <a:ext cx="1448166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prstDash val="sysDash"/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6" name="Straight Arrow Connector 1045"/>
                <p:cNvCxnSpPr/>
                <p:nvPr/>
              </p:nvCxnSpPr>
              <p:spPr>
                <a:xfrm>
                  <a:off x="3025552" y="3056384"/>
                  <a:ext cx="376688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prstDash val="sysDash"/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8" name="Straight Arrow Connector 1047"/>
                <p:cNvCxnSpPr/>
                <p:nvPr/>
              </p:nvCxnSpPr>
              <p:spPr>
                <a:xfrm flipH="1">
                  <a:off x="2320702" y="3056384"/>
                  <a:ext cx="376688" cy="1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prstDash val="sysDash"/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5" name="TextBox 124"/>
                <p:cNvSpPr txBox="1"/>
                <p:nvPr/>
              </p:nvSpPr>
              <p:spPr>
                <a:xfrm>
                  <a:off x="2611665" y="2927900"/>
                  <a:ext cx="49885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1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12bp</a:t>
                  </a:r>
                  <a:endParaRPr lang="en-GB" sz="11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133" name="Straight Arrow Connector 132"/>
                <p:cNvCxnSpPr/>
                <p:nvPr/>
              </p:nvCxnSpPr>
              <p:spPr>
                <a:xfrm>
                  <a:off x="1691680" y="3167820"/>
                  <a:ext cx="171056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50" name="Straight Arrow Connector 49"/>
              <p:cNvCxnSpPr>
                <a:endCxn id="48" idx="3"/>
              </p:cNvCxnSpPr>
              <p:nvPr/>
            </p:nvCxnSpPr>
            <p:spPr>
              <a:xfrm flipH="1">
                <a:off x="5736980" y="1566068"/>
                <a:ext cx="278398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Straight Arrow Connector 50"/>
              <p:cNvCxnSpPr/>
              <p:nvPr/>
            </p:nvCxnSpPr>
            <p:spPr>
              <a:xfrm flipH="1">
                <a:off x="1674566" y="4782084"/>
                <a:ext cx="646136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52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098" t="53000" r="19375" b="42717"/>
              <a:stretch/>
            </p:blipFill>
            <p:spPr bwMode="auto">
              <a:xfrm>
                <a:off x="3426691" y="2299860"/>
                <a:ext cx="3962400" cy="14778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pic>
          <p:nvPicPr>
            <p:cNvPr id="55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185" t="10710" r="41513" b="86346"/>
            <a:stretch/>
          </p:blipFill>
          <p:spPr bwMode="auto">
            <a:xfrm>
              <a:off x="1953884" y="2651620"/>
              <a:ext cx="110837" cy="101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54" name="Rectangle 53"/>
          <p:cNvSpPr/>
          <p:nvPr/>
        </p:nvSpPr>
        <p:spPr>
          <a:xfrm>
            <a:off x="204677" y="132445"/>
            <a:ext cx="18025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upplemental Figure </a:t>
            </a:r>
            <a:r>
              <a:rPr lang="en-GB" sz="1200" b="1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5 </a:t>
            </a:r>
            <a:endParaRPr lang="en-GB" sz="1200" dirty="0">
              <a:solidFill>
                <a:prstClr val="black"/>
              </a:solidFill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79513" y="5531921"/>
            <a:ext cx="885971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Times New Roman"/>
                <a:ea typeface="PMingLiU"/>
                <a:cs typeface="Times New Roman"/>
              </a:rPr>
              <a:t>Supplementary Fig. S5. </a:t>
            </a:r>
            <a:r>
              <a:rPr lang="en-US" sz="1200" i="1" dirty="0">
                <a:latin typeface="Times New Roman"/>
                <a:ea typeface="PMingLiU"/>
                <a:cs typeface="Times New Roman"/>
              </a:rPr>
              <a:t>BrFLC2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 nucleotide sequence (DNA) analyses within exon 4-exon 5 and comparison to </a:t>
            </a:r>
            <a:r>
              <a:rPr lang="en-US" sz="1200" i="1" dirty="0">
                <a:latin typeface="Times New Roman"/>
                <a:ea typeface="PMingLiU"/>
                <a:cs typeface="Times New Roman"/>
              </a:rPr>
              <a:t>Arabidopsis thaliana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 (</a:t>
            </a:r>
            <a:r>
              <a:rPr lang="en-US" sz="1200" dirty="0" err="1">
                <a:latin typeface="Times New Roman"/>
                <a:ea typeface="PMingLiU"/>
                <a:cs typeface="Times New Roman"/>
              </a:rPr>
              <a:t>cDNA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) and reference genome </a:t>
            </a:r>
            <a:r>
              <a:rPr lang="en-US" sz="1200" dirty="0" err="1">
                <a:latin typeface="Times New Roman"/>
                <a:ea typeface="PMingLiU"/>
                <a:cs typeface="Times New Roman"/>
              </a:rPr>
              <a:t>Chiifu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 </a:t>
            </a:r>
            <a:r>
              <a:rPr lang="en-US" sz="1200" i="1" dirty="0">
                <a:latin typeface="Times New Roman"/>
                <a:ea typeface="PMingLiU"/>
                <a:cs typeface="Times New Roman"/>
              </a:rPr>
              <a:t>BrFLC2</a:t>
            </a:r>
            <a:r>
              <a:rPr lang="en-US" sz="1200" dirty="0">
                <a:latin typeface="Times New Roman"/>
                <a:ea typeface="PMingLiU"/>
                <a:cs typeface="Times New Roman"/>
              </a:rPr>
              <a:t>. The consistent nucleotide sequences are highlighted in black; among them, those difference nucleotide sequence are highlighted in grey.</a:t>
            </a:r>
            <a:r>
              <a:rPr lang="en-US" sz="1200" i="1" dirty="0">
                <a:latin typeface="Times New Roman"/>
                <a:ea typeface="PMingLiU"/>
                <a:cs typeface="Times New Roman"/>
              </a:rPr>
              <a:t> </a:t>
            </a:r>
            <a:endParaRPr lang="en-GB" sz="850" dirty="0">
              <a:effectLst/>
              <a:latin typeface="Verdana"/>
              <a:ea typeface="PMingLiU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6934518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Group 53"/>
          <p:cNvGrpSpPr/>
          <p:nvPr/>
        </p:nvGrpSpPr>
        <p:grpSpPr>
          <a:xfrm>
            <a:off x="139502" y="-79975"/>
            <a:ext cx="9075290" cy="6928885"/>
            <a:chOff x="139502" y="-79975"/>
            <a:chExt cx="9075290" cy="6928885"/>
          </a:xfrm>
        </p:grpSpPr>
        <p:grpSp>
          <p:nvGrpSpPr>
            <p:cNvPr id="58" name="Group 57"/>
            <p:cNvGrpSpPr/>
            <p:nvPr/>
          </p:nvGrpSpPr>
          <p:grpSpPr>
            <a:xfrm>
              <a:off x="7538651" y="73199"/>
              <a:ext cx="1676141" cy="6775711"/>
              <a:chOff x="991442" y="-315416"/>
              <a:chExt cx="1676141" cy="7526932"/>
            </a:xfrm>
          </p:grpSpPr>
          <p:pic>
            <p:nvPicPr>
              <p:cNvPr id="60" name="Picture 3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545" t="16083" r="29612" b="49216"/>
              <a:stretch/>
            </p:blipFill>
            <p:spPr bwMode="auto">
              <a:xfrm>
                <a:off x="991442" y="4638277"/>
                <a:ext cx="1408733" cy="257323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1" name="Picture 3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194" t="16082" r="46163" b="11823"/>
              <a:stretch/>
            </p:blipFill>
            <p:spPr bwMode="auto">
              <a:xfrm>
                <a:off x="1009911" y="-315416"/>
                <a:ext cx="1657672" cy="534605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63" name="Straight Connector 62"/>
              <p:cNvCxnSpPr/>
              <p:nvPr/>
            </p:nvCxnSpPr>
            <p:spPr>
              <a:xfrm>
                <a:off x="1363166" y="4293096"/>
                <a:ext cx="0" cy="93465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/>
              <p:cNvCxnSpPr/>
              <p:nvPr/>
            </p:nvCxnSpPr>
            <p:spPr>
              <a:xfrm>
                <a:off x="1472703" y="4445496"/>
                <a:ext cx="0" cy="93465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55" name="Group 2054"/>
            <p:cNvGrpSpPr/>
            <p:nvPr/>
          </p:nvGrpSpPr>
          <p:grpSpPr>
            <a:xfrm>
              <a:off x="139502" y="-79975"/>
              <a:ext cx="8091984" cy="6686055"/>
              <a:chOff x="358577" y="-79975"/>
              <a:chExt cx="8091984" cy="6686055"/>
            </a:xfrm>
          </p:grpSpPr>
          <p:grpSp>
            <p:nvGrpSpPr>
              <p:cNvPr id="31" name="Group 30"/>
              <p:cNvGrpSpPr/>
              <p:nvPr/>
            </p:nvGrpSpPr>
            <p:grpSpPr>
              <a:xfrm>
                <a:off x="358577" y="-79975"/>
                <a:ext cx="8091984" cy="6686055"/>
                <a:chOff x="358577" y="-79975"/>
                <a:chExt cx="8091984" cy="6686055"/>
              </a:xfrm>
            </p:grpSpPr>
            <p:sp>
              <p:nvSpPr>
                <p:cNvPr id="72" name="TextBox 71"/>
                <p:cNvSpPr txBox="1"/>
                <p:nvPr/>
              </p:nvSpPr>
              <p:spPr>
                <a:xfrm>
                  <a:off x="965166" y="6347787"/>
                  <a:ext cx="5036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e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3234262" y="6359859"/>
                  <a:ext cx="4683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f</a:t>
                  </a:r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30" name="Group 29"/>
                <p:cNvGrpSpPr/>
                <p:nvPr/>
              </p:nvGrpSpPr>
              <p:grpSpPr>
                <a:xfrm>
                  <a:off x="358577" y="-79975"/>
                  <a:ext cx="8091984" cy="6531087"/>
                  <a:chOff x="358577" y="-79975"/>
                  <a:chExt cx="8091984" cy="6531087"/>
                </a:xfrm>
              </p:grpSpPr>
              <p:sp>
                <p:nvSpPr>
                  <p:cNvPr id="75" name="TextBox 74"/>
                  <p:cNvSpPr txBox="1"/>
                  <p:nvPr/>
                </p:nvSpPr>
                <p:spPr>
                  <a:xfrm>
                    <a:off x="3073191" y="183992"/>
                    <a:ext cx="44755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LOD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17" name="Group 16"/>
                  <p:cNvGrpSpPr/>
                  <p:nvPr/>
                </p:nvGrpSpPr>
                <p:grpSpPr>
                  <a:xfrm>
                    <a:off x="358577" y="-79975"/>
                    <a:ext cx="8091984" cy="6531087"/>
                    <a:chOff x="539552" y="72159"/>
                    <a:chExt cx="8091984" cy="6531087"/>
                  </a:xfrm>
                </p:grpSpPr>
                <p:grpSp>
                  <p:nvGrpSpPr>
                    <p:cNvPr id="73" name="Group 72"/>
                    <p:cNvGrpSpPr/>
                    <p:nvPr/>
                  </p:nvGrpSpPr>
                  <p:grpSpPr>
                    <a:xfrm>
                      <a:off x="4826436" y="72159"/>
                      <a:ext cx="3805100" cy="6531087"/>
                      <a:chOff x="718316" y="138272"/>
                      <a:chExt cx="4340809" cy="6531087"/>
                    </a:xfrm>
                  </p:grpSpPr>
                  <p:sp>
                    <p:nvSpPr>
                      <p:cNvPr id="10" name="TextBox 9"/>
                      <p:cNvSpPr txBox="1"/>
                      <p:nvPr/>
                    </p:nvSpPr>
                    <p:spPr>
                      <a:xfrm>
                        <a:off x="4444321" y="138272"/>
                        <a:ext cx="614804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GB" sz="1000" dirty="0" smtClean="0">
                            <a:solidFill>
                              <a:prstClr val="black"/>
                            </a:solidFill>
                            <a:latin typeface="Arial" pitchFamily="34" charset="0"/>
                            <a:cs typeface="Arial" pitchFamily="34" charset="0"/>
                          </a:rPr>
                          <a:t>A02-P</a:t>
                        </a:r>
                        <a:endParaRPr lang="en-GB" sz="1000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grpSp>
                    <p:nvGrpSpPr>
                      <p:cNvPr id="13" name="Group 12"/>
                      <p:cNvGrpSpPr/>
                      <p:nvPr/>
                    </p:nvGrpSpPr>
                    <p:grpSpPr>
                      <a:xfrm>
                        <a:off x="718316" y="478895"/>
                        <a:ext cx="2119227" cy="6190464"/>
                        <a:chOff x="4067944" y="168494"/>
                        <a:chExt cx="1515906" cy="4903841"/>
                      </a:xfrm>
                    </p:grpSpPr>
                    <p:pic>
                      <p:nvPicPr>
                        <p:cNvPr id="9" name="Picture 3"/>
                        <p:cNvPicPr>
                          <a:picLocks noChangeAspect="1" noChangeArrowheads="1"/>
                        </p:cNvPicPr>
                        <p:nvPr/>
                      </p:nvPicPr>
                      <p:blipFill rotWithShape="1">
                        <a:blip r:embed="rId3" cstate="print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t="13343" r="54169" b="19734"/>
                        <a:stretch/>
                      </p:blipFill>
                      <p:spPr bwMode="auto">
                        <a:xfrm>
                          <a:off x="4067944" y="506815"/>
                          <a:ext cx="1515906" cy="456552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  <p:sp>
                      <p:nvSpPr>
                        <p:cNvPr id="12" name="TextBox 11"/>
                        <p:cNvSpPr txBox="1"/>
                        <p:nvPr/>
                      </p:nvSpPr>
                      <p:spPr>
                        <a:xfrm>
                          <a:off x="4212448" y="168494"/>
                          <a:ext cx="335130" cy="19504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GB" sz="1000" dirty="0" smtClean="0">
                              <a:solidFill>
                                <a:prstClr val="black"/>
                              </a:solidFill>
                              <a:latin typeface="Arial" pitchFamily="34" charset="0"/>
                              <a:cs typeface="Arial" pitchFamily="34" charset="0"/>
                            </a:rPr>
                            <a:t>A02</a:t>
                          </a:r>
                          <a:endParaRPr lang="en-GB" sz="1000" dirty="0">
                            <a:solidFill>
                              <a:prstClr val="black"/>
                            </a:solidFill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</p:grpSp>
                  <p:cxnSp>
                    <p:nvCxnSpPr>
                      <p:cNvPr id="14" name="Straight Arrow Connector 13"/>
                      <p:cNvCxnSpPr/>
                      <p:nvPr/>
                    </p:nvCxnSpPr>
                    <p:spPr>
                      <a:xfrm flipV="1">
                        <a:off x="2339752" y="906871"/>
                        <a:ext cx="1841976" cy="70892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" name="Straight Arrow Connector 18"/>
                      <p:cNvCxnSpPr/>
                      <p:nvPr/>
                    </p:nvCxnSpPr>
                    <p:spPr>
                      <a:xfrm flipV="1">
                        <a:off x="2411760" y="905367"/>
                        <a:ext cx="1769968" cy="867450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2" name="Straight Arrow Connector 21"/>
                      <p:cNvCxnSpPr/>
                      <p:nvPr/>
                    </p:nvCxnSpPr>
                    <p:spPr>
                      <a:xfrm flipV="1">
                        <a:off x="2267743" y="905367"/>
                        <a:ext cx="1913984" cy="507410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4" name="Straight Arrow Connector 23"/>
                      <p:cNvCxnSpPr/>
                      <p:nvPr/>
                    </p:nvCxnSpPr>
                    <p:spPr>
                      <a:xfrm flipV="1">
                        <a:off x="2267743" y="906871"/>
                        <a:ext cx="1913984" cy="649922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6" name="Straight Arrow Connector 25"/>
                      <p:cNvCxnSpPr/>
                      <p:nvPr/>
                    </p:nvCxnSpPr>
                    <p:spPr>
                      <a:xfrm flipV="1">
                        <a:off x="2229643" y="1900005"/>
                        <a:ext cx="1932571" cy="177926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7" name="Straight Arrow Connector 36"/>
                      <p:cNvCxnSpPr/>
                      <p:nvPr/>
                    </p:nvCxnSpPr>
                    <p:spPr>
                      <a:xfrm>
                        <a:off x="2294839" y="2292597"/>
                        <a:ext cx="1867375" cy="855800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1" name="Straight Arrow Connector 40"/>
                      <p:cNvCxnSpPr/>
                      <p:nvPr/>
                    </p:nvCxnSpPr>
                    <p:spPr>
                      <a:xfrm flipV="1">
                        <a:off x="2195736" y="2321172"/>
                        <a:ext cx="1985992" cy="203326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4" name="Straight Arrow Connector 43"/>
                      <p:cNvCxnSpPr/>
                      <p:nvPr/>
                    </p:nvCxnSpPr>
                    <p:spPr>
                      <a:xfrm flipV="1">
                        <a:off x="2195736" y="2204864"/>
                        <a:ext cx="1985992" cy="472034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8" name="Straight Arrow Connector 47"/>
                      <p:cNvCxnSpPr/>
                      <p:nvPr/>
                    </p:nvCxnSpPr>
                    <p:spPr>
                      <a:xfrm flipV="1">
                        <a:off x="2186500" y="2321172"/>
                        <a:ext cx="1995228" cy="576407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3" name="Straight Arrow Connector 52"/>
                      <p:cNvCxnSpPr/>
                      <p:nvPr/>
                    </p:nvCxnSpPr>
                    <p:spPr>
                      <a:xfrm>
                        <a:off x="2195736" y="3068960"/>
                        <a:ext cx="1966479" cy="184212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6" name="Straight Arrow Connector 55"/>
                      <p:cNvCxnSpPr/>
                      <p:nvPr/>
                    </p:nvCxnSpPr>
                    <p:spPr>
                      <a:xfrm>
                        <a:off x="2195736" y="3221360"/>
                        <a:ext cx="1966479" cy="31812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59" name="Straight Arrow Connector 58"/>
                      <p:cNvCxnSpPr/>
                      <p:nvPr/>
                    </p:nvCxnSpPr>
                    <p:spPr>
                      <a:xfrm>
                        <a:off x="2195736" y="3329372"/>
                        <a:ext cx="1966479" cy="245867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2" name="Straight Arrow Connector 61"/>
                      <p:cNvCxnSpPr/>
                      <p:nvPr/>
                    </p:nvCxnSpPr>
                    <p:spPr>
                      <a:xfrm flipV="1">
                        <a:off x="2250066" y="3575239"/>
                        <a:ext cx="1912149" cy="141794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4" name="Straight Arrow Connector 63"/>
                      <p:cNvCxnSpPr/>
                      <p:nvPr/>
                    </p:nvCxnSpPr>
                    <p:spPr>
                      <a:xfrm>
                        <a:off x="2250066" y="5685631"/>
                        <a:ext cx="1912149" cy="506279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66" name="Straight Arrow Connector 65"/>
                      <p:cNvCxnSpPr/>
                      <p:nvPr/>
                    </p:nvCxnSpPr>
                    <p:spPr>
                      <a:xfrm>
                        <a:off x="2294839" y="6274256"/>
                        <a:ext cx="1867375" cy="105681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0" name="Straight Arrow Connector 69"/>
                      <p:cNvCxnSpPr/>
                      <p:nvPr/>
                    </p:nvCxnSpPr>
                    <p:spPr>
                      <a:xfrm flipV="1">
                        <a:off x="2332939" y="6379937"/>
                        <a:ext cx="1829275" cy="161926"/>
                      </a:xfrm>
                      <a:prstGeom prst="straightConnector1">
                        <a:avLst/>
                      </a:prstGeom>
                      <a:ln>
                        <a:solidFill>
                          <a:srgbClr val="FF0000"/>
                        </a:solidFill>
                        <a:headEnd type="oval" w="med" len="med"/>
                        <a:tailEnd type="oval" w="med" len="med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16" name="Group 15"/>
                    <p:cNvGrpSpPr/>
                    <p:nvPr/>
                  </p:nvGrpSpPr>
                  <p:grpSpPr>
                    <a:xfrm>
                      <a:off x="2523778" y="631279"/>
                      <a:ext cx="2380589" cy="289843"/>
                      <a:chOff x="3251565" y="612229"/>
                      <a:chExt cx="2380589" cy="289843"/>
                    </a:xfrm>
                  </p:grpSpPr>
                  <p:sp>
                    <p:nvSpPr>
                      <p:cNvPr id="35" name="TextBox 34"/>
                      <p:cNvSpPr txBox="1"/>
                      <p:nvPr/>
                    </p:nvSpPr>
                    <p:spPr>
                      <a:xfrm>
                        <a:off x="5376956" y="618904"/>
                        <a:ext cx="255198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GB" sz="1000" dirty="0" smtClean="0">
                            <a:solidFill>
                              <a:prstClr val="black"/>
                            </a:solidFill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lang="en-GB" sz="1000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cxnSp>
                    <p:nvCxnSpPr>
                      <p:cNvPr id="38" name="Straight Connector 37"/>
                      <p:cNvCxnSpPr/>
                      <p:nvPr/>
                    </p:nvCxnSpPr>
                    <p:spPr>
                      <a:xfrm>
                        <a:off x="3820273" y="821708"/>
                        <a:ext cx="0" cy="67962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9" name="Straight Connector 38"/>
                      <p:cNvCxnSpPr/>
                      <p:nvPr/>
                    </p:nvCxnSpPr>
                    <p:spPr>
                      <a:xfrm>
                        <a:off x="4220811" y="834110"/>
                        <a:ext cx="0" cy="67962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0" name="Straight Connector 39"/>
                      <p:cNvCxnSpPr/>
                      <p:nvPr/>
                    </p:nvCxnSpPr>
                    <p:spPr>
                      <a:xfrm>
                        <a:off x="4638635" y="821708"/>
                        <a:ext cx="0" cy="67962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2" name="Straight Connector 41"/>
                      <p:cNvCxnSpPr/>
                      <p:nvPr/>
                    </p:nvCxnSpPr>
                    <p:spPr>
                      <a:xfrm>
                        <a:off x="5064081" y="820204"/>
                        <a:ext cx="0" cy="67962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43" name="Straight Connector 42"/>
                      <p:cNvCxnSpPr/>
                      <p:nvPr/>
                    </p:nvCxnSpPr>
                    <p:spPr>
                      <a:xfrm>
                        <a:off x="5504923" y="826268"/>
                        <a:ext cx="0" cy="67962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5" name="TextBox 44"/>
                      <p:cNvSpPr txBox="1"/>
                      <p:nvPr/>
                    </p:nvSpPr>
                    <p:spPr>
                      <a:xfrm>
                        <a:off x="4928101" y="612229"/>
                        <a:ext cx="255198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GB" sz="1000" dirty="0" smtClean="0">
                            <a:solidFill>
                              <a:prstClr val="black"/>
                            </a:solidFill>
                            <a:latin typeface="Arial" pitchFamily="34" charset="0"/>
                            <a:cs typeface="Arial" pitchFamily="34" charset="0"/>
                          </a:rPr>
                          <a:t>3</a:t>
                        </a:r>
                        <a:endParaRPr lang="en-GB" sz="1000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46" name="TextBox 45"/>
                      <p:cNvSpPr txBox="1"/>
                      <p:nvPr/>
                    </p:nvSpPr>
                    <p:spPr>
                      <a:xfrm>
                        <a:off x="4513058" y="624132"/>
                        <a:ext cx="255198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GB" sz="1000" dirty="0" smtClean="0">
                            <a:solidFill>
                              <a:prstClr val="black"/>
                            </a:solidFill>
                            <a:latin typeface="Arial" pitchFamily="34" charset="0"/>
                            <a:cs typeface="Arial" pitchFamily="34" charset="0"/>
                          </a:rPr>
                          <a:t>6</a:t>
                        </a:r>
                        <a:endParaRPr lang="en-GB" sz="1000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47" name="TextBox 46"/>
                      <p:cNvSpPr txBox="1"/>
                      <p:nvPr/>
                    </p:nvSpPr>
                    <p:spPr>
                      <a:xfrm>
                        <a:off x="3656069" y="630108"/>
                        <a:ext cx="325730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GB" sz="1000" dirty="0" smtClean="0">
                            <a:solidFill>
                              <a:prstClr val="black"/>
                            </a:solidFill>
                            <a:latin typeface="Arial" pitchFamily="34" charset="0"/>
                            <a:cs typeface="Arial" pitchFamily="34" charset="0"/>
                          </a:rPr>
                          <a:t>12</a:t>
                        </a:r>
                        <a:endParaRPr lang="en-GB" sz="1000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49" name="TextBox 48"/>
                      <p:cNvSpPr txBox="1"/>
                      <p:nvPr/>
                    </p:nvSpPr>
                    <p:spPr>
                      <a:xfrm>
                        <a:off x="3251565" y="621822"/>
                        <a:ext cx="325730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GB" sz="1000" dirty="0" smtClean="0">
                            <a:solidFill>
                              <a:prstClr val="black"/>
                            </a:solidFill>
                            <a:latin typeface="Arial" pitchFamily="34" charset="0"/>
                            <a:cs typeface="Arial" pitchFamily="34" charset="0"/>
                          </a:rPr>
                          <a:t>15</a:t>
                        </a:r>
                        <a:endParaRPr lang="en-GB" sz="1000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  <p:pic>
                  <p:nvPicPr>
                    <p:cNvPr id="2051" name="Picture 3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4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539552" y="929813"/>
                      <a:ext cx="2066925" cy="56022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</p:grpSp>
            </p:grpSp>
          </p:grpSp>
          <p:cxnSp>
            <p:nvCxnSpPr>
              <p:cNvPr id="69" name="Straight Connector 68"/>
              <p:cNvCxnSpPr/>
              <p:nvPr/>
            </p:nvCxnSpPr>
            <p:spPr>
              <a:xfrm>
                <a:off x="2507171" y="697231"/>
                <a:ext cx="0" cy="6796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TextBox 70"/>
              <p:cNvSpPr txBox="1"/>
              <p:nvPr/>
            </p:nvSpPr>
            <p:spPr>
              <a:xfrm>
                <a:off x="3171999" y="49154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9</a:t>
                </a:r>
              </a:p>
            </p:txBody>
          </p:sp>
        </p:grpSp>
      </p:grpSp>
      <p:pic>
        <p:nvPicPr>
          <p:cNvPr id="2" name="Picture 3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31" t="30874" r="81469" b="37876"/>
          <a:stretch/>
        </p:blipFill>
        <p:spPr bwMode="auto">
          <a:xfrm flipH="1">
            <a:off x="2217681" y="759207"/>
            <a:ext cx="2175803" cy="57052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661902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314003" y="-35083"/>
            <a:ext cx="8835934" cy="6918453"/>
            <a:chOff x="314003" y="-92233"/>
            <a:chExt cx="8835934" cy="6918453"/>
          </a:xfrm>
        </p:grpSpPr>
        <p:grpSp>
          <p:nvGrpSpPr>
            <p:cNvPr id="16" name="Group 15"/>
            <p:cNvGrpSpPr/>
            <p:nvPr/>
          </p:nvGrpSpPr>
          <p:grpSpPr>
            <a:xfrm>
              <a:off x="314003" y="-92233"/>
              <a:ext cx="8098293" cy="6895791"/>
              <a:chOff x="314003" y="-92233"/>
              <a:chExt cx="8098293" cy="6895791"/>
            </a:xfrm>
          </p:grpSpPr>
          <p:grpSp>
            <p:nvGrpSpPr>
              <p:cNvPr id="13" name="Group 12"/>
              <p:cNvGrpSpPr/>
              <p:nvPr/>
            </p:nvGrpSpPr>
            <p:grpSpPr>
              <a:xfrm>
                <a:off x="314003" y="-92233"/>
                <a:ext cx="8098293" cy="6895791"/>
                <a:chOff x="314003" y="-92233"/>
                <a:chExt cx="8098293" cy="6895791"/>
              </a:xfrm>
            </p:grpSpPr>
            <p:grpSp>
              <p:nvGrpSpPr>
                <p:cNvPr id="58" name="Group 57"/>
                <p:cNvGrpSpPr/>
                <p:nvPr/>
              </p:nvGrpSpPr>
              <p:grpSpPr>
                <a:xfrm>
                  <a:off x="2855579" y="84366"/>
                  <a:ext cx="2114880" cy="312670"/>
                  <a:chOff x="2855579" y="84366"/>
                  <a:chExt cx="2114880" cy="312670"/>
                </a:xfrm>
              </p:grpSpPr>
              <p:sp>
                <p:nvSpPr>
                  <p:cNvPr id="35" name="TextBox 34"/>
                  <p:cNvSpPr txBox="1"/>
                  <p:nvPr/>
                </p:nvSpPr>
                <p:spPr>
                  <a:xfrm>
                    <a:off x="4715261" y="103238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0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37" name="Straight Connector 36"/>
                  <p:cNvCxnSpPr/>
                  <p:nvPr/>
                </p:nvCxnSpPr>
                <p:spPr>
                  <a:xfrm>
                    <a:off x="2855579" y="323596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" name="Straight Connector 37"/>
                  <p:cNvCxnSpPr/>
                  <p:nvPr/>
                </p:nvCxnSpPr>
                <p:spPr>
                  <a:xfrm>
                    <a:off x="3169904" y="326934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" name="Straight Connector 38"/>
                  <p:cNvCxnSpPr/>
                  <p:nvPr/>
                </p:nvCxnSpPr>
                <p:spPr>
                  <a:xfrm>
                    <a:off x="3493754" y="319726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" name="Straight Connector 40"/>
                  <p:cNvCxnSpPr/>
                  <p:nvPr/>
                </p:nvCxnSpPr>
                <p:spPr>
                  <a:xfrm>
                    <a:off x="4170029" y="325637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" name="Straight Connector 41"/>
                  <p:cNvCxnSpPr/>
                  <p:nvPr/>
                </p:nvCxnSpPr>
                <p:spPr>
                  <a:xfrm>
                    <a:off x="4503404" y="322721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" name="Straight Connector 42"/>
                  <p:cNvCxnSpPr/>
                  <p:nvPr/>
                </p:nvCxnSpPr>
                <p:spPr>
                  <a:xfrm>
                    <a:off x="4852753" y="329074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5" name="TextBox 44"/>
                  <p:cNvSpPr txBox="1"/>
                  <p:nvPr/>
                </p:nvSpPr>
                <p:spPr>
                  <a:xfrm>
                    <a:off x="4368591" y="100078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1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4044741" y="99908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2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8" name="TextBox 47"/>
                  <p:cNvSpPr txBox="1"/>
                  <p:nvPr/>
                </p:nvSpPr>
                <p:spPr>
                  <a:xfrm>
                    <a:off x="3711366" y="94368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3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9" name="TextBox 48"/>
                  <p:cNvSpPr txBox="1"/>
                  <p:nvPr/>
                </p:nvSpPr>
                <p:spPr>
                  <a:xfrm>
                    <a:off x="3347953" y="98719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4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0" name="TextBox 49"/>
                  <p:cNvSpPr txBox="1"/>
                  <p:nvPr/>
                </p:nvSpPr>
                <p:spPr>
                  <a:xfrm>
                    <a:off x="3046687" y="84366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grpSp>
              <p:nvGrpSpPr>
                <p:cNvPr id="47" name="Group 46"/>
                <p:cNvGrpSpPr/>
                <p:nvPr/>
              </p:nvGrpSpPr>
              <p:grpSpPr>
                <a:xfrm>
                  <a:off x="4893940" y="-32050"/>
                  <a:ext cx="3518356" cy="6622575"/>
                  <a:chOff x="1475656" y="35332"/>
                  <a:chExt cx="3518356" cy="6622575"/>
                </a:xfrm>
              </p:grpSpPr>
              <p:sp>
                <p:nvSpPr>
                  <p:cNvPr id="7" name="TextBox 6"/>
                  <p:cNvSpPr txBox="1"/>
                  <p:nvPr/>
                </p:nvSpPr>
                <p:spPr>
                  <a:xfrm>
                    <a:off x="4455082" y="35332"/>
                    <a:ext cx="5389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A03-P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11" name="Group 10"/>
                  <p:cNvGrpSpPr/>
                  <p:nvPr/>
                </p:nvGrpSpPr>
                <p:grpSpPr>
                  <a:xfrm>
                    <a:off x="1475656" y="62961"/>
                    <a:ext cx="1354868" cy="6594946"/>
                    <a:chOff x="3347864" y="58056"/>
                    <a:chExt cx="1354868" cy="6594946"/>
                  </a:xfrm>
                </p:grpSpPr>
                <p:pic>
                  <p:nvPicPr>
                    <p:cNvPr id="9" name="Picture 4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3078" r="61619"/>
                    <a:stretch/>
                  </p:blipFill>
                  <p:spPr bwMode="auto">
                    <a:xfrm>
                      <a:off x="3347864" y="404664"/>
                      <a:ext cx="1354868" cy="624833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10" name="Rectangle 9"/>
                    <p:cNvSpPr/>
                    <p:nvPr/>
                  </p:nvSpPr>
                  <p:spPr>
                    <a:xfrm>
                      <a:off x="3485522" y="58056"/>
                      <a:ext cx="410690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GB" sz="1000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A03</a:t>
                      </a:r>
                    </a:p>
                  </p:txBody>
                </p:sp>
              </p:grpSp>
              <p:cxnSp>
                <p:nvCxnSpPr>
                  <p:cNvPr id="12" name="Straight Arrow Connector 11"/>
                  <p:cNvCxnSpPr/>
                  <p:nvPr/>
                </p:nvCxnSpPr>
                <p:spPr>
                  <a:xfrm>
                    <a:off x="2555776" y="764704"/>
                    <a:ext cx="1765956" cy="105681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" name="Straight Arrow Connector 13"/>
                  <p:cNvCxnSpPr/>
                  <p:nvPr/>
                </p:nvCxnSpPr>
                <p:spPr>
                  <a:xfrm>
                    <a:off x="2627784" y="1736812"/>
                    <a:ext cx="1669622" cy="36004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" name="Straight Arrow Connector 17"/>
                  <p:cNvCxnSpPr/>
                  <p:nvPr/>
                </p:nvCxnSpPr>
                <p:spPr>
                  <a:xfrm>
                    <a:off x="2761712" y="2871408"/>
                    <a:ext cx="1516443" cy="1800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Straight Arrow Connector 19"/>
                  <p:cNvCxnSpPr/>
                  <p:nvPr/>
                </p:nvCxnSpPr>
                <p:spPr>
                  <a:xfrm>
                    <a:off x="2555776" y="3027325"/>
                    <a:ext cx="1765956" cy="363058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" name="Straight Arrow Connector 21"/>
                  <p:cNvCxnSpPr/>
                  <p:nvPr/>
                </p:nvCxnSpPr>
                <p:spPr>
                  <a:xfrm>
                    <a:off x="2635559" y="3425953"/>
                    <a:ext cx="1624124" cy="52369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" name="Straight Arrow Connector 26"/>
                  <p:cNvCxnSpPr/>
                  <p:nvPr/>
                </p:nvCxnSpPr>
                <p:spPr>
                  <a:xfrm>
                    <a:off x="2635559" y="3485249"/>
                    <a:ext cx="1631899" cy="329125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" name="Straight Arrow Connector 29"/>
                  <p:cNvCxnSpPr/>
                  <p:nvPr/>
                </p:nvCxnSpPr>
                <p:spPr>
                  <a:xfrm>
                    <a:off x="2667891" y="3637649"/>
                    <a:ext cx="1599567" cy="505086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" name="Straight Arrow Connector 31"/>
                  <p:cNvCxnSpPr/>
                  <p:nvPr/>
                </p:nvCxnSpPr>
                <p:spPr>
                  <a:xfrm>
                    <a:off x="2697839" y="3931982"/>
                    <a:ext cx="1580316" cy="505086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" name="Straight Arrow Connector 32"/>
                  <p:cNvCxnSpPr/>
                  <p:nvPr/>
                </p:nvCxnSpPr>
                <p:spPr>
                  <a:xfrm>
                    <a:off x="2697839" y="4336925"/>
                    <a:ext cx="1580316" cy="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" name="Straight Arrow Connector 35"/>
                  <p:cNvCxnSpPr/>
                  <p:nvPr/>
                </p:nvCxnSpPr>
                <p:spPr>
                  <a:xfrm>
                    <a:off x="2686363" y="4501724"/>
                    <a:ext cx="1591792" cy="836428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Straight Arrow Connector 39"/>
                  <p:cNvCxnSpPr/>
                  <p:nvPr/>
                </p:nvCxnSpPr>
                <p:spPr>
                  <a:xfrm>
                    <a:off x="2686363" y="4842616"/>
                    <a:ext cx="1611043" cy="14285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Straight Arrow Connector 43"/>
                  <p:cNvCxnSpPr/>
                  <p:nvPr/>
                </p:nvCxnSpPr>
                <p:spPr>
                  <a:xfrm>
                    <a:off x="2761712" y="5696109"/>
                    <a:ext cx="1505746" cy="167703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3" name="Group 52"/>
                <p:cNvGrpSpPr/>
                <p:nvPr/>
              </p:nvGrpSpPr>
              <p:grpSpPr>
                <a:xfrm>
                  <a:off x="314003" y="377840"/>
                  <a:ext cx="2470622" cy="6261085"/>
                  <a:chOff x="314003" y="511190"/>
                  <a:chExt cx="2470622" cy="6261085"/>
                </a:xfrm>
              </p:grpSpPr>
              <p:grpSp>
                <p:nvGrpSpPr>
                  <p:cNvPr id="51" name="Group 50"/>
                  <p:cNvGrpSpPr/>
                  <p:nvPr/>
                </p:nvGrpSpPr>
                <p:grpSpPr>
                  <a:xfrm>
                    <a:off x="460525" y="511190"/>
                    <a:ext cx="2324100" cy="6203160"/>
                    <a:chOff x="422425" y="520715"/>
                    <a:chExt cx="2324100" cy="6203160"/>
                  </a:xfrm>
                </p:grpSpPr>
                <p:pic>
                  <p:nvPicPr>
                    <p:cNvPr id="17" name="Picture 4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451000" y="520715"/>
                      <a:ext cx="2295525" cy="620316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cxnSp>
                  <p:nvCxnSpPr>
                    <p:cNvPr id="21" name="Straight Connector 20"/>
                    <p:cNvCxnSpPr/>
                    <p:nvPr/>
                  </p:nvCxnSpPr>
                  <p:spPr>
                    <a:xfrm flipV="1">
                      <a:off x="422425" y="6704825"/>
                      <a:ext cx="2305050" cy="1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52" name="Rectangle 51"/>
                  <p:cNvSpPr/>
                  <p:nvPr/>
                </p:nvSpPr>
                <p:spPr>
                  <a:xfrm>
                    <a:off x="314003" y="6609575"/>
                    <a:ext cx="156047" cy="1627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sz="1000">
                      <a:solidFill>
                        <a:prstClr val="white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61" name="TextBox 60"/>
                <p:cNvSpPr txBox="1"/>
                <p:nvPr/>
              </p:nvSpPr>
              <p:spPr>
                <a:xfrm>
                  <a:off x="1184241" y="6557337"/>
                  <a:ext cx="5036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e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2" name="TextBox 61"/>
                <p:cNvSpPr txBox="1"/>
                <p:nvPr/>
              </p:nvSpPr>
              <p:spPr>
                <a:xfrm>
                  <a:off x="3500467" y="6554973"/>
                  <a:ext cx="4683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f</a:t>
                  </a:r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4" name="TextBox 63"/>
                <p:cNvSpPr txBox="1"/>
                <p:nvPr/>
              </p:nvSpPr>
              <p:spPr>
                <a:xfrm>
                  <a:off x="3558966" y="-92233"/>
                  <a:ext cx="44755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LOD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54" name="Straight Connector 53"/>
              <p:cNvCxnSpPr/>
              <p:nvPr/>
            </p:nvCxnSpPr>
            <p:spPr>
              <a:xfrm>
                <a:off x="3836654" y="326934"/>
                <a:ext cx="0" cy="6796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TextBox 54"/>
              <p:cNvSpPr txBox="1"/>
              <p:nvPr/>
            </p:nvSpPr>
            <p:spPr>
              <a:xfrm>
                <a:off x="2732237" y="9575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6</a:t>
                </a:r>
              </a:p>
            </p:txBody>
          </p:sp>
        </p:grpSp>
        <p:grpSp>
          <p:nvGrpSpPr>
            <p:cNvPr id="56" name="Group 55"/>
            <p:cNvGrpSpPr/>
            <p:nvPr/>
          </p:nvGrpSpPr>
          <p:grpSpPr>
            <a:xfrm>
              <a:off x="7740016" y="255335"/>
              <a:ext cx="1409921" cy="6570885"/>
              <a:chOff x="467544" y="188640"/>
              <a:chExt cx="1657910" cy="8922321"/>
            </a:xfrm>
          </p:grpSpPr>
          <p:pic>
            <p:nvPicPr>
              <p:cNvPr id="57" name="Picture 4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0954" t="14196" r="10400" b="10792"/>
              <a:stretch/>
            </p:blipFill>
            <p:spPr bwMode="auto">
              <a:xfrm>
                <a:off x="467544" y="188640"/>
                <a:ext cx="1657910" cy="556232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9" name="Picture 5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2278" r="83757" b="31901"/>
              <a:stretch/>
            </p:blipFill>
            <p:spPr bwMode="auto">
              <a:xfrm>
                <a:off x="535814" y="5713241"/>
                <a:ext cx="1493323" cy="339772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60" name="Straight Connector 59"/>
              <p:cNvCxnSpPr/>
              <p:nvPr/>
            </p:nvCxnSpPr>
            <p:spPr>
              <a:xfrm>
                <a:off x="868484" y="4509119"/>
                <a:ext cx="0" cy="1656183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Straight Connector 62"/>
              <p:cNvCxnSpPr/>
              <p:nvPr/>
            </p:nvCxnSpPr>
            <p:spPr>
              <a:xfrm>
                <a:off x="981657" y="4661520"/>
                <a:ext cx="0" cy="1656183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28" t="30497" r="81757" b="26442"/>
          <a:stretch/>
        </p:blipFill>
        <p:spPr bwMode="auto">
          <a:xfrm flipH="1">
            <a:off x="2834572" y="377783"/>
            <a:ext cx="2059368" cy="63182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356136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1911896" y="971693"/>
            <a:ext cx="6664245" cy="5122344"/>
            <a:chOff x="1911896" y="971693"/>
            <a:chExt cx="6664245" cy="5122344"/>
          </a:xfrm>
        </p:grpSpPr>
        <p:grpSp>
          <p:nvGrpSpPr>
            <p:cNvPr id="11" name="Group 10"/>
            <p:cNvGrpSpPr/>
            <p:nvPr/>
          </p:nvGrpSpPr>
          <p:grpSpPr>
            <a:xfrm>
              <a:off x="1911896" y="971693"/>
              <a:ext cx="6095347" cy="2657863"/>
              <a:chOff x="1911896" y="971693"/>
              <a:chExt cx="6095347" cy="2657863"/>
            </a:xfrm>
          </p:grpSpPr>
          <p:grpSp>
            <p:nvGrpSpPr>
              <p:cNvPr id="8" name="Group 7"/>
              <p:cNvGrpSpPr/>
              <p:nvPr/>
            </p:nvGrpSpPr>
            <p:grpSpPr>
              <a:xfrm>
                <a:off x="1911896" y="971693"/>
                <a:ext cx="6095347" cy="2657863"/>
                <a:chOff x="1911896" y="971693"/>
                <a:chExt cx="6095347" cy="2657863"/>
              </a:xfrm>
            </p:grpSpPr>
            <p:grpSp>
              <p:nvGrpSpPr>
                <p:cNvPr id="12" name="Group 11"/>
                <p:cNvGrpSpPr/>
                <p:nvPr/>
              </p:nvGrpSpPr>
              <p:grpSpPr>
                <a:xfrm>
                  <a:off x="2785196" y="1325185"/>
                  <a:ext cx="2086305" cy="314673"/>
                  <a:chOff x="2775671" y="982285"/>
                  <a:chExt cx="2086305" cy="314673"/>
                </a:xfrm>
              </p:grpSpPr>
              <p:sp>
                <p:nvSpPr>
                  <p:cNvPr id="16" name="TextBox 15"/>
                  <p:cNvSpPr txBox="1"/>
                  <p:nvPr/>
                </p:nvSpPr>
                <p:spPr>
                  <a:xfrm>
                    <a:off x="4606778" y="999113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0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17" name="Straight Connector 16"/>
                  <p:cNvCxnSpPr/>
                  <p:nvPr/>
                </p:nvCxnSpPr>
                <p:spPr>
                  <a:xfrm>
                    <a:off x="2775671" y="1228996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" name="Straight Connector 17"/>
                  <p:cNvCxnSpPr/>
                  <p:nvPr/>
                </p:nvCxnSpPr>
                <p:spPr>
                  <a:xfrm>
                    <a:off x="3080471" y="1222809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" name="Straight Connector 18"/>
                  <p:cNvCxnSpPr/>
                  <p:nvPr/>
                </p:nvCxnSpPr>
                <p:spPr>
                  <a:xfrm>
                    <a:off x="3404321" y="1215601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Straight Connector 19"/>
                  <p:cNvCxnSpPr/>
                  <p:nvPr/>
                </p:nvCxnSpPr>
                <p:spPr>
                  <a:xfrm>
                    <a:off x="4080596" y="1221512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" name="Straight Connector 20"/>
                  <p:cNvCxnSpPr/>
                  <p:nvPr/>
                </p:nvCxnSpPr>
                <p:spPr>
                  <a:xfrm>
                    <a:off x="4423496" y="1218596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" name="Straight Connector 21"/>
                  <p:cNvCxnSpPr/>
                  <p:nvPr/>
                </p:nvCxnSpPr>
                <p:spPr>
                  <a:xfrm>
                    <a:off x="4744270" y="1224949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3" name="TextBox 22"/>
                  <p:cNvSpPr txBox="1"/>
                  <p:nvPr/>
                </p:nvSpPr>
                <p:spPr>
                  <a:xfrm>
                    <a:off x="4279158" y="991980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1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4" name="TextBox 23"/>
                  <p:cNvSpPr txBox="1"/>
                  <p:nvPr/>
                </p:nvSpPr>
                <p:spPr>
                  <a:xfrm>
                    <a:off x="3945783" y="982285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2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5" name="TextBox 24"/>
                  <p:cNvSpPr txBox="1"/>
                  <p:nvPr/>
                </p:nvSpPr>
                <p:spPr>
                  <a:xfrm>
                    <a:off x="3583833" y="995795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3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6" name="TextBox 25"/>
                  <p:cNvSpPr txBox="1"/>
                  <p:nvPr/>
                </p:nvSpPr>
                <p:spPr>
                  <a:xfrm>
                    <a:off x="3250458" y="988451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4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7" name="TextBox 26"/>
                  <p:cNvSpPr txBox="1"/>
                  <p:nvPr/>
                </p:nvSpPr>
                <p:spPr>
                  <a:xfrm>
                    <a:off x="2950804" y="991394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grpSp>
              <p:nvGrpSpPr>
                <p:cNvPr id="10" name="Group 9"/>
                <p:cNvGrpSpPr/>
                <p:nvPr/>
              </p:nvGrpSpPr>
              <p:grpSpPr>
                <a:xfrm>
                  <a:off x="4804017" y="971693"/>
                  <a:ext cx="3203226" cy="2386682"/>
                  <a:chOff x="1259632" y="813808"/>
                  <a:chExt cx="3203226" cy="2386682"/>
                </a:xfrm>
              </p:grpSpPr>
              <p:sp>
                <p:nvSpPr>
                  <p:cNvPr id="3" name="TextBox 2"/>
                  <p:cNvSpPr txBox="1"/>
                  <p:nvPr/>
                </p:nvSpPr>
                <p:spPr>
                  <a:xfrm>
                    <a:off x="3923928" y="813808"/>
                    <a:ext cx="5389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A04-P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7" name="Group 6"/>
                  <p:cNvGrpSpPr/>
                  <p:nvPr/>
                </p:nvGrpSpPr>
                <p:grpSpPr>
                  <a:xfrm>
                    <a:off x="1259632" y="1012086"/>
                    <a:ext cx="1584176" cy="2188404"/>
                    <a:chOff x="2602671" y="852324"/>
                    <a:chExt cx="1584176" cy="2188404"/>
                  </a:xfrm>
                </p:grpSpPr>
                <p:pic>
                  <p:nvPicPr>
                    <p:cNvPr id="4" name="Picture 5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28902" r="55933" b="49381"/>
                    <a:stretch/>
                  </p:blipFill>
                  <p:spPr bwMode="auto">
                    <a:xfrm>
                      <a:off x="2602671" y="1268760"/>
                      <a:ext cx="1584176" cy="177196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6" name="TextBox 5"/>
                    <p:cNvSpPr txBox="1"/>
                    <p:nvPr/>
                  </p:nvSpPr>
                  <p:spPr>
                    <a:xfrm>
                      <a:off x="2659237" y="852324"/>
                      <a:ext cx="4106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A04</a:t>
                      </a:r>
                      <a:endParaRPr lang="en-GB" sz="10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cxnSp>
                <p:nvCxnSpPr>
                  <p:cNvPr id="9" name="Straight Arrow Connector 8"/>
                  <p:cNvCxnSpPr/>
                  <p:nvPr/>
                </p:nvCxnSpPr>
                <p:spPr>
                  <a:xfrm flipV="1">
                    <a:off x="2411760" y="1844824"/>
                    <a:ext cx="1392909" cy="100811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9" name="Group 28"/>
                <p:cNvGrpSpPr/>
                <p:nvPr/>
              </p:nvGrpSpPr>
              <p:grpSpPr>
                <a:xfrm>
                  <a:off x="1911896" y="1638983"/>
                  <a:ext cx="771525" cy="1676858"/>
                  <a:chOff x="1911896" y="1638983"/>
                  <a:chExt cx="771525" cy="1676858"/>
                </a:xfrm>
              </p:grpSpPr>
              <p:pic>
                <p:nvPicPr>
                  <p:cNvPr id="4100" name="Picture 4"/>
                  <p:cNvPicPr>
                    <a:picLocks noChangeAspect="1" noChangeArrowheads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1911896" y="1638983"/>
                    <a:ext cx="771525" cy="1676858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cxnSp>
                <p:nvCxnSpPr>
                  <p:cNvPr id="28" name="Straight Connector 27"/>
                  <p:cNvCxnSpPr/>
                  <p:nvPr/>
                </p:nvCxnSpPr>
                <p:spPr>
                  <a:xfrm>
                    <a:off x="1911896" y="3306316"/>
                    <a:ext cx="753158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7" name="TextBox 46"/>
                <p:cNvSpPr txBox="1"/>
                <p:nvPr/>
              </p:nvSpPr>
              <p:spPr>
                <a:xfrm>
                  <a:off x="2003781" y="3372037"/>
                  <a:ext cx="5036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e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3432958" y="3383335"/>
                  <a:ext cx="4683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f</a:t>
                  </a:r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3432958" y="1096808"/>
                  <a:ext cx="44755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LOD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32" name="Straight Connector 31"/>
              <p:cNvCxnSpPr/>
              <p:nvPr/>
            </p:nvCxnSpPr>
            <p:spPr>
              <a:xfrm>
                <a:off x="3737696" y="1558501"/>
                <a:ext cx="0" cy="6796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TextBox 32"/>
              <p:cNvSpPr txBox="1"/>
              <p:nvPr/>
            </p:nvSpPr>
            <p:spPr>
              <a:xfrm>
                <a:off x="2646004" y="1343819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6</a:t>
                </a:r>
              </a:p>
            </p:txBody>
          </p:sp>
        </p:grpSp>
        <p:grpSp>
          <p:nvGrpSpPr>
            <p:cNvPr id="35" name="Group 34"/>
            <p:cNvGrpSpPr/>
            <p:nvPr/>
          </p:nvGrpSpPr>
          <p:grpSpPr>
            <a:xfrm>
              <a:off x="7321346" y="1243542"/>
              <a:ext cx="1254795" cy="4850495"/>
              <a:chOff x="1710605" y="1466850"/>
              <a:chExt cx="1254795" cy="4850495"/>
            </a:xfrm>
          </p:grpSpPr>
          <p:pic>
            <p:nvPicPr>
              <p:cNvPr id="36" name="Picture 6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015" t="19781" r="69113" b="19140"/>
              <a:stretch/>
            </p:blipFill>
            <p:spPr bwMode="auto">
              <a:xfrm>
                <a:off x="1731913" y="1466850"/>
                <a:ext cx="1233487" cy="452913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7" name="Picture 6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708" t="19781" r="55240" b="71551"/>
              <a:stretch/>
            </p:blipFill>
            <p:spPr bwMode="auto">
              <a:xfrm>
                <a:off x="1710605" y="5674631"/>
                <a:ext cx="1129850" cy="64271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</p:grpSp>
      <p:pic>
        <p:nvPicPr>
          <p:cNvPr id="14" name="Picture 3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39" r="8334" b="4526"/>
          <a:stretch/>
        </p:blipFill>
        <p:spPr bwMode="auto">
          <a:xfrm>
            <a:off x="2760369" y="1626618"/>
            <a:ext cx="2002662" cy="16994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621250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/>
          <p:cNvGrpSpPr/>
          <p:nvPr/>
        </p:nvGrpSpPr>
        <p:grpSpPr>
          <a:xfrm>
            <a:off x="210420" y="452956"/>
            <a:ext cx="8622220" cy="6280744"/>
            <a:chOff x="210420" y="452956"/>
            <a:chExt cx="8622220" cy="6280744"/>
          </a:xfrm>
        </p:grpSpPr>
        <p:grpSp>
          <p:nvGrpSpPr>
            <p:cNvPr id="12" name="Group 11"/>
            <p:cNvGrpSpPr/>
            <p:nvPr/>
          </p:nvGrpSpPr>
          <p:grpSpPr>
            <a:xfrm>
              <a:off x="210420" y="452956"/>
              <a:ext cx="7854992" cy="5208292"/>
              <a:chOff x="543795" y="452956"/>
              <a:chExt cx="7854992" cy="5208292"/>
            </a:xfrm>
          </p:grpSpPr>
          <p:grpSp>
            <p:nvGrpSpPr>
              <p:cNvPr id="11" name="Group 10"/>
              <p:cNvGrpSpPr/>
              <p:nvPr/>
            </p:nvGrpSpPr>
            <p:grpSpPr>
              <a:xfrm>
                <a:off x="543795" y="452956"/>
                <a:ext cx="7854992" cy="5208292"/>
                <a:chOff x="543795" y="452956"/>
                <a:chExt cx="7854992" cy="5208292"/>
              </a:xfrm>
            </p:grpSpPr>
            <p:sp>
              <p:nvSpPr>
                <p:cNvPr id="13" name="Rectangle 12"/>
                <p:cNvSpPr/>
                <p:nvPr/>
              </p:nvSpPr>
              <p:spPr>
                <a:xfrm>
                  <a:off x="4646811" y="1138176"/>
                  <a:ext cx="45719" cy="364882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solidFill>
                      <a:prstClr val="white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27" name="Group 26"/>
                <p:cNvGrpSpPr/>
                <p:nvPr/>
              </p:nvGrpSpPr>
              <p:grpSpPr>
                <a:xfrm>
                  <a:off x="4644008" y="452956"/>
                  <a:ext cx="3754779" cy="5208292"/>
                  <a:chOff x="899592" y="509135"/>
                  <a:chExt cx="3754779" cy="5208292"/>
                </a:xfrm>
              </p:grpSpPr>
              <p:sp>
                <p:nvSpPr>
                  <p:cNvPr id="5" name="TextBox 4"/>
                  <p:cNvSpPr txBox="1"/>
                  <p:nvPr/>
                </p:nvSpPr>
                <p:spPr>
                  <a:xfrm>
                    <a:off x="4115441" y="509135"/>
                    <a:ext cx="5389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A05-P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8" name="Group 7"/>
                  <p:cNvGrpSpPr/>
                  <p:nvPr/>
                </p:nvGrpSpPr>
                <p:grpSpPr>
                  <a:xfrm>
                    <a:off x="899592" y="961586"/>
                    <a:ext cx="1656184" cy="3887728"/>
                    <a:chOff x="3851920" y="961586"/>
                    <a:chExt cx="1656184" cy="3887728"/>
                  </a:xfrm>
                </p:grpSpPr>
                <p:pic>
                  <p:nvPicPr>
                    <p:cNvPr id="7" name="Picture 6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27416" r="54977" b="30481"/>
                    <a:stretch/>
                  </p:blipFill>
                  <p:spPr bwMode="auto">
                    <a:xfrm>
                      <a:off x="3851920" y="1248914"/>
                      <a:ext cx="1656184" cy="36004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6" name="Rectangle 5"/>
                    <p:cNvSpPr/>
                    <p:nvPr/>
                  </p:nvSpPr>
                  <p:spPr>
                    <a:xfrm>
                      <a:off x="4009630" y="961586"/>
                      <a:ext cx="410690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GB" sz="1000" dirty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A05</a:t>
                      </a:r>
                    </a:p>
                  </p:txBody>
                </p:sp>
              </p:grpSp>
              <p:cxnSp>
                <p:nvCxnSpPr>
                  <p:cNvPr id="10" name="Straight Arrow Connector 9"/>
                  <p:cNvCxnSpPr/>
                  <p:nvPr/>
                </p:nvCxnSpPr>
                <p:spPr>
                  <a:xfrm flipV="1">
                    <a:off x="2195736" y="1080444"/>
                    <a:ext cx="1709720" cy="24185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" name="Straight Arrow Connector 14"/>
                  <p:cNvCxnSpPr/>
                  <p:nvPr/>
                </p:nvCxnSpPr>
                <p:spPr>
                  <a:xfrm flipV="1">
                    <a:off x="2195736" y="1201370"/>
                    <a:ext cx="1709720" cy="273326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" name="Straight Arrow Connector 17"/>
                  <p:cNvCxnSpPr/>
                  <p:nvPr/>
                </p:nvCxnSpPr>
                <p:spPr>
                  <a:xfrm>
                    <a:off x="2165330" y="2017567"/>
                    <a:ext cx="1751030" cy="574941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Straight Arrow Connector 19"/>
                  <p:cNvCxnSpPr/>
                  <p:nvPr/>
                </p:nvCxnSpPr>
                <p:spPr>
                  <a:xfrm>
                    <a:off x="2161959" y="2537476"/>
                    <a:ext cx="1689961" cy="247570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" name="Straight Arrow Connector 21"/>
                  <p:cNvCxnSpPr/>
                  <p:nvPr/>
                </p:nvCxnSpPr>
                <p:spPr>
                  <a:xfrm>
                    <a:off x="2161959" y="2435525"/>
                    <a:ext cx="1743497" cy="328190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" name="Straight Arrow Connector 23"/>
                  <p:cNvCxnSpPr/>
                  <p:nvPr/>
                </p:nvCxnSpPr>
                <p:spPr>
                  <a:xfrm>
                    <a:off x="2195736" y="3333529"/>
                    <a:ext cx="1656184" cy="76162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" name="Straight Arrow Connector 25"/>
                  <p:cNvCxnSpPr/>
                  <p:nvPr/>
                </p:nvCxnSpPr>
                <p:spPr>
                  <a:xfrm>
                    <a:off x="2177264" y="3859256"/>
                    <a:ext cx="1728192" cy="1858171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8" name="Group 67"/>
                <p:cNvGrpSpPr/>
                <p:nvPr/>
              </p:nvGrpSpPr>
              <p:grpSpPr>
                <a:xfrm>
                  <a:off x="2540362" y="923029"/>
                  <a:ext cx="2152980" cy="300045"/>
                  <a:chOff x="2855579" y="97168"/>
                  <a:chExt cx="2152980" cy="300045"/>
                </a:xfrm>
              </p:grpSpPr>
              <p:sp>
                <p:nvSpPr>
                  <p:cNvPr id="70" name="TextBox 69"/>
                  <p:cNvSpPr txBox="1"/>
                  <p:nvPr/>
                </p:nvSpPr>
                <p:spPr>
                  <a:xfrm>
                    <a:off x="4753361" y="103238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0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71" name="Straight Connector 70"/>
                  <p:cNvCxnSpPr/>
                  <p:nvPr/>
                </p:nvCxnSpPr>
                <p:spPr>
                  <a:xfrm>
                    <a:off x="2855579" y="323596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2" name="Straight Connector 71"/>
                  <p:cNvCxnSpPr/>
                  <p:nvPr/>
                </p:nvCxnSpPr>
                <p:spPr>
                  <a:xfrm>
                    <a:off x="3179429" y="326934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" name="Straight Connector 72"/>
                  <p:cNvCxnSpPr/>
                  <p:nvPr/>
                </p:nvCxnSpPr>
                <p:spPr>
                  <a:xfrm>
                    <a:off x="3522329" y="329251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4" name="Straight Connector 73"/>
                  <p:cNvCxnSpPr/>
                  <p:nvPr/>
                </p:nvCxnSpPr>
                <p:spPr>
                  <a:xfrm>
                    <a:off x="4236704" y="325637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" name="Straight Connector 74"/>
                  <p:cNvCxnSpPr/>
                  <p:nvPr/>
                </p:nvCxnSpPr>
                <p:spPr>
                  <a:xfrm>
                    <a:off x="4551029" y="322721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" name="Straight Connector 75"/>
                  <p:cNvCxnSpPr/>
                  <p:nvPr/>
                </p:nvCxnSpPr>
                <p:spPr>
                  <a:xfrm>
                    <a:off x="4890853" y="329074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7" name="TextBox 76"/>
                  <p:cNvSpPr txBox="1"/>
                  <p:nvPr/>
                </p:nvSpPr>
                <p:spPr>
                  <a:xfrm>
                    <a:off x="4416216" y="102872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1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8" name="TextBox 77"/>
                  <p:cNvSpPr txBox="1"/>
                  <p:nvPr/>
                </p:nvSpPr>
                <p:spPr>
                  <a:xfrm>
                    <a:off x="4101891" y="103237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2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79" name="TextBox 78"/>
                  <p:cNvSpPr txBox="1"/>
                  <p:nvPr/>
                </p:nvSpPr>
                <p:spPr>
                  <a:xfrm>
                    <a:off x="3730182" y="98753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3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0" name="TextBox 79"/>
                  <p:cNvSpPr txBox="1"/>
                  <p:nvPr/>
                </p:nvSpPr>
                <p:spPr>
                  <a:xfrm>
                    <a:off x="3376528" y="97168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4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81" name="TextBox 80"/>
                  <p:cNvSpPr txBox="1"/>
                  <p:nvPr/>
                </p:nvSpPr>
                <p:spPr>
                  <a:xfrm>
                    <a:off x="3042907" y="104119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pic>
              <p:nvPicPr>
                <p:cNvPr id="5123" name="Picture 3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43795" y="1226229"/>
                  <a:ext cx="1895475" cy="35321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82" name="TextBox 81"/>
                <p:cNvSpPr txBox="1"/>
                <p:nvPr/>
              </p:nvSpPr>
              <p:spPr>
                <a:xfrm>
                  <a:off x="1043608" y="4751822"/>
                  <a:ext cx="5036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e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3241378" y="4758428"/>
                  <a:ext cx="4683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f</a:t>
                  </a:r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3118808" y="633715"/>
                  <a:ext cx="44755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LOD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39" name="Straight Connector 38"/>
              <p:cNvCxnSpPr/>
              <p:nvPr/>
            </p:nvCxnSpPr>
            <p:spPr>
              <a:xfrm>
                <a:off x="3550012" y="1155112"/>
                <a:ext cx="0" cy="6796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TextBox 39"/>
              <p:cNvSpPr txBox="1"/>
              <p:nvPr/>
            </p:nvSpPr>
            <p:spPr>
              <a:xfrm>
                <a:off x="2409232" y="92651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6</a:t>
                </a:r>
                <a:endParaRPr lang="en-GB" sz="10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2" name="Group 41"/>
            <p:cNvGrpSpPr/>
            <p:nvPr/>
          </p:nvGrpSpPr>
          <p:grpSpPr>
            <a:xfrm>
              <a:off x="7318165" y="746112"/>
              <a:ext cx="1514475" cy="5987588"/>
              <a:chOff x="679093" y="483916"/>
              <a:chExt cx="1514475" cy="5987588"/>
            </a:xfrm>
          </p:grpSpPr>
          <p:pic>
            <p:nvPicPr>
              <p:cNvPr id="43" name="Picture 7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5081" t="20094" r="40671" b="18768"/>
              <a:stretch/>
            </p:blipFill>
            <p:spPr bwMode="auto">
              <a:xfrm>
                <a:off x="683568" y="483916"/>
                <a:ext cx="1266825" cy="453347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4" name="Picture 8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509" t="23049" r="23459" b="55929"/>
              <a:stretch/>
            </p:blipFill>
            <p:spPr bwMode="auto">
              <a:xfrm>
                <a:off x="679093" y="4912618"/>
                <a:ext cx="1514475" cy="155888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</p:grpSp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8" t="30665" r="81523" b="34308"/>
          <a:stretch/>
        </p:blipFill>
        <p:spPr bwMode="auto">
          <a:xfrm flipH="1">
            <a:off x="2152334" y="1193935"/>
            <a:ext cx="2139823" cy="35644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552837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683359" y="-41871"/>
            <a:ext cx="8146418" cy="6783239"/>
            <a:chOff x="683359" y="-41871"/>
            <a:chExt cx="8146418" cy="6783239"/>
          </a:xfrm>
        </p:grpSpPr>
        <p:grpSp>
          <p:nvGrpSpPr>
            <p:cNvPr id="47" name="Group 46"/>
            <p:cNvGrpSpPr/>
            <p:nvPr/>
          </p:nvGrpSpPr>
          <p:grpSpPr>
            <a:xfrm>
              <a:off x="7229865" y="188640"/>
              <a:ext cx="1599912" cy="6552728"/>
              <a:chOff x="5069201" y="104552"/>
              <a:chExt cx="1599912" cy="6734477"/>
            </a:xfrm>
          </p:grpSpPr>
          <p:cxnSp>
            <p:nvCxnSpPr>
              <p:cNvPr id="48" name="Straight Connector 47"/>
              <p:cNvCxnSpPr/>
              <p:nvPr/>
            </p:nvCxnSpPr>
            <p:spPr>
              <a:xfrm>
                <a:off x="5402181" y="4300811"/>
                <a:ext cx="0" cy="814981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49" name="Picture 9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490" t="22360" r="3620" b="19020"/>
              <a:stretch/>
            </p:blipFill>
            <p:spPr bwMode="auto">
              <a:xfrm>
                <a:off x="5076056" y="104552"/>
                <a:ext cx="1590676" cy="434679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0" name="Picture 10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126" r="82521" b="46990"/>
              <a:stretch/>
            </p:blipFill>
            <p:spPr bwMode="auto">
              <a:xfrm>
                <a:off x="5069201" y="4546600"/>
                <a:ext cx="1599912" cy="229242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51" name="Straight Connector 50"/>
              <p:cNvCxnSpPr/>
              <p:nvPr/>
            </p:nvCxnSpPr>
            <p:spPr>
              <a:xfrm>
                <a:off x="5512296" y="4351611"/>
                <a:ext cx="0" cy="814981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" name="Group 14"/>
            <p:cNvGrpSpPr/>
            <p:nvPr/>
          </p:nvGrpSpPr>
          <p:grpSpPr>
            <a:xfrm>
              <a:off x="683359" y="-41871"/>
              <a:ext cx="7245213" cy="5271071"/>
              <a:chOff x="683359" y="-41871"/>
              <a:chExt cx="7245213" cy="5271071"/>
            </a:xfrm>
          </p:grpSpPr>
          <p:grpSp>
            <p:nvGrpSpPr>
              <p:cNvPr id="13" name="Group 12"/>
              <p:cNvGrpSpPr/>
              <p:nvPr/>
            </p:nvGrpSpPr>
            <p:grpSpPr>
              <a:xfrm>
                <a:off x="683359" y="-41871"/>
                <a:ext cx="7245213" cy="5271071"/>
                <a:chOff x="683359" y="-41871"/>
                <a:chExt cx="7245213" cy="5271071"/>
              </a:xfrm>
            </p:grpSpPr>
            <p:grpSp>
              <p:nvGrpSpPr>
                <p:cNvPr id="25" name="Group 24"/>
                <p:cNvGrpSpPr/>
                <p:nvPr/>
              </p:nvGrpSpPr>
              <p:grpSpPr>
                <a:xfrm>
                  <a:off x="4153733" y="-41871"/>
                  <a:ext cx="3774839" cy="5271071"/>
                  <a:chOff x="1677591" y="-157128"/>
                  <a:chExt cx="3774839" cy="5271071"/>
                </a:xfrm>
              </p:grpSpPr>
              <p:sp>
                <p:nvSpPr>
                  <p:cNvPr id="7" name="TextBox 6"/>
                  <p:cNvSpPr txBox="1"/>
                  <p:nvPr/>
                </p:nvSpPr>
                <p:spPr>
                  <a:xfrm>
                    <a:off x="4913500" y="-157128"/>
                    <a:ext cx="5389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A06-P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11" name="Group 10"/>
                  <p:cNvGrpSpPr/>
                  <p:nvPr/>
                </p:nvGrpSpPr>
                <p:grpSpPr>
                  <a:xfrm>
                    <a:off x="1677591" y="581447"/>
                    <a:ext cx="1923454" cy="3972724"/>
                    <a:chOff x="3477791" y="576600"/>
                    <a:chExt cx="1923454" cy="3972724"/>
                  </a:xfrm>
                </p:grpSpPr>
                <p:pic>
                  <p:nvPicPr>
                    <p:cNvPr id="8" name="Picture 2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15135" r="46787" b="36033"/>
                    <a:stretch/>
                  </p:blipFill>
                  <p:spPr bwMode="auto">
                    <a:xfrm>
                      <a:off x="3477791" y="908720"/>
                      <a:ext cx="1923454" cy="364060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9" name="TextBox 8"/>
                    <p:cNvSpPr txBox="1"/>
                    <p:nvPr/>
                  </p:nvSpPr>
                  <p:spPr>
                    <a:xfrm>
                      <a:off x="3590357" y="576600"/>
                      <a:ext cx="4106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A06</a:t>
                      </a:r>
                      <a:endParaRPr lang="en-GB" sz="10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cxnSp>
                <p:nvCxnSpPr>
                  <p:cNvPr id="12" name="Straight Arrow Connector 11"/>
                  <p:cNvCxnSpPr/>
                  <p:nvPr/>
                </p:nvCxnSpPr>
                <p:spPr>
                  <a:xfrm flipV="1">
                    <a:off x="2887946" y="476671"/>
                    <a:ext cx="1872632" cy="611129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" name="Straight Arrow Connector 13"/>
                  <p:cNvCxnSpPr/>
                  <p:nvPr/>
                </p:nvCxnSpPr>
                <p:spPr>
                  <a:xfrm>
                    <a:off x="2887946" y="1596246"/>
                    <a:ext cx="1846473" cy="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" name="Straight Arrow Connector 15"/>
                  <p:cNvCxnSpPr/>
                  <p:nvPr/>
                </p:nvCxnSpPr>
                <p:spPr>
                  <a:xfrm>
                    <a:off x="3496908" y="3313743"/>
                    <a:ext cx="1148911" cy="1728192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" name="Straight Arrow Connector 18"/>
                  <p:cNvCxnSpPr/>
                  <p:nvPr/>
                </p:nvCxnSpPr>
                <p:spPr>
                  <a:xfrm>
                    <a:off x="3496908" y="3313743"/>
                    <a:ext cx="1148911" cy="180020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" name="Straight Arrow Connector 21"/>
                  <p:cNvCxnSpPr/>
                  <p:nvPr/>
                </p:nvCxnSpPr>
                <p:spPr>
                  <a:xfrm flipV="1">
                    <a:off x="2887946" y="4127455"/>
                    <a:ext cx="1757873" cy="28536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2" name="Group 41"/>
                <p:cNvGrpSpPr/>
                <p:nvPr/>
              </p:nvGrpSpPr>
              <p:grpSpPr>
                <a:xfrm>
                  <a:off x="2042665" y="750486"/>
                  <a:ext cx="2114880" cy="4121825"/>
                  <a:chOff x="2042665" y="750486"/>
                  <a:chExt cx="2114880" cy="4121825"/>
                </a:xfrm>
              </p:grpSpPr>
              <p:grpSp>
                <p:nvGrpSpPr>
                  <p:cNvPr id="24" name="Group 23"/>
                  <p:cNvGrpSpPr/>
                  <p:nvPr/>
                </p:nvGrpSpPr>
                <p:grpSpPr>
                  <a:xfrm>
                    <a:off x="2042665" y="750486"/>
                    <a:ext cx="2114880" cy="306726"/>
                    <a:chOff x="1346438" y="1065079"/>
                    <a:chExt cx="2114880" cy="306726"/>
                  </a:xfrm>
                </p:grpSpPr>
                <p:sp>
                  <p:nvSpPr>
                    <p:cNvPr id="28" name="TextBox 27"/>
                    <p:cNvSpPr txBox="1"/>
                    <p:nvPr/>
                  </p:nvSpPr>
                  <p:spPr>
                    <a:xfrm>
                      <a:off x="3206120" y="1078007"/>
                      <a:ext cx="255198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0</a:t>
                      </a:r>
                      <a:endParaRPr lang="en-GB" sz="10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cxnSp>
                  <p:nvCxnSpPr>
                    <p:cNvPr id="29" name="Straight Connector 28"/>
                    <p:cNvCxnSpPr/>
                    <p:nvPr/>
                  </p:nvCxnSpPr>
                  <p:spPr>
                    <a:xfrm>
                      <a:off x="1346438" y="1298365"/>
                      <a:ext cx="0" cy="67962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" name="Straight Connector 29"/>
                    <p:cNvCxnSpPr/>
                    <p:nvPr/>
                  </p:nvCxnSpPr>
                  <p:spPr>
                    <a:xfrm>
                      <a:off x="1670288" y="1292178"/>
                      <a:ext cx="0" cy="67962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" name="Straight Connector 30"/>
                    <p:cNvCxnSpPr/>
                    <p:nvPr/>
                  </p:nvCxnSpPr>
                  <p:spPr>
                    <a:xfrm>
                      <a:off x="1984613" y="1294495"/>
                      <a:ext cx="0" cy="67962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" name="Straight Connector 31"/>
                    <p:cNvCxnSpPr/>
                    <p:nvPr/>
                  </p:nvCxnSpPr>
                  <p:spPr>
                    <a:xfrm>
                      <a:off x="2317988" y="1300406"/>
                      <a:ext cx="0" cy="67962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" name="Straight Connector 32"/>
                    <p:cNvCxnSpPr/>
                    <p:nvPr/>
                  </p:nvCxnSpPr>
                  <p:spPr>
                    <a:xfrm>
                      <a:off x="3013313" y="1297490"/>
                      <a:ext cx="0" cy="67962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" name="Straight Connector 33"/>
                    <p:cNvCxnSpPr/>
                    <p:nvPr/>
                  </p:nvCxnSpPr>
                  <p:spPr>
                    <a:xfrm>
                      <a:off x="3343612" y="1303843"/>
                      <a:ext cx="0" cy="67962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5" name="TextBox 34"/>
                    <p:cNvSpPr txBox="1"/>
                    <p:nvPr/>
                  </p:nvSpPr>
                  <p:spPr>
                    <a:xfrm>
                      <a:off x="2868975" y="1068076"/>
                      <a:ext cx="255198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GB" sz="10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6" name="TextBox 35"/>
                    <p:cNvSpPr txBox="1"/>
                    <p:nvPr/>
                  </p:nvSpPr>
                  <p:spPr>
                    <a:xfrm>
                      <a:off x="2516550" y="1067906"/>
                      <a:ext cx="255198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GB" sz="10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7" name="TextBox 36"/>
                    <p:cNvSpPr txBox="1"/>
                    <p:nvPr/>
                  </p:nvSpPr>
                  <p:spPr>
                    <a:xfrm>
                      <a:off x="2174476" y="1065079"/>
                      <a:ext cx="255198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GB" sz="10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8" name="TextBox 37"/>
                    <p:cNvSpPr txBox="1"/>
                    <p:nvPr/>
                  </p:nvSpPr>
                  <p:spPr>
                    <a:xfrm>
                      <a:off x="1829297" y="1065079"/>
                      <a:ext cx="255198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GB" sz="10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9" name="TextBox 38"/>
                    <p:cNvSpPr txBox="1"/>
                    <p:nvPr/>
                  </p:nvSpPr>
                  <p:spPr>
                    <a:xfrm>
                      <a:off x="1531096" y="1067490"/>
                      <a:ext cx="255198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GB" sz="10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sp>
                <p:nvSpPr>
                  <p:cNvPr id="40" name="Rectangle 39"/>
                  <p:cNvSpPr/>
                  <p:nvPr/>
                </p:nvSpPr>
                <p:spPr>
                  <a:xfrm>
                    <a:off x="4064272" y="1028824"/>
                    <a:ext cx="45719" cy="3843487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sz="1000">
                      <a:solidFill>
                        <a:prstClr val="white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grpSp>
              <p:nvGrpSpPr>
                <p:cNvPr id="56" name="Group 55"/>
                <p:cNvGrpSpPr/>
                <p:nvPr/>
              </p:nvGrpSpPr>
              <p:grpSpPr>
                <a:xfrm>
                  <a:off x="683359" y="1058206"/>
                  <a:ext cx="1282451" cy="3717986"/>
                  <a:chOff x="654784" y="1058206"/>
                  <a:chExt cx="1282451" cy="3717986"/>
                </a:xfrm>
              </p:grpSpPr>
              <p:grpSp>
                <p:nvGrpSpPr>
                  <p:cNvPr id="54" name="Group 53"/>
                  <p:cNvGrpSpPr/>
                  <p:nvPr/>
                </p:nvGrpSpPr>
                <p:grpSpPr>
                  <a:xfrm>
                    <a:off x="654784" y="1058206"/>
                    <a:ext cx="1209675" cy="3601986"/>
                    <a:chOff x="654784" y="1058206"/>
                    <a:chExt cx="1209675" cy="3601986"/>
                  </a:xfrm>
                </p:grpSpPr>
                <p:pic>
                  <p:nvPicPr>
                    <p:cNvPr id="6147" name="Picture 3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654784" y="1058206"/>
                      <a:ext cx="1209675" cy="3601986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cxnSp>
                  <p:nvCxnSpPr>
                    <p:cNvPr id="44" name="Straight Connector 43"/>
                    <p:cNvCxnSpPr/>
                    <p:nvPr/>
                  </p:nvCxnSpPr>
                  <p:spPr>
                    <a:xfrm>
                      <a:off x="654784" y="4650378"/>
                      <a:ext cx="1209675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55" name="Rectangle 54"/>
                  <p:cNvSpPr/>
                  <p:nvPr/>
                </p:nvSpPr>
                <p:spPr>
                  <a:xfrm>
                    <a:off x="1865373" y="4603417"/>
                    <a:ext cx="71862" cy="17277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sz="1000">
                      <a:solidFill>
                        <a:prstClr val="white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59" name="TextBox 58"/>
                <p:cNvSpPr txBox="1"/>
                <p:nvPr/>
              </p:nvSpPr>
              <p:spPr>
                <a:xfrm>
                  <a:off x="1003502" y="4688651"/>
                  <a:ext cx="5036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e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0" name="TextBox 59"/>
                <p:cNvSpPr txBox="1"/>
                <p:nvPr/>
              </p:nvSpPr>
              <p:spPr>
                <a:xfrm>
                  <a:off x="2765128" y="4710803"/>
                  <a:ext cx="4683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f</a:t>
                  </a:r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1" name="TextBox 60"/>
                <p:cNvSpPr txBox="1"/>
                <p:nvPr/>
              </p:nvSpPr>
              <p:spPr>
                <a:xfrm>
                  <a:off x="2631462" y="472479"/>
                  <a:ext cx="44755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LOD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45" name="Straight Connector 44"/>
              <p:cNvCxnSpPr/>
              <p:nvPr/>
            </p:nvCxnSpPr>
            <p:spPr>
              <a:xfrm>
                <a:off x="3357115" y="985813"/>
                <a:ext cx="0" cy="6796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45"/>
              <p:cNvSpPr txBox="1"/>
              <p:nvPr/>
            </p:nvSpPr>
            <p:spPr>
              <a:xfrm>
                <a:off x="1900483" y="74399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6</a:t>
                </a:r>
                <a:endParaRPr lang="en-GB" sz="10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pic>
        <p:nvPicPr>
          <p:cNvPr id="6" name="Picture 3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20" t="5450" r="15005" b="4968"/>
          <a:stretch/>
        </p:blipFill>
        <p:spPr bwMode="auto">
          <a:xfrm>
            <a:off x="1994723" y="1044539"/>
            <a:ext cx="2115267" cy="36360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1083418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80" r="2536" b="4481"/>
          <a:stretch/>
        </p:blipFill>
        <p:spPr bwMode="auto">
          <a:xfrm>
            <a:off x="2550875" y="914855"/>
            <a:ext cx="2171934" cy="28519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4" name="Group 23"/>
          <p:cNvGrpSpPr/>
          <p:nvPr/>
        </p:nvGrpSpPr>
        <p:grpSpPr>
          <a:xfrm>
            <a:off x="899592" y="127664"/>
            <a:ext cx="7826379" cy="6412812"/>
            <a:chOff x="899592" y="127664"/>
            <a:chExt cx="7826379" cy="6412812"/>
          </a:xfrm>
        </p:grpSpPr>
        <p:grpSp>
          <p:nvGrpSpPr>
            <p:cNvPr id="16" name="Group 15"/>
            <p:cNvGrpSpPr/>
            <p:nvPr/>
          </p:nvGrpSpPr>
          <p:grpSpPr>
            <a:xfrm>
              <a:off x="899592" y="127664"/>
              <a:ext cx="7202578" cy="3885403"/>
              <a:chOff x="899592" y="127664"/>
              <a:chExt cx="7202578" cy="3885403"/>
            </a:xfrm>
          </p:grpSpPr>
          <p:grpSp>
            <p:nvGrpSpPr>
              <p:cNvPr id="14" name="Group 13"/>
              <p:cNvGrpSpPr/>
              <p:nvPr/>
            </p:nvGrpSpPr>
            <p:grpSpPr>
              <a:xfrm>
                <a:off x="899592" y="127664"/>
                <a:ext cx="7202578" cy="3885403"/>
                <a:chOff x="899592" y="127664"/>
                <a:chExt cx="7202578" cy="3885403"/>
              </a:xfrm>
            </p:grpSpPr>
            <p:grpSp>
              <p:nvGrpSpPr>
                <p:cNvPr id="19" name="Group 18"/>
                <p:cNvGrpSpPr/>
                <p:nvPr/>
              </p:nvGrpSpPr>
              <p:grpSpPr>
                <a:xfrm>
                  <a:off x="4709496" y="127664"/>
                  <a:ext cx="3392674" cy="3613386"/>
                  <a:chOff x="1619672" y="421552"/>
                  <a:chExt cx="3392674" cy="3613386"/>
                </a:xfrm>
              </p:grpSpPr>
              <p:sp>
                <p:nvSpPr>
                  <p:cNvPr id="8" name="TextBox 7"/>
                  <p:cNvSpPr txBox="1"/>
                  <p:nvPr/>
                </p:nvSpPr>
                <p:spPr>
                  <a:xfrm>
                    <a:off x="4473416" y="421552"/>
                    <a:ext cx="53893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A07-P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grpSp>
                <p:nvGrpSpPr>
                  <p:cNvPr id="7" name="Group 6"/>
                  <p:cNvGrpSpPr/>
                  <p:nvPr/>
                </p:nvGrpSpPr>
                <p:grpSpPr>
                  <a:xfrm>
                    <a:off x="1619672" y="899718"/>
                    <a:ext cx="1172890" cy="3135220"/>
                    <a:chOff x="3355365" y="1119486"/>
                    <a:chExt cx="1172890" cy="3135220"/>
                  </a:xfrm>
                </p:grpSpPr>
                <p:pic>
                  <p:nvPicPr>
                    <p:cNvPr id="9" name="Picture 3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21704" r="67322" b="42013"/>
                    <a:stretch/>
                  </p:blipFill>
                  <p:spPr bwMode="auto">
                    <a:xfrm>
                      <a:off x="3355365" y="1440962"/>
                      <a:ext cx="1172890" cy="28137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10" name="TextBox 9"/>
                    <p:cNvSpPr txBox="1"/>
                    <p:nvPr/>
                  </p:nvSpPr>
                  <p:spPr>
                    <a:xfrm>
                      <a:off x="3446278" y="1119486"/>
                      <a:ext cx="4106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1000" dirty="0" smtClean="0">
                          <a:solidFill>
                            <a:prstClr val="black"/>
                          </a:solidFill>
                          <a:latin typeface="Arial" pitchFamily="34" charset="0"/>
                          <a:cs typeface="Arial" pitchFamily="34" charset="0"/>
                        </a:rPr>
                        <a:t>A07</a:t>
                      </a:r>
                      <a:endParaRPr lang="en-GB" sz="1000" dirty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cxnSp>
                <p:nvCxnSpPr>
                  <p:cNvPr id="13" name="Straight Arrow Connector 12"/>
                  <p:cNvCxnSpPr/>
                  <p:nvPr/>
                </p:nvCxnSpPr>
                <p:spPr>
                  <a:xfrm flipV="1">
                    <a:off x="2792562" y="1157668"/>
                    <a:ext cx="1475650" cy="2341238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" name="Straight Arrow Connector 14"/>
                  <p:cNvCxnSpPr/>
                  <p:nvPr/>
                </p:nvCxnSpPr>
                <p:spPr>
                  <a:xfrm flipV="1">
                    <a:off x="2792562" y="1157668"/>
                    <a:ext cx="1475650" cy="2619745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" name="Straight Arrow Connector 17"/>
                  <p:cNvCxnSpPr/>
                  <p:nvPr/>
                </p:nvCxnSpPr>
                <p:spPr>
                  <a:xfrm flipV="1">
                    <a:off x="2792562" y="2210720"/>
                    <a:ext cx="1475650" cy="1720234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Straight Arrow Connector 19"/>
                  <p:cNvCxnSpPr/>
                  <p:nvPr/>
                </p:nvCxnSpPr>
                <p:spPr>
                  <a:xfrm flipV="1">
                    <a:off x="2792562" y="2210720"/>
                    <a:ext cx="1475650" cy="286368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headEnd type="oval" w="med" len="med"/>
                    <a:tailEnd type="oval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pic>
              <p:nvPicPr>
                <p:cNvPr id="7170" name="Picture 2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899592" y="975161"/>
                  <a:ext cx="1543819" cy="276588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grpSp>
              <p:nvGrpSpPr>
                <p:cNvPr id="38" name="Group 37"/>
                <p:cNvGrpSpPr/>
                <p:nvPr/>
              </p:nvGrpSpPr>
              <p:grpSpPr>
                <a:xfrm>
                  <a:off x="2607929" y="646030"/>
                  <a:ext cx="2114880" cy="316153"/>
                  <a:chOff x="2855579" y="84055"/>
                  <a:chExt cx="2114880" cy="316153"/>
                </a:xfrm>
              </p:grpSpPr>
              <p:sp>
                <p:nvSpPr>
                  <p:cNvPr id="40" name="TextBox 39"/>
                  <p:cNvSpPr txBox="1"/>
                  <p:nvPr/>
                </p:nvSpPr>
                <p:spPr>
                  <a:xfrm>
                    <a:off x="4715261" y="103238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0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41" name="Straight Connector 40"/>
                  <p:cNvCxnSpPr/>
                  <p:nvPr/>
                </p:nvCxnSpPr>
                <p:spPr>
                  <a:xfrm>
                    <a:off x="2855579" y="323596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" name="Straight Connector 41"/>
                  <p:cNvCxnSpPr/>
                  <p:nvPr/>
                </p:nvCxnSpPr>
                <p:spPr>
                  <a:xfrm>
                    <a:off x="3179429" y="326934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3" name="Straight Connector 42"/>
                  <p:cNvCxnSpPr/>
                  <p:nvPr/>
                </p:nvCxnSpPr>
                <p:spPr>
                  <a:xfrm>
                    <a:off x="3522329" y="319726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Straight Connector 43"/>
                  <p:cNvCxnSpPr/>
                  <p:nvPr/>
                </p:nvCxnSpPr>
                <p:spPr>
                  <a:xfrm>
                    <a:off x="4169571" y="325637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Straight Connector 44"/>
                  <p:cNvCxnSpPr/>
                  <p:nvPr/>
                </p:nvCxnSpPr>
                <p:spPr>
                  <a:xfrm>
                    <a:off x="4522454" y="332246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" name="Straight Connector 45"/>
                  <p:cNvCxnSpPr/>
                  <p:nvPr/>
                </p:nvCxnSpPr>
                <p:spPr>
                  <a:xfrm>
                    <a:off x="4852753" y="329074"/>
                    <a:ext cx="0" cy="679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7" name="TextBox 46"/>
                  <p:cNvSpPr txBox="1"/>
                  <p:nvPr/>
                </p:nvSpPr>
                <p:spPr>
                  <a:xfrm>
                    <a:off x="4387641" y="104642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1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8" name="TextBox 47"/>
                  <p:cNvSpPr txBox="1"/>
                  <p:nvPr/>
                </p:nvSpPr>
                <p:spPr>
                  <a:xfrm>
                    <a:off x="4041357" y="95758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2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49" name="TextBox 48"/>
                  <p:cNvSpPr txBox="1"/>
                  <p:nvPr/>
                </p:nvSpPr>
                <p:spPr>
                  <a:xfrm>
                    <a:off x="3710678" y="98620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3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0" name="TextBox 49"/>
                  <p:cNvSpPr txBox="1"/>
                  <p:nvPr/>
                </p:nvSpPr>
                <p:spPr>
                  <a:xfrm>
                    <a:off x="3377761" y="99877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4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1" name="TextBox 50"/>
                  <p:cNvSpPr txBox="1"/>
                  <p:nvPr/>
                </p:nvSpPr>
                <p:spPr>
                  <a:xfrm>
                    <a:off x="3051524" y="84055"/>
                    <a:ext cx="255198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1000" dirty="0" smtClean="0">
                        <a:solidFill>
                          <a:prstClr val="black"/>
                        </a:solidFill>
                        <a:latin typeface="Arial" pitchFamily="34" charset="0"/>
                        <a:cs typeface="Arial" pitchFamily="34" charset="0"/>
                      </a:rPr>
                      <a:t>5</a:t>
                    </a:r>
                    <a:endParaRPr lang="en-GB" sz="1000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11" name="Rectangle 10"/>
                <p:cNvSpPr/>
                <p:nvPr/>
              </p:nvSpPr>
              <p:spPr>
                <a:xfrm>
                  <a:off x="4647742" y="863780"/>
                  <a:ext cx="45719" cy="299763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000">
                    <a:solidFill>
                      <a:prstClr val="white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2" name="TextBox 51"/>
                <p:cNvSpPr txBox="1"/>
                <p:nvPr/>
              </p:nvSpPr>
              <p:spPr>
                <a:xfrm>
                  <a:off x="1288195" y="3766846"/>
                  <a:ext cx="50366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e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3" name="TextBox 52"/>
                <p:cNvSpPr txBox="1"/>
                <p:nvPr/>
              </p:nvSpPr>
              <p:spPr>
                <a:xfrm>
                  <a:off x="3199333" y="3766846"/>
                  <a:ext cx="4683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err="1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f</a:t>
                  </a:r>
                  <a:r>
                    <a:rPr lang="en-GB" sz="1000" dirty="0" err="1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QTL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54" name="TextBox 53"/>
                <p:cNvSpPr txBox="1"/>
                <p:nvPr/>
              </p:nvSpPr>
              <p:spPr>
                <a:xfrm>
                  <a:off x="3232196" y="382904"/>
                  <a:ext cx="44755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dirty="0" smtClean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LOD</a:t>
                  </a:r>
                  <a:endParaRPr lang="en-GB" sz="10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39" name="Straight Connector 38"/>
              <p:cNvCxnSpPr/>
              <p:nvPr/>
            </p:nvCxnSpPr>
            <p:spPr>
              <a:xfrm>
                <a:off x="3598071" y="887612"/>
                <a:ext cx="0" cy="6796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TextBox 54"/>
              <p:cNvSpPr txBox="1"/>
              <p:nvPr/>
            </p:nvSpPr>
            <p:spPr>
              <a:xfrm>
                <a:off x="2467274" y="652327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6</a:t>
                </a:r>
                <a:endParaRPr lang="en-GB" sz="10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6" name="Group 55"/>
            <p:cNvGrpSpPr/>
            <p:nvPr/>
          </p:nvGrpSpPr>
          <p:grpSpPr>
            <a:xfrm>
              <a:off x="7386608" y="483514"/>
              <a:ext cx="1339363" cy="6056962"/>
              <a:chOff x="1884129" y="720436"/>
              <a:chExt cx="1339363" cy="6056962"/>
            </a:xfrm>
          </p:grpSpPr>
          <p:pic>
            <p:nvPicPr>
              <p:cNvPr id="57" name="Picture 11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741" t="22791" r="66352" b="15676"/>
              <a:stretch/>
            </p:blipFill>
            <p:spPr bwMode="auto">
              <a:xfrm>
                <a:off x="1898074" y="720436"/>
                <a:ext cx="1325418" cy="456276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58" name="Picture 11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054" t="19503" r="52900" b="58744"/>
              <a:stretch/>
            </p:blipFill>
            <p:spPr bwMode="auto">
              <a:xfrm>
                <a:off x="1884129" y="5164335"/>
                <a:ext cx="1186309" cy="161306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59" name="Straight Connector 58"/>
              <p:cNvCxnSpPr/>
              <p:nvPr/>
            </p:nvCxnSpPr>
            <p:spPr>
              <a:xfrm>
                <a:off x="2251653" y="4886707"/>
                <a:ext cx="0" cy="792986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Connector 59"/>
              <p:cNvCxnSpPr/>
              <p:nvPr/>
            </p:nvCxnSpPr>
            <p:spPr>
              <a:xfrm>
                <a:off x="2360942" y="4856768"/>
                <a:ext cx="0" cy="792986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41363966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160</Words>
  <Application>Microsoft Office PowerPoint</Application>
  <PresentationFormat>On-screen Show (4:3)</PresentationFormat>
  <Paragraphs>202</Paragraphs>
  <Slides>30</Slides>
  <Notes>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0</vt:i4>
      </vt:variant>
    </vt:vector>
  </HeadingPairs>
  <TitlesOfParts>
    <vt:vector size="31" baseType="lpstr">
      <vt:lpstr>Office-them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ao, Dong</dc:creator>
  <cp:lastModifiedBy>Xiao, Dong</cp:lastModifiedBy>
  <cp:revision>8</cp:revision>
  <dcterms:created xsi:type="dcterms:W3CDTF">2013-05-23T13:37:18Z</dcterms:created>
  <dcterms:modified xsi:type="dcterms:W3CDTF">2013-08-14T15:16:20Z</dcterms:modified>
</cp:coreProperties>
</file>